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ags/tag2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07" d="100"/>
          <a:sy n="107" d="100"/>
        </p:scale>
        <p:origin x="714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wimr-my.sharepoint.com/personal/fatema_safri_wimr_org_au/Documents/Desktop/PhD_%20Project/MAFLD%20non%20cirrhotic%20Lipidomics/Plasma%20Lipidomics_MAFLD%20non%20cirrhotic/Classes%20found_Pie%20char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wimr-my.sharepoint.com/personal/fatema_safri_wimr_org_au/Documents/Desktop/PhD_%20Project/MAFLD%20non%20cirrhotic%20Lipidomics/Plasma%20Lipidomics_MAFLD%20non%20cirrhotic/Classes%20found_Pie%20char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AU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</a:p>
        </c:rich>
      </c:tx>
      <c:layout>
        <c:manualLayout>
          <c:xMode val="edge"/>
          <c:yMode val="edge"/>
          <c:x val="0.17967087002374499"/>
          <c:y val="0.4729586733254434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5.3709714857071426E-2"/>
          <c:y val="6.6732990039654744E-2"/>
          <c:w val="0.36650347278018819"/>
          <c:h val="0.89346602186512369"/>
        </c:manualLayout>
      </c:layout>
      <c:doughnut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5F3-4984-BFE1-891179ADC94A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5F3-4984-BFE1-891179ADC94A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5F3-4984-BFE1-891179ADC94A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75F3-4984-BFE1-891179ADC94A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75F3-4984-BFE1-891179ADC94A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75F3-4984-BFE1-891179ADC94A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75F3-4984-BFE1-891179ADC94A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75F3-4984-BFE1-891179ADC94A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75F3-4984-BFE1-891179ADC94A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75F3-4984-BFE1-891179ADC94A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75F3-4984-BFE1-891179ADC94A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75F3-4984-BFE1-891179ADC94A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75F3-4984-BFE1-891179ADC94A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75F3-4984-BFE1-891179ADC94A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75F3-4984-BFE1-891179ADC94A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75F3-4984-BFE1-891179ADC94A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75F3-4984-BFE1-891179ADC94A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75F3-4984-BFE1-891179ADC94A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75F3-4984-BFE1-891179ADC94A}"/>
              </c:ext>
            </c:extLst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75F3-4984-BFE1-891179ADC94A}"/>
              </c:ext>
            </c:extLst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75F3-4984-BFE1-891179ADC94A}"/>
              </c:ext>
            </c:extLst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75F3-4984-BFE1-891179ADC94A}"/>
              </c:ext>
            </c:extLst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75F3-4984-BFE1-891179ADC94A}"/>
              </c:ext>
            </c:extLst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75F3-4984-BFE1-891179ADC94A}"/>
              </c:ext>
            </c:extLst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75F3-4984-BFE1-891179ADC94A}"/>
              </c:ext>
            </c:extLst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75F3-4984-BFE1-891179ADC94A}"/>
              </c:ext>
            </c:extLst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75F3-4984-BFE1-891179ADC94A}"/>
              </c:ext>
            </c:extLst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75F3-4984-BFE1-891179ADC94A}"/>
              </c:ext>
            </c:extLst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75F3-4984-BFE1-891179ADC94A}"/>
              </c:ext>
            </c:extLst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75F3-4984-BFE1-891179ADC94A}"/>
              </c:ext>
            </c:extLst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75F3-4984-BFE1-891179ADC94A}"/>
              </c:ext>
            </c:extLst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F-75F3-4984-BFE1-891179ADC94A}"/>
              </c:ext>
            </c:extLst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1-75F3-4984-BFE1-891179ADC94A}"/>
              </c:ext>
            </c:extLst>
          </c:dPt>
          <c:dPt>
            <c:idx val="33"/>
            <c:bubble3D val="0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3-75F3-4984-BFE1-891179ADC94A}"/>
              </c:ext>
            </c:extLst>
          </c:dPt>
          <c:dPt>
            <c:idx val="34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5-75F3-4984-BFE1-891179ADC94A}"/>
              </c:ext>
            </c:extLst>
          </c:dPt>
          <c:dPt>
            <c:idx val="35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7-75F3-4984-BFE1-891179ADC94A}"/>
              </c:ext>
            </c:extLst>
          </c:dPt>
          <c:cat>
            <c:strRef>
              <c:f>'[Classes found_Pie chart.xlsx]Plasma'!$G$3:$G$38</c:f>
              <c:strCache>
                <c:ptCount val="36"/>
                <c:pt idx="0">
                  <c:v>AcCa</c:v>
                </c:pt>
                <c:pt idx="1">
                  <c:v>AcHexChE</c:v>
                </c:pt>
                <c:pt idx="2">
                  <c:v>CL</c:v>
                </c:pt>
                <c:pt idx="3">
                  <c:v>CarE</c:v>
                </c:pt>
                <c:pt idx="4">
                  <c:v>Cer</c:v>
                </c:pt>
                <c:pt idx="5">
                  <c:v>CerG2GNAc1</c:v>
                </c:pt>
                <c:pt idx="6">
                  <c:v>CerG3GNAc1</c:v>
                </c:pt>
                <c:pt idx="7">
                  <c:v>CerP</c:v>
                </c:pt>
                <c:pt idx="8">
                  <c:v>ChE</c:v>
                </c:pt>
                <c:pt idx="9">
                  <c:v>Co</c:v>
                </c:pt>
                <c:pt idx="10">
                  <c:v>D5TG</c:v>
                </c:pt>
                <c:pt idx="11">
                  <c:v>DG</c:v>
                </c:pt>
                <c:pt idx="12">
                  <c:v>Hex1Cer</c:v>
                </c:pt>
                <c:pt idx="13">
                  <c:v>Hex2Cer</c:v>
                </c:pt>
                <c:pt idx="14">
                  <c:v>Hex3Cer</c:v>
                </c:pt>
                <c:pt idx="15">
                  <c:v>LBPA</c:v>
                </c:pt>
                <c:pt idx="16">
                  <c:v>LPA</c:v>
                </c:pt>
                <c:pt idx="17">
                  <c:v>LPC</c:v>
                </c:pt>
                <c:pt idx="18">
                  <c:v>LPE</c:v>
                </c:pt>
                <c:pt idx="19">
                  <c:v>LPG</c:v>
                </c:pt>
                <c:pt idx="20">
                  <c:v>LPI</c:v>
                </c:pt>
                <c:pt idx="21">
                  <c:v>LPS</c:v>
                </c:pt>
                <c:pt idx="22">
                  <c:v>LSM</c:v>
                </c:pt>
                <c:pt idx="23">
                  <c:v>PA</c:v>
                </c:pt>
                <c:pt idx="24">
                  <c:v>PC</c:v>
                </c:pt>
                <c:pt idx="25">
                  <c:v>PE</c:v>
                </c:pt>
                <c:pt idx="26">
                  <c:v>PEt</c:v>
                </c:pt>
                <c:pt idx="27">
                  <c:v>PG</c:v>
                </c:pt>
                <c:pt idx="28">
                  <c:v>PI</c:v>
                </c:pt>
                <c:pt idx="29">
                  <c:v>PIP</c:v>
                </c:pt>
                <c:pt idx="30">
                  <c:v>PS</c:v>
                </c:pt>
                <c:pt idx="31">
                  <c:v>SM</c:v>
                </c:pt>
                <c:pt idx="32">
                  <c:v>SPH</c:v>
                </c:pt>
                <c:pt idx="33">
                  <c:v>ST</c:v>
                </c:pt>
                <c:pt idx="34">
                  <c:v>TG</c:v>
                </c:pt>
                <c:pt idx="35">
                  <c:v>WE</c:v>
                </c:pt>
              </c:strCache>
            </c:strRef>
          </c:cat>
          <c:val>
            <c:numRef>
              <c:f>'[Classes found_Pie chart.xlsx]Plasma'!$I$3:$I$38</c:f>
              <c:numCache>
                <c:formatCode>General</c:formatCode>
                <c:ptCount val="36"/>
                <c:pt idx="0">
                  <c:v>0.49417578538651608</c:v>
                </c:pt>
                <c:pt idx="1">
                  <c:v>3.5298270384751147E-2</c:v>
                </c:pt>
                <c:pt idx="2">
                  <c:v>7.0596540769502295E-2</c:v>
                </c:pt>
                <c:pt idx="3">
                  <c:v>0.10589481115425343</c:v>
                </c:pt>
                <c:pt idx="4">
                  <c:v>6.5301800211789622</c:v>
                </c:pt>
                <c:pt idx="5">
                  <c:v>0</c:v>
                </c:pt>
                <c:pt idx="6">
                  <c:v>0.14119308153900459</c:v>
                </c:pt>
                <c:pt idx="7">
                  <c:v>1.0589481115425343</c:v>
                </c:pt>
                <c:pt idx="8">
                  <c:v>1.2001411930815391</c:v>
                </c:pt>
                <c:pt idx="9">
                  <c:v>0.14119308153900459</c:v>
                </c:pt>
                <c:pt idx="10">
                  <c:v>2.6120720084715847</c:v>
                </c:pt>
                <c:pt idx="11">
                  <c:v>4.8005647723261564</c:v>
                </c:pt>
                <c:pt idx="12">
                  <c:v>2.8591599011648428</c:v>
                </c:pt>
                <c:pt idx="13">
                  <c:v>1.4119308153900458</c:v>
                </c:pt>
                <c:pt idx="14">
                  <c:v>0.49417578538651608</c:v>
                </c:pt>
                <c:pt idx="15">
                  <c:v>0</c:v>
                </c:pt>
                <c:pt idx="16">
                  <c:v>0.3882809742322626</c:v>
                </c:pt>
                <c:pt idx="17">
                  <c:v>4.6946699611719023</c:v>
                </c:pt>
                <c:pt idx="18">
                  <c:v>0.60007059654076955</c:v>
                </c:pt>
                <c:pt idx="19">
                  <c:v>0.10589481115425343</c:v>
                </c:pt>
                <c:pt idx="20">
                  <c:v>0.14119308153900459</c:v>
                </c:pt>
                <c:pt idx="21">
                  <c:v>0</c:v>
                </c:pt>
                <c:pt idx="22">
                  <c:v>0</c:v>
                </c:pt>
                <c:pt idx="23">
                  <c:v>0.14119308153900459</c:v>
                </c:pt>
                <c:pt idx="24">
                  <c:v>18.072714436992587</c:v>
                </c:pt>
                <c:pt idx="25">
                  <c:v>5.047652665019414</c:v>
                </c:pt>
                <c:pt idx="26">
                  <c:v>0</c:v>
                </c:pt>
                <c:pt idx="27">
                  <c:v>0.21178962230850687</c:v>
                </c:pt>
                <c:pt idx="28">
                  <c:v>1.0942463819272856</c:v>
                </c:pt>
                <c:pt idx="29">
                  <c:v>0</c:v>
                </c:pt>
                <c:pt idx="30">
                  <c:v>0.21178962230850687</c:v>
                </c:pt>
                <c:pt idx="31">
                  <c:v>12.989763501588422</c:v>
                </c:pt>
                <c:pt idx="32">
                  <c:v>0.10589481115425343</c:v>
                </c:pt>
                <c:pt idx="33">
                  <c:v>0.21178962230850687</c:v>
                </c:pt>
                <c:pt idx="34">
                  <c:v>33.921637839745856</c:v>
                </c:pt>
                <c:pt idx="35">
                  <c:v>0.105894811154253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8-75F3-4984-BFE1-891179ADC9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75"/>
      </c:doughnut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9271484526411163"/>
          <c:y val="0.25800394821426131"/>
          <c:w val="0.40447288737634174"/>
          <c:h val="0.5432063255936656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rtl="0"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6350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AU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</a:p>
        </c:rich>
      </c:tx>
      <c:layout>
        <c:manualLayout>
          <c:xMode val="edge"/>
          <c:yMode val="edge"/>
          <c:x val="0.19316717240665376"/>
          <c:y val="0.5042411713585969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5.4421935959730598E-2"/>
          <c:y val="0.14953453769783792"/>
          <c:w val="0.3732737983553206"/>
          <c:h val="0.75965587391041001"/>
        </c:manualLayout>
      </c:layout>
      <c:doughnut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53E-453D-8E56-5AB74F792A74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53E-453D-8E56-5AB74F792A74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53E-453D-8E56-5AB74F792A74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753E-453D-8E56-5AB74F792A74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753E-453D-8E56-5AB74F792A74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753E-453D-8E56-5AB74F792A74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753E-453D-8E56-5AB74F792A74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753E-453D-8E56-5AB74F792A74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753E-453D-8E56-5AB74F792A74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753E-453D-8E56-5AB74F792A74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753E-453D-8E56-5AB74F792A74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753E-453D-8E56-5AB74F792A74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753E-453D-8E56-5AB74F792A74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753E-453D-8E56-5AB74F792A74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753E-453D-8E56-5AB74F792A74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753E-453D-8E56-5AB74F792A74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753E-453D-8E56-5AB74F792A74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753E-453D-8E56-5AB74F792A74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753E-453D-8E56-5AB74F792A74}"/>
              </c:ext>
            </c:extLst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753E-453D-8E56-5AB74F792A74}"/>
              </c:ext>
            </c:extLst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753E-453D-8E56-5AB74F792A74}"/>
              </c:ext>
            </c:extLst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753E-453D-8E56-5AB74F792A74}"/>
              </c:ext>
            </c:extLst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753E-453D-8E56-5AB74F792A74}"/>
              </c:ext>
            </c:extLst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753E-453D-8E56-5AB74F792A74}"/>
              </c:ext>
            </c:extLst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753E-453D-8E56-5AB74F792A74}"/>
              </c:ext>
            </c:extLst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753E-453D-8E56-5AB74F792A74}"/>
              </c:ext>
            </c:extLst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753E-453D-8E56-5AB74F792A74}"/>
              </c:ext>
            </c:extLst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753E-453D-8E56-5AB74F792A74}"/>
              </c:ext>
            </c:extLst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753E-453D-8E56-5AB74F792A74}"/>
              </c:ext>
            </c:extLst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753E-453D-8E56-5AB74F792A74}"/>
              </c:ext>
            </c:extLst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753E-453D-8E56-5AB74F792A74}"/>
              </c:ext>
            </c:extLst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F-753E-453D-8E56-5AB74F792A74}"/>
              </c:ext>
            </c:extLst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1-753E-453D-8E56-5AB74F792A74}"/>
              </c:ext>
            </c:extLst>
          </c:dPt>
          <c:dPt>
            <c:idx val="33"/>
            <c:bubble3D val="0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3-753E-453D-8E56-5AB74F792A74}"/>
              </c:ext>
            </c:extLst>
          </c:dPt>
          <c:dPt>
            <c:idx val="34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5-753E-453D-8E56-5AB74F792A74}"/>
              </c:ext>
            </c:extLst>
          </c:dPt>
          <c:dPt>
            <c:idx val="35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7-753E-453D-8E56-5AB74F792A74}"/>
              </c:ext>
            </c:extLst>
          </c:dPt>
          <c:cat>
            <c:strRef>
              <c:f>'[Classes found_Pie chart.xlsx]Tissue'!$G$3:$G$38</c:f>
              <c:strCache>
                <c:ptCount val="36"/>
                <c:pt idx="0">
                  <c:v>AcCa</c:v>
                </c:pt>
                <c:pt idx="1">
                  <c:v>AcHexChE</c:v>
                </c:pt>
                <c:pt idx="2">
                  <c:v>CL</c:v>
                </c:pt>
                <c:pt idx="3">
                  <c:v>CarE</c:v>
                </c:pt>
                <c:pt idx="4">
                  <c:v>Cer</c:v>
                </c:pt>
                <c:pt idx="5">
                  <c:v>CerG2GNAc1</c:v>
                </c:pt>
                <c:pt idx="6">
                  <c:v>CerG3GNAc1</c:v>
                </c:pt>
                <c:pt idx="7">
                  <c:v>CerP</c:v>
                </c:pt>
                <c:pt idx="8">
                  <c:v>ChE</c:v>
                </c:pt>
                <c:pt idx="9">
                  <c:v>Co</c:v>
                </c:pt>
                <c:pt idx="10">
                  <c:v>D5TG</c:v>
                </c:pt>
                <c:pt idx="11">
                  <c:v>DG</c:v>
                </c:pt>
                <c:pt idx="12">
                  <c:v>Hex1Cer</c:v>
                </c:pt>
                <c:pt idx="13">
                  <c:v>Hex2Cer</c:v>
                </c:pt>
                <c:pt idx="14">
                  <c:v>Hex3Cer</c:v>
                </c:pt>
                <c:pt idx="15">
                  <c:v>LBPA</c:v>
                </c:pt>
                <c:pt idx="16">
                  <c:v>LPA</c:v>
                </c:pt>
                <c:pt idx="17">
                  <c:v>LPC</c:v>
                </c:pt>
                <c:pt idx="18">
                  <c:v>LPE</c:v>
                </c:pt>
                <c:pt idx="19">
                  <c:v>LPG</c:v>
                </c:pt>
                <c:pt idx="20">
                  <c:v>LPI</c:v>
                </c:pt>
                <c:pt idx="21">
                  <c:v>LPS</c:v>
                </c:pt>
                <c:pt idx="22">
                  <c:v>LSM</c:v>
                </c:pt>
                <c:pt idx="23">
                  <c:v>PA</c:v>
                </c:pt>
                <c:pt idx="24">
                  <c:v>PC</c:v>
                </c:pt>
                <c:pt idx="25">
                  <c:v>PE</c:v>
                </c:pt>
                <c:pt idx="26">
                  <c:v>PEt</c:v>
                </c:pt>
                <c:pt idx="27">
                  <c:v>PG</c:v>
                </c:pt>
                <c:pt idx="28">
                  <c:v>PI</c:v>
                </c:pt>
                <c:pt idx="29">
                  <c:v>PIP</c:v>
                </c:pt>
                <c:pt idx="30">
                  <c:v>PS</c:v>
                </c:pt>
                <c:pt idx="31">
                  <c:v>SM</c:v>
                </c:pt>
                <c:pt idx="32">
                  <c:v>SPH</c:v>
                </c:pt>
                <c:pt idx="33">
                  <c:v>ST</c:v>
                </c:pt>
                <c:pt idx="34">
                  <c:v>TG</c:v>
                </c:pt>
                <c:pt idx="35">
                  <c:v>WE</c:v>
                </c:pt>
              </c:strCache>
            </c:strRef>
          </c:cat>
          <c:val>
            <c:numRef>
              <c:f>'[Classes found_Pie chart.xlsx]Tissue'!$I$3:$I$38</c:f>
              <c:numCache>
                <c:formatCode>General</c:formatCode>
                <c:ptCount val="36"/>
                <c:pt idx="0">
                  <c:v>1.0410641989589358</c:v>
                </c:pt>
                <c:pt idx="1">
                  <c:v>5.7836899942163102E-2</c:v>
                </c:pt>
                <c:pt idx="2">
                  <c:v>0.31810294968189706</c:v>
                </c:pt>
                <c:pt idx="3">
                  <c:v>0.26026604973973394</c:v>
                </c:pt>
                <c:pt idx="4">
                  <c:v>9.0803932909196075</c:v>
                </c:pt>
                <c:pt idx="5">
                  <c:v>8.6755349913244656E-2</c:v>
                </c:pt>
                <c:pt idx="6">
                  <c:v>0.37593984962406013</c:v>
                </c:pt>
                <c:pt idx="7">
                  <c:v>5.7836899942163102E-2</c:v>
                </c:pt>
                <c:pt idx="8">
                  <c:v>1.1278195488721805</c:v>
                </c:pt>
                <c:pt idx="9">
                  <c:v>0.20242914979757085</c:v>
                </c:pt>
                <c:pt idx="10">
                  <c:v>1.0410641989589358</c:v>
                </c:pt>
                <c:pt idx="11">
                  <c:v>5.8126084441873918</c:v>
                </c:pt>
                <c:pt idx="12">
                  <c:v>2.5737420474262578</c:v>
                </c:pt>
                <c:pt idx="13">
                  <c:v>1.7640254482359745</c:v>
                </c:pt>
                <c:pt idx="14">
                  <c:v>0.37593984962406013</c:v>
                </c:pt>
                <c:pt idx="15">
                  <c:v>1.098901098901099</c:v>
                </c:pt>
                <c:pt idx="16">
                  <c:v>0.1156737998843262</c:v>
                </c:pt>
                <c:pt idx="17">
                  <c:v>2.9207634470792367</c:v>
                </c:pt>
                <c:pt idx="18">
                  <c:v>1.3591671486408328</c:v>
                </c:pt>
                <c:pt idx="19">
                  <c:v>0.89647194910352801</c:v>
                </c:pt>
                <c:pt idx="20">
                  <c:v>0.49161364950838637</c:v>
                </c:pt>
                <c:pt idx="21">
                  <c:v>5.7836899942163102E-2</c:v>
                </c:pt>
                <c:pt idx="22">
                  <c:v>2.8918449971081551E-2</c:v>
                </c:pt>
                <c:pt idx="23">
                  <c:v>0.2891844997108155</c:v>
                </c:pt>
                <c:pt idx="24">
                  <c:v>13.157894736842104</c:v>
                </c:pt>
                <c:pt idx="25">
                  <c:v>10.092539039907461</c:v>
                </c:pt>
                <c:pt idx="26">
                  <c:v>2.8918449971081551E-2</c:v>
                </c:pt>
                <c:pt idx="27">
                  <c:v>6.130711393869289</c:v>
                </c:pt>
                <c:pt idx="28">
                  <c:v>2.2845575477154423</c:v>
                </c:pt>
                <c:pt idx="29">
                  <c:v>5.7836899942163102E-2</c:v>
                </c:pt>
                <c:pt idx="30">
                  <c:v>1.1856564488143435</c:v>
                </c:pt>
                <c:pt idx="31">
                  <c:v>8.2128397917871609</c:v>
                </c:pt>
                <c:pt idx="32">
                  <c:v>0.26026604973973394</c:v>
                </c:pt>
                <c:pt idx="33">
                  <c:v>0</c:v>
                </c:pt>
                <c:pt idx="34">
                  <c:v>26.951995373048003</c:v>
                </c:pt>
                <c:pt idx="35">
                  <c:v>0.202429149797570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8-753E-453D-8E56-5AB74F792A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75"/>
      </c:doughnut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996595151366145"/>
          <c:y val="0.25410357359176255"/>
          <c:w val="0.39634613030884092"/>
          <c:h val="0.5944849562426397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rtl="0"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307246-C036-7F89-AF99-E5679B8B8FB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AAADDF7-AE3C-BCBE-9949-458DB7F836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5BF726-45BB-DE23-0187-17E352132F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29D31-C9AE-4FF5-A82B-9A5E5AFED7D6}" type="datetimeFigureOut">
              <a:rPr lang="en-AU" smtClean="0"/>
              <a:t>6/07/2026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C2C6CB-7210-921F-FC67-270F64A3C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963C31-705F-01BE-BB33-9B30D67E9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9830-18AB-47F5-85EC-BE4E3ECDD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78329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75F8C5-97FF-36BD-D32D-EFA537DE63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076461-5904-A2EA-A0B3-DC745D496C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F5C175-250E-68F9-EC1F-2EB2AE99E1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29D31-C9AE-4FF5-A82B-9A5E5AFED7D6}" type="datetimeFigureOut">
              <a:rPr lang="en-AU" smtClean="0"/>
              <a:t>6/07/2026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E2219F-A02B-B89B-530C-3A3609814C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FBE8D6-6C7A-DE2B-E26D-3A283CB5A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9830-18AB-47F5-85EC-BE4E3ECDD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03570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D0CD6F1-7579-B3CB-96D4-399660FE5D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7729B7-7BB5-621E-E4A4-D49ACE4942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A3ADDE-2F55-1E62-FA0C-05FD5FD919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29D31-C9AE-4FF5-A82B-9A5E5AFED7D6}" type="datetimeFigureOut">
              <a:rPr lang="en-AU" smtClean="0"/>
              <a:t>6/07/2026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46BC3B-4B3E-E125-24BE-DDAC59C7C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13CC3D-C2E1-681E-17A7-2037F20AB1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9830-18AB-47F5-85EC-BE4E3ECDD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429848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3201E2-41AB-079B-6B88-AE6DA224CA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1CD741-75C9-4DEB-C95B-7712096A0B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EA9E53-FDC3-1B3F-B3E9-B35B42E2C6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29D31-C9AE-4FF5-A82B-9A5E5AFED7D6}" type="datetimeFigureOut">
              <a:rPr lang="en-AU" smtClean="0"/>
              <a:t>6/07/2026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386939-7D8A-638F-5716-E6B9645FD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68FD5A-9147-8900-AFBB-1A004F5C54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9830-18AB-47F5-85EC-BE4E3ECDD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16888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F90B2F-7853-076A-87A4-4ED3DAE2F5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7330D4-62A1-DAF3-6F7A-53B028EBD5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CEB41D-5F2C-5AD3-DE2C-F676763F40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29D31-C9AE-4FF5-A82B-9A5E5AFED7D6}" type="datetimeFigureOut">
              <a:rPr lang="en-AU" smtClean="0"/>
              <a:t>6/07/2026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C519CB-ED50-3AF9-D51B-9B76E8A985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9DF4F4-3F8B-690F-084B-80FAE4E765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9830-18AB-47F5-85EC-BE4E3ECDD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99320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897932-F289-0727-22D0-0DFFAA6661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375EAA-19FD-D57A-F597-4093B1D37D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6D3FB8-E347-4F00-3B32-D2C8C1168B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B9E5C7-4641-30D5-38DB-4B79303997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29D31-C9AE-4FF5-A82B-9A5E5AFED7D6}" type="datetimeFigureOut">
              <a:rPr lang="en-AU" smtClean="0"/>
              <a:t>6/07/2026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7BB94B-7EB3-C522-9595-52FBA70438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7F2328-0B34-6ECD-5F55-90AE7B545F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9830-18AB-47F5-85EC-BE4E3ECDD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39879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B042BC-52A3-5CAC-FD15-7D72BB4182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8E80EA-D684-6D48-6537-972B6C76C6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9609954-5479-88E2-D38E-3E8F82FB9D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BD37F31-D0B7-95D8-9E04-B0C755EC56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5015046-F3D0-CF1D-056B-3F35B764D0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507C278-82E1-2772-5CA6-C35507F7C7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29D31-C9AE-4FF5-A82B-9A5E5AFED7D6}" type="datetimeFigureOut">
              <a:rPr lang="en-AU" smtClean="0"/>
              <a:t>6/07/2026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4A3DC26-E366-1409-94B0-F61E09EBD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9379499-F107-0A74-722C-951AF28A4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9830-18AB-47F5-85EC-BE4E3ECDD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42009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7E7FE4-B731-CDAD-9F97-F5CD3F0F9F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4C476FE-8FD3-ED31-6F4E-4CD42C8A6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29D31-C9AE-4FF5-A82B-9A5E5AFED7D6}" type="datetimeFigureOut">
              <a:rPr lang="en-AU" smtClean="0"/>
              <a:t>6/07/2026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81E7F53-A772-C320-44EC-FDA0994BD4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4B883BD-544B-4ADE-39C7-AD7EBB03AB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9830-18AB-47F5-85EC-BE4E3ECDD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36353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1F4505E-C922-8084-344B-76BEE2A4EE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29D31-C9AE-4FF5-A82B-9A5E5AFED7D6}" type="datetimeFigureOut">
              <a:rPr lang="en-AU" smtClean="0"/>
              <a:t>6/07/2026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4C14EDB-45DF-7DE5-6151-6F3230CBB1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996943B-4F49-947D-3F4E-918B71CF04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9830-18AB-47F5-85EC-BE4E3ECDD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5807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AB8B37-9497-7E3A-4886-4D3730D37B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79727A-7422-BE56-6077-BEB5A7DFCC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9CD9F2-24D9-21D3-75B1-D6F17D80BB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7FE4C4-5129-43D9-8F86-DEF0F1887F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29D31-C9AE-4FF5-A82B-9A5E5AFED7D6}" type="datetimeFigureOut">
              <a:rPr lang="en-AU" smtClean="0"/>
              <a:t>6/07/2026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4B0415-6C09-E8D2-725F-006C2AD066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A30BB3-9031-3F67-FE4F-8DD4B4CF67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9830-18AB-47F5-85EC-BE4E3ECDD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60196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ABC268-90F9-AC1D-1E21-5A28D369D1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9A2122B-A1EA-2223-D019-56185DDD5E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3E8E35-61A9-90A3-C92A-9EEFE06BD7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AC6B8A-DA76-D295-E1E5-4CE3CB02CD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29D31-C9AE-4FF5-A82B-9A5E5AFED7D6}" type="datetimeFigureOut">
              <a:rPr lang="en-AU" smtClean="0"/>
              <a:t>6/07/2026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DD20EF-0611-E269-B39B-62014205C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2FCE77-F7DB-6A52-3352-515E06259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9830-18AB-47F5-85EC-BE4E3ECDD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464067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289EE1C-24DE-68C0-B53B-8ACC31CE65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5E53A1-46E9-6BAC-CCA1-83B6C8553B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2F22F8-056A-7BEB-2C13-BBE57D3EF7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B29D31-C9AE-4FF5-A82B-9A5E5AFED7D6}" type="datetimeFigureOut">
              <a:rPr lang="en-AU" smtClean="0"/>
              <a:t>6/07/2026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7C69D6-EF05-EDC5-CA50-2C027B0D93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03D704-15A1-1CB6-8163-BDEE3EB55F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ADE9830-18AB-47F5-85EC-BE4E3ECDD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18022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BFD8027-75D3-7FD5-20A9-DA03CD736E3D}"/>
              </a:ext>
            </a:extLst>
          </p:cNvPr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3"/>
          <a:stretch>
            <a:fillRect/>
          </a:stretch>
        </p:blipFill>
        <p:spPr>
          <a:xfrm>
            <a:off x="1389487" y="268881"/>
            <a:ext cx="9413026" cy="658911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69055B3-F169-0C40-D1B7-EE72D5B20675}"/>
              </a:ext>
            </a:extLst>
          </p:cNvPr>
          <p:cNvSpPr txBox="1"/>
          <p:nvPr/>
        </p:nvSpPr>
        <p:spPr>
          <a:xfrm>
            <a:off x="0" y="-32419"/>
            <a:ext cx="9050154" cy="60260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AU" sz="12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</a:t>
            </a:r>
            <a:r>
              <a:rPr lang="en-AU" sz="1200" b="1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ure</a:t>
            </a:r>
            <a:r>
              <a:rPr lang="en-AU" sz="12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S1: Flowchart of cohort selection based on the inclusion and exclusion criteria </a:t>
            </a:r>
            <a:r>
              <a:rPr lang="en-AU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</a:p>
          <a:p>
            <a:pPr>
              <a:lnSpc>
                <a:spcPct val="115000"/>
              </a:lnSpc>
              <a:spcAft>
                <a:spcPts val="800"/>
              </a:spcAft>
            </a:pPr>
            <a:endParaRPr lang="en-AU" sz="1200" kern="1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75743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E4AB7674-BEF7-1A38-6882-8A5AF044A49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820864918"/>
              </p:ext>
            </p:extLst>
          </p:nvPr>
        </p:nvGraphicFramePr>
        <p:xfrm>
          <a:off x="3514157" y="546118"/>
          <a:ext cx="6182360" cy="27292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1EBA0B7C-5537-7335-5108-FF95CBABAE45}"/>
              </a:ext>
            </a:extLst>
          </p:cNvPr>
          <p:cNvSpPr txBox="1"/>
          <p:nvPr/>
        </p:nvSpPr>
        <p:spPr>
          <a:xfrm>
            <a:off x="2963778" y="546118"/>
            <a:ext cx="6448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793ECE07-D780-9008-65D8-1AC5E366473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70949669"/>
              </p:ext>
            </p:extLst>
          </p:nvPr>
        </p:nvGraphicFramePr>
        <p:xfrm>
          <a:off x="3514157" y="3466851"/>
          <a:ext cx="6182360" cy="30378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0FDC7361-C4EC-A64F-36D4-254AEAF4459F}"/>
              </a:ext>
            </a:extLst>
          </p:cNvPr>
          <p:cNvSpPr txBox="1"/>
          <p:nvPr/>
        </p:nvSpPr>
        <p:spPr>
          <a:xfrm>
            <a:off x="2963778" y="3466851"/>
            <a:ext cx="6448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C49C046-61A7-3563-3F56-940A0B816528}"/>
              </a:ext>
            </a:extLst>
          </p:cNvPr>
          <p:cNvSpPr txBox="1"/>
          <p:nvPr/>
        </p:nvSpPr>
        <p:spPr>
          <a:xfrm>
            <a:off x="83819" y="2518"/>
            <a:ext cx="8925025" cy="2766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AU" sz="12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</a:t>
            </a:r>
            <a:r>
              <a:rPr lang="en-AU" sz="1200" b="1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ure</a:t>
            </a:r>
            <a:r>
              <a:rPr lang="en-AU" sz="12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S2: Graphical representation of the lipid class distribution in the plasma and liver tissue detected by LC-MS/MS </a:t>
            </a:r>
            <a:endParaRPr lang="en-AU" sz="1200" kern="1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09826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FF41000-F49B-8EE8-C792-EBEE0E43EDC1}"/>
              </a:ext>
            </a:extLst>
          </p:cNvPr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3"/>
          <a:srcRect l="12029" t="32330" r="5441" b="20579"/>
          <a:stretch>
            <a:fillRect/>
          </a:stretch>
        </p:blipFill>
        <p:spPr>
          <a:xfrm>
            <a:off x="1380935" y="261695"/>
            <a:ext cx="10073129" cy="402336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8112093-6E54-E3DC-EF4B-CC29C980CDA6}"/>
              </a:ext>
            </a:extLst>
          </p:cNvPr>
          <p:cNvSpPr txBox="1"/>
          <p:nvPr/>
        </p:nvSpPr>
        <p:spPr>
          <a:xfrm>
            <a:off x="230861" y="117874"/>
            <a:ext cx="8354873" cy="2876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AU" sz="1200" b="1" kern="10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</a:t>
            </a:r>
            <a:r>
              <a:rPr lang="en-AU" sz="1200" b="1" kern="10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ure</a:t>
            </a:r>
            <a:r>
              <a:rPr lang="en-AU" sz="1200" b="1" kern="10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AU" sz="12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3: General trend of lipid classes in plasma across MAFLD, </a:t>
            </a:r>
            <a:r>
              <a:rPr lang="en-AU" sz="1200" b="1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c</a:t>
            </a:r>
            <a:r>
              <a:rPr lang="en-AU" sz="12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AFLD-HCC and </a:t>
            </a:r>
            <a:r>
              <a:rPr lang="en-AU" sz="1200" b="1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AU" sz="12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AFLD-HCC cohorts</a:t>
            </a:r>
            <a:r>
              <a:rPr lang="en-AU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1198562077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8a50ed9a5dd4d5763fe5c68"/>
  <p:tag name="BIOJSON" val="{&quot;id&quot;:&quot;1e0c7d69-be41-4b73-bb5e-091bcf22d899&quot;,&quot;objects&quot;:{&quot;1e0c7d69-be41-4b73-bb5e-091bcf22d899&quot;:{&quot;id&quot;:&quot;1e0c7d69-be41-4b73-bb5e-091bcf22d899&quot;,&quot;type&quot;:&quot;FIGURE_OBJECT&quot;,&quot;document&quot;:{&quot;type&quot;:&quot;DOCUMENT_GROUP&quot;,&quot;canvasType&quot;:&quot;FIGURE&quot;,&quot;units&quot;:&quot;in&quot;}},&quot;39c6d49a-a1d6-40de-80be-c10a48dfd4cd&quot;:{&quot;id&quot;:&quot;39c6d49a-a1d6-40de-80be-c10a48dfd4cd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1e0c7d69-be41-4b73-bb5e-091bcf22d899&quot;,&quot;type&quot;:&quot;FRAME&quot;,&quot;order&quot;:&quot;5&quot;}},&quot;865a3a62-89db-4a0f-9081-e39324f060c0&quot;:{&quot;id&quot;:&quot;865a3a62-89db-4a0f-9081-e39324f060c0&quot;,&quot;type&quot;:&quot;FIGURE_OBJECT&quot;,&quot;document&quot;:{&quot;type&quot;:&quot;FIGURE&quot;,&quot;canvasType&quot;:&quot;FIGURE&quot;,&quot;units&quot;:&quot;in&quot;},&quot;parent&quot;:{&quot;parentId&quot;:&quot;1e0c7d69-be41-4b73-bb5e-091bcf22d899&quot;,&quot;type&quot;:&quot;DOCUMENT&quot;,&quot;order&quot;:&quot;5&quot;}},&quot;03dfd604-4d30-4f73-a9d5-04aa8596ce33&quot;:{&quot;id&quot;:&quot;03dfd604-4d30-4f73-a9d5-04aa8596ce33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865a3a62-89db-4a0f-9081-e39324f060c0&quot;,&quot;order&quot;:&quot;5&quot;}},&quot;f6b58ba0-1272-45ba-b88a-ec40e0cba2f9&quot;:{&quot;id&quot;:&quot;f6b58ba0-1272-45ba-b88a-ec40e0cba2f9&quot;,&quot;type&quot;:&quot;FIGURE_OBJECT&quot;,&quot;guide&quot;:{&quot;type&quot;:&quot;GRID&quot;,&quot;distance&quot;:0.5,&quot;units&quot;:&quot;in&quot;},&quot;parent&quot;:{&quot;parentId&quot;:&quot;1e0c7d69-be41-4b73-bb5e-091bcf22d899&quot;,&quot;type&quot;:&quot;GUIDE&quot;,&quot;order&quot;:&quot;5&quot;}},&quot;18fc379b-013e-4307-af42-cc15f8408038&quot;:{&quot;relativeTransform&quot;:{&quot;translate&quot;:{&quot;x&quot;:-187.6947400763662,&quot;y&quot;:-169.48308067968023},&quot;rotate&quot;:0,&quot;skewX&quot;:0,&quot;scale&quot;:{&quot;x&quot;:1,&quot;y&quot;:1}},&quot;type&quot;:&quot;FIGURE_OBJECT&quot;,&quot;id&quot;:&quot;18fc379b-013e-4307-af42-cc15f8408038&quot;,&quot;parent&quot;:{&quot;type&quot;:&quot;CHILD&quot;,&quot;parentId&quot;:&quot;865a3a62-89db-4a0f-9081-e39324f060c0&quot;,&quot;order&quot;:&quot;7&quot;},&quot;name&quot;:&quot;Flow chart (screening funnel)&quot;,&quot;displayName&quot;:&quot;Flow chart (screening funnel)&quot;,&quot;source&quot;:{&quot;id&quot;:&quot;645551def11a26485b20bd98&quot;,&quot;type&quot;:&quot;ASSETS&quot;},&quot;isPremium&quot;:true},&quot;25659034-5deb-4786-98ab-be567126fa62&quot;:{&quot;type&quot;:&quot;FIGURE_OBJECT&quot;,&quot;id&quot;:&quot;25659034-5deb-4786-98ab-be567126fa62&quot;,&quot;relativeTransform&quot;:{&quot;translate&quot;:{&quot;x&quot;:-110.31616909793102,&quot;y&quot;:-100.11472512659003},&quot;rotate&quot;:0,&quot;skewX&quot;:0,&quot;scale&quot;:{&quot;x&quot;:1,&quot;y&quot;:1}},&quot;layout&quot;:{&quot;sizeRatio&quot;:{&quot;x&quot;:0.99328165374677,&quot;y&quot;:0.95},&quot;keepAspectRatio&quot;:false},&quot;opacity&quot;:1,&quot;path&quot;:{&quot;type&quot;:&quot;RECT&quot;,&quot;size&quot;:{&quot;x&quot;:292.15961377718537,&quot;y&quot;:65.67755353686482},&quot;cornerRounding&quot;:{&quot;type&quot;:&quot;ARC_LENGTH&quot;,&quot;global&quot;:7.15920267128069}},&quot;pathStyles&quot;:[{&quot;type&quot;:&quot;FILL&quot;,&quot;fillStyle&quot;:&quot;rgba(237, 217, 186, 1)&quot;},{&quot;type&quot;:&quot;STROKE&quot;,&quot;strokeStyle&quot;:&quot;rgba(138, 79, 33, 1)&quot;,&quot;lineWidth&quot;:1.62,&quot;lineJoin&quot;:&quot;round&quot;}],&quot;isLocked&quot;:false,&quot;parent&quot;:{&quot;type&quot;:&quot;CHILD&quot;,&quot;parentId&quot;:&quot;18fc379b-013e-4307-af42-cc15f8408038&quot;,&quot;order&quot;:&quot;2&quot;}},&quot;13f8e085-cd65-461b-a605-254f361f2014&quot;:{&quot;type&quot;:&quot;FIGURE_OBJECT&quot;,&quot;id&quot;:&quot;13f8e085-cd65-461b-a605-254f361f2014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6,&quot;color&quot;:&quot;rgb(0,0,0)&quot;,&quot;fontWeight&quot;:&quot;normal&quot;,&quot;fontStyle&quot;:&quot;normal&quot;,&quot;decoration&quot;:&quot;none&quot;,&quot;script&quot;:&quot;none&quot;},&quot;range&quot;:[0,13]}],&quot;text&quot;:&quot;MAFLD patients&quot;,&quot;baseStyle&quot;:{&quot;fontFamily&quot;:&quot;Roboto&quot;,&quot;fontSize&quot;:16,&quot;color&quot;:&quot;black&quot;,&quot;fontWeight&quot;:&quot;normal&quot;,&quot;fontStyle&quot;:&quot;normal&quot;,&quot;decoration&quot;:&quot;none&quot;,&quot;script&quot;:&quot;none&quot;}},{&quot;runs&quot;:[],&quot;text&quot;:&quot;&quot;,&quot;baseStyle&quot;:{&quot;fontFamily&quot;:&quot;Roboto&quot;,&quot;fontSize&quot;:13.333333333333332,&quot;color&quot;:&quot;rgba(23,23,23,1)&quot;,&quot;fontWeight&quot;:&quot;normal&quot;,&quot;fontStyle&quot;:&quot;normal&quot;,&quot;decoration&quot;:&quot;none&quot;,&quot;script&quot;:&quot;none&quot;}},{&quot;runs&quot;:[{&quot;style&quot;:{&quot;fontFamily&quot;:&quot;Roboto&quot;,&quot;fontSize&quot;:13.333333333333332,&quot;color&quot;:&quot;rgb(0,0,0)&quot;,&quot;fontWeight&quot;:&quot;normal&quot;,&quot;fontStyle&quot;:&quot;normal&quot;,&quot;decoration&quot;:&quot;none&quot;,&quot;script&quot;:&quot;none&quot;},&quot;range&quot;:[0,30]}],&quot;text&quot;:&quot;Diagnosis- clinical and imaging&quot;,&quot;baseStyle&quot;:{&quot;fontFamily&quot;:&quot;Roboto&quot;,&quot;fontSize&quot;:13.333333333333332,&quot;color&quot;:&quot;rgba(23,23,23,1)&quot;,&quot;fontWeight&quot;:&quot;normal&quot;,&quot;fontStyle&quot;:&quot;normal&quot;,&quot;decoration&quot;:&quot;none&quot;,&quot;script&quot;:&quot;none&quot;}}],&quot;verticalAlign&quot;:&quot;TOP&quot;,&quot;_lastCaretLocation&quot;:{&quot;lineIndex&quot;:0,&quot;runIndex&quot;:-1,&quot;charIndex&quot;:-1,&quot;endOfLine&quot;:true}},&quot;size&quot;:{&quot;x&quot;:290.1967843306203,&quot;y&quot;:49},&quot;targetSize&quot;:{&quot;x&quot;:290.1967843306203,&quot;y&quot;:2},&quot;format&quot;:&quot;BETTER_TEXT&quot;},&quot;parent&quot;:{&quot;type&quot;:&quot;CHILD&quot;,&quot;parentId&quot;:&quot;25659034-5deb-4786-98ab-be567126fa62&quot;,&quot;order&quot;:&quot;5&quot;}},&quot;e076035a-34a7-4d83-bff4-37f635830637&quot;:{&quot;type&quot;:&quot;FIGURE_OBJECT&quot;,&quot;id&quot;:&quot;e076035a-34a7-4d83-bff4-37f635830637&quot;,&quot;relativeTransform&quot;:{&quot;translate&quot;:{&quot;x&quot;:0,&quot;y&quot;:0},&quot;rotate&quot;:0,&quot;skewX&quot;:0,&quot;scale&quot;:{&quot;x&quot;:1,&quot;y&quot;:1}},&quot;opacity&quot;:1,&quot;path&quot;:{&quot;type&quot;:&quot;POLY_LINE&quot;,&quot;points&quot;:[{&quot;x&quot;:-110.31616909793102,&quot;y&quot;:-67.27594835815762},{&quot;x&quot;:-110.31600534329189,&quot;y&quot;:169.64213502053076}],&quot;closed&quot;:false},&quot;pathStyles&quot;:[{&quot;type&quot;:&quot;FILL&quot;,&quot;fillStyle&quot;:&quot;rgba(0,0,0,0)&quot;},{&quot;type&quot;:&quot;STROKE&quot;,&quot;strokeStyle&quot;:&quot;rgba(138, 79, 33, 1)&quot;,&quot;lineWidth&quot;:2.337276910217483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18fc379b-013e-4307-af42-cc15f8408038&quot;,&quot;order&quot;:&quot;5&quot;},&quot;connectorInfo&quot;:{&quot;type&quot;:&quot;LINE&quot;,&quot;offset&quot;:{&quot;x&quot;:0,&quot;y&quot;:0},&quot;bending&quot;:0.1,&quot;customized&quot;:true,&quot;connectedObjectAtLineStart&quot;:{&quot;objectId&quot;:&quot;25659034-5deb-4786-98ab-be567126fa62&quot;,&quot;coordinates&quot;:{&quot;x&quot;:0.5,&quot;y&quot;:1}},&quot;connectedObjectAtLineEnd&quot;:{&quot;objectId&quot;:&quot;8762b755-d2ee-4c3a-89c8-8ad0d07defb3&quot;,&quot;coordinates&quot;:{&quot;x&quot;:0.5,&quot;y&quot;:0}}}},&quot;8762b755-d2ee-4c3a-89c8-8ad0d07defb3&quot;:{&quot;type&quot;:&quot;FIGURE_OBJECT&quot;,&quot;id&quot;:&quot;8762b755-d2ee-4c3a-89c8-8ad0d07defb3&quot;,&quot;relativeTransform&quot;:{&quot;translate&quot;:{&quot;x&quot;:-110.31600534329189,&quot;y&quot;:208.31091355467512},&quot;rotate&quot;:0,&quot;skewX&quot;:0,&quot;scale&quot;:{&quot;x&quot;:1,&quot;y&quot;:1}},&quot;layout&quot;:{&quot;sizeRatio&quot;:{&quot;x&quot;:0.99328165374677,&quot;y&quot;:0.95},&quot;keepAspectRatio&quot;:false},&quot;opacity&quot;:1,&quot;path&quot;:{&quot;type&quot;:&quot;RECT&quot;,&quot;size&quot;:{&quot;x&quot;:119.21846449459807,&quot;y&quot;:77.33755706828873},&quot;cornerRounding&quot;:{&quot;type&quot;:&quot;ARC_LENGTH&quot;,&quot;global&quot;:7.1377808468139055}},&quot;pathStyles&quot;:[{&quot;type&quot;:&quot;FILL&quot;,&quot;fillStyle&quot;:&quot;rgba(251, 253, 242, 1)&quot;},{&quot;type&quot;:&quot;STROKE&quot;,&quot;strokeStyle&quot;:&quot;rgba(196, 206, 146, 1)&quot;,&quot;lineWidth&quot;:1.62,&quot;lineJoin&quot;:&quot;round&quot;}],&quot;isLocked&quot;:false,&quot;parent&quot;:{&quot;type&quot;:&quot;CHILD&quot;,&quot;parentId&quot;:&quot;18fc379b-013e-4307-af42-cc15f8408038&quot;,&quot;order&quot;:&quot;8&quot;}},&quot;131e56b2-71ab-4544-8c3c-f5eceb2ae32f&quot;:{&quot;type&quot;:&quot;FIGURE_OBJECT&quot;,&quot;id&quot;:&quot;131e56b2-71ab-4544-8c3c-f5eceb2ae32f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6,&quot;color&quot;:&quot;rgb(0,0,0)&quot;,&quot;fontWeight&quot;:&quot;normal&quot;,&quot;fontStyle&quot;:&quot;normal&quot;,&quot;decoration&quot;:&quot;none&quot;,&quot;script&quot;:&quot;none&quot;},&quot;range&quot;:[0,14]},{&quot;style&quot;:{&quot;fontFamily&quot;:&quot;Roboto&quot;,&quot;fontSize&quot;:13.333333333333332,&quot;color&quot;:&quot;rgb(0,0,0)&quot;,&quot;fontWeight&quot;:&quot;normal&quot;,&quot;fontStyle&quot;:&quot;normal&quot;,&quot;decoration&quot;:&quot;none&quot;,&quot;script&quot;:&quot;none&quot;},&quot;range&quot;:[15,31]}],&quot;text&quot;:&quot;MAFLD patients Fibrosis score &lt;2&quot;}],&quot;verticalAlign&quot;:&quot;TOP&quot;,&quot;_lastCaretLocation&quot;:{&quot;lineIndex&quot;:0,&quot;runIndex&quot;:-1,&quot;charIndex&quot;:-1,&quot;endOfLine&quot;:true}},&quot;size&quot;:{&quot;x&quot;:118.41751357034497,&quot;y&quot;:34},&quot;targetSize&quot;:{&quot;x&quot;:118.41751357034497,&quot;y&quot;:2},&quot;format&quot;:&quot;BETTER_TEXT&quot;},&quot;parent&quot;:{&quot;type&quot;:&quot;CHILD&quot;,&quot;parentId&quot;:&quot;8762b755-d2ee-4c3a-89c8-8ad0d07defb3&quot;,&quot;order&quot;:&quot;5&quot;}},&quot;e7f9be2d-d2e4-4a49-a84f-9fd0d9cd98f6&quot;:{&quot;type&quot;:&quot;FIGURE_OBJECT&quot;,&quot;id&quot;:&quot;e7f9be2d-d2e4-4a49-a84f-9fd0d9cd98f6&quot;,&quot;relativeTransform&quot;:{&quot;translate&quot;:{&quot;x&quot;:0,&quot;y&quot;:213.19538005728208},&quot;rotate&quot;:0},&quot;opacity&quot;:1,&quot;path&quot;:{&quot;type&quot;:&quot;POLY_LINE&quot;,&quot;points&quot;:[{&quot;x&quot;:-110.31616923881482,&quot;y&quot;:35.66599160106351},{&quot;x&quot;:-110.31616923881482,&quot;y&quot;:68.08343507354084}],&quot;closed&quot;:false},&quot;pathStyles&quot;:[{&quot;type&quot;:&quot;FILL&quot;,&quot;fillStyle&quot;:&quot;rgba(0,0,0,0)&quot;},{&quot;type&quot;:&quot;STROKE&quot;,&quot;strokeStyle&quot;:&quot;rgb(138, 79, 33)&quot;,&quot;lineWidth&quot;:2.337276910217483,&quot;lineJoin&quot;:&quot;round&quot;}],&quot;pathMarkers&quot;:{},&quot;isLocked&quot;:false,&quot;parent&quot;:{&quot;type&quot;:&quot;CHILD&quot;,&quot;parentId&quot;:&quot;18fc379b-013e-4307-af42-cc15f8408038&quot;,&quot;order&quot;:&quot;9&quot;},&quot;connectorInfo&quot;:{&quot;connectedObjects&quot;:[],&quot;type&quot;:&quot;LINE&quot;,&quot;offset&quot;:{&quot;x&quot;:0,&quot;y&quot;:0},&quot;bending&quot;:0.1,&quot;firstElementIsHead&quot;:false,&quot;customized&quot;:true}},&quot;d00d50a3-cea4-41ab-a3b4-1790f0ea7e66&quot;:{&quot;type&quot;:&quot;FIGURE_OBJECT&quot;,&quot;id&quot;:&quot;d00d50a3-cea4-41ab-a3b4-1790f0ea7e66&quot;,&quot;relativeTransform&quot;:{&quot;translate&quot;:{&quot;x&quot;:203.011,&quot;y&quot;:260.0672070395091},&quot;rotate&quot;:0},&quot;opacity&quot;:1,&quot;path&quot;:{&quot;type&quot;:&quot;POLY_LINE&quot;,&quot;points&quot;:[{&quot;x&quot;:-110.31616923881482,&quot;y&quot;:-11.20583569110769},{&quot;x&quot;:-110.31616923881482,&quot;y&quot;:20.211288863759442}],&quot;closed&quot;:false},&quot;pathStyles&quot;:[{&quot;type&quot;:&quot;FILL&quot;,&quot;fillStyle&quot;:&quot;rgba(0,0,0,0)&quot;},{&quot;type&quot;:&quot;STROKE&quot;,&quot;strokeStyle&quot;:&quot;rgba(138, 79, 33, 1)&quot;,&quot;lineWidth&quot;:2.337276910217483,&quot;lineJoin&quot;:&quot;round&quot;}],&quot;pathMarkers&quot;:{},&quot;isLocked&quot;:false,&quot;parent&quot;:{&quot;type&quot;:&quot;CHILD&quot;,&quot;parentId&quot;:&quot;18fc379b-013e-4307-af42-cc15f8408038&quot;,&quot;order&quot;:&quot;95&quot;},&quot;connectorInfo&quot;:{&quot;connectedObjects&quot;:[],&quot;type&quot;:&quot;LINE&quot;,&quot;offset&quot;:{&quot;x&quot;:0,&quot;y&quot;:0},&quot;bending&quot;:0.1,&quot;firstElementIsHead&quot;:false,&quot;customized&quot;:true}},&quot;c2ffcce7-d35c-4a28-b10d-43e12e999ce7&quot;:{&quot;type&quot;:&quot;FIGURE_OBJECT&quot;,&quot;id&quot;:&quot;c2ffcce7-d35c-4a28-b10d-43e12e999ce7&quot;,&quot;relativeTransform&quot;:{&quot;translate&quot;:{&quot;x&quot;:406.02200000000005,&quot;y&quot;:260.1524740523521},&quot;rotate&quot;:0},&quot;opacity&quot;:1,&quot;path&quot;:{&quot;type&quot;:&quot;POLY_LINE&quot;,&quot;points&quot;:[{&quot;x&quot;:-110.31616923881482,&quot;y&quot;:-11.291102858922798},{&quot;x&quot;:-110.31616923881484,&quot;y&quot;:21.126021850916445}],&quot;closed&quot;:false},&quot;pathStyles&quot;:[{&quot;type&quot;:&quot;FILL&quot;,&quot;fillStyle&quot;:&quot;rgba(0,0,0,0)&quot;},{&quot;type&quot;:&quot;STROKE&quot;,&quot;strokeStyle&quot;:&quot;rgba(138, 79, 33, 1)&quot;,&quot;lineWidth&quot;:2.337276910217483,&quot;lineJoin&quot;:&quot;round&quot;}],&quot;pathMarkers&quot;:{},&quot;isLocked&quot;:false,&quot;parent&quot;:{&quot;type&quot;:&quot;CHILD&quot;,&quot;parentId&quot;:&quot;18fc379b-013e-4307-af42-cc15f8408038&quot;,&quot;order&quot;:&quot;4&quot;},&quot;connectorInfo&quot;:{&quot;connectedObjects&quot;:[],&quot;type&quot;:&quot;LINE&quot;,&quot;offset&quot;:{&quot;x&quot;:0,&quot;y&quot;:0},&quot;bending&quot;:0.1,&quot;firstElementIsHead&quot;:false,&quot;customized&quot;:true}},&quot;f92d4c55-49ba-4923-a293-cfda67b05fe1&quot;:{&quot;type&quot;:&quot;FIGURE_OBJECT&quot;,&quot;id&quot;:&quot;f92d4c55-49ba-4923-a293-cfda67b05fe1&quot;,&quot;relativeTransform&quot;:{&quot;translate&quot;:{&quot;x&quot;:35.697111850453055,&quot;y&quot;:171.29989676626218},&quot;rotate&quot;:-1.570796326794897},&quot;opacity&quot;:1,&quot;path&quot;:{&quot;type&quot;:&quot;POLY_LINE&quot;,&quot;points&quot;:[{&quot;x&quot;:-110.31616923881482,&quot;y&quot;:-146.01403021501383},{&quot;x&quot;:-110.31616923881501,&quot;y&quot;:259.6710949033883}],&quot;closed&quot;:false},&quot;pathStyles&quot;:[{&quot;type&quot;:&quot;FILL&quot;,&quot;fillStyle&quot;:&quot;rgba(0,0,0,0)&quot;},{&quot;type&quot;:&quot;STROKE&quot;,&quot;strokeStyle&quot;:&quot;rgba(138, 79, 33, 1)&quot;,&quot;lineWidth&quot;:2.337276910217483,&quot;lineJoin&quot;:&quot;round&quot;}],&quot;pathMarkers&quot;:{},&quot;isLocked&quot;:false,&quot;parent&quot;:{&quot;type&quot;:&quot;CHILD&quot;,&quot;parentId&quot;:&quot;18fc379b-013e-4307-af42-cc15f8408038&quot;,&quot;order&quot;:&quot;98&quot;},&quot;connectorInfo&quot;:{&quot;connectedObjects&quot;:[],&quot;type&quot;:&quot;LINE&quot;,&quot;offset&quot;:{&quot;x&quot;:0,&quot;y&quot;:0},&quot;bending&quot;:0.1,&quot;firstElementIsHead&quot;:false,&quot;customized&quot;:true}},&quot;2bccf4f8-e15c-4dfb-9126-60cfcd5c1926&quot;:{&quot;type&quot;:&quot;FIGURE_OBJECT&quot;,&quot;id&quot;:&quot;2bccf4f8-e15c-4dfb-9126-60cfcd5c1926&quot;,&quot;relativeTransform&quot;:{&quot;translate&quot;:{&quot;x&quot;:15.31625992363378,&quot;y&quot;:127.64326157703391},&quot;rotate&quot;:0,&quot;skewX&quot;:0,&quot;scale&quot;:{&quot;x&quot;:1,&quot;y&quot;:1}},&quot;opacity&quot;:1,&quot;path&quot;:{&quot;type&quot;:&quot;POLY_LINE&quot;,&quot;points&quot;:[{&quot;x&quot;:-110.31616923881482,&quot;y&quot;:-13.172290699401994},{&quot;x&quot;:-110.31590391679599,&quot;y&quot;:23.245153646554378}],&quot;closed&quot;:false},&quot;pathStyles&quot;:[{&quot;type&quot;:&quot;FILL&quot;,&quot;fillStyle&quot;:&quot;rgba(0,0,0,0)&quot;},{&quot;type&quot;:&quot;STROKE&quot;,&quot;strokeStyle&quot;:&quot;rgb(138, 79, 33)&quot;,&quot;lineWidth&quot;:2.337276910217483,&quot;lineJoin&quot;:&quot;round&quot;}],&quot;pathMarkers&quot;:{&quot;markerEnd&quot;:{&quot;type&quot;:&quot;PATH&quot;,&quot;units&quot;:{&quot;type&quot;:&quot;STROKE_WIDTH&quot;,&quot;scale&quot;:0.9887574363260839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65a3a62-89db-4a0f-9081-e39324f060c0&quot;,&quot;order&quot;:&quot;8&quot;},&quot;connectorInfo&quot;:{&quot;connectedObjects&quot;:[],&quot;type&quot;:&quot;LINE&quot;,&quot;offset&quot;:{&quot;x&quot;:0,&quot;y&quot;:0},&quot;bending&quot;:0.1,&quot;firstElementIsHead&quot;:false,&quot;customized&quot;:true}},&quot;30f266c0-9097-4acf-8467-5c33f508e395&quot;:{&quot;type&quot;:&quot;FIGURE_OBJECT&quot;,&quot;id&quot;:&quot;30f266c0-9097-4acf-8467-5c33f508e395&quot;,&quot;relativeTransform&quot;:{&quot;translate&quot;:{&quot;x&quot;:-94.99990931518104,&quot;y&quot;:277.5986941585088},&quot;rotate&quot;:0,&quot;skewX&quot;:0,&quot;scale&quot;:{&quot;x&quot;:1,&quot;y&quot;:1}},&quot;layout&quot;:{&quot;sizeRatio&quot;:{&quot;x&quot;:0.99328165374677,&quot;y&quot;:0.95},&quot;keepAspectRatio&quot;:false},&quot;opacity&quot;:1,&quot;path&quot;:{&quot;type&quot;:&quot;RECT&quot;,&quot;size&quot;:{&quot;x&quot;:292.15961377718537,&quot;y&quot;:59.082553438246286},&quot;cornerRounding&quot;:{&quot;type&quot;:&quot;ARC_LENGTH&quot;,&quot;global&quot;:7.15920267128069}},&quot;pathStyles&quot;:[{&quot;type&quot;:&quot;FILL&quot;,&quot;fillStyle&quot;:&quot;rgba(251, 253, 242, 1)&quot;},{&quot;type&quot;:&quot;STROKE&quot;,&quot;strokeStyle&quot;:&quot;rgba(196, 206, 146, 1)&quot;,&quot;lineWidth&quot;:1.62,&quot;lineJoin&quot;:&quot;round&quot;}],&quot;isLocked&quot;:false,&quot;parent&quot;:{&quot;type&quot;:&quot;CHILD&quot;,&quot;parentId&quot;:&quot;865a3a62-89db-4a0f-9081-e39324f060c0&quot;,&quot;order&quot;:&quot;9&quot;}},&quot;e5fa4bea-1bf4-4bbc-a4be-9d8ee5c1c129&quot;:{&quot;type&quot;:&quot;FIGURE_OBJECT&quot;,&quot;id&quot;:&quot;e5fa4bea-1bf4-4bbc-a4be-9d8ee5c1c129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6,&quot;color&quot;:&quot;rgb(0,0,0)&quot;,&quot;fontWeight&quot;:&quot;normal&quot;,&quot;fontStyle&quot;:&quot;normal&quot;,&quot;decoration&quot;:&quot;none&quot;,&quot;script&quot;:&quot;none&quot;},&quot;range&quot;:[0,38]}],&quot;text&quot;:&quot;Liquid chromatography-Mass spectrometry&quot;,&quot;baseStyle&quot;:{&quot;fontFamily&quot;:&quot;Roboto&quot;,&quot;fontSize&quot;:16,&quot;color&quot;:&quot;rgba(23,23,23,1)&quot;,&quot;fontWeight&quot;:&quot;normal&quot;,&quot;fontStyle&quot;:&quot;normal&quot;,&quot;decoration&quot;:&quot;none&quot;,&quot;script&quot;:&quot;none&quot;}}],&quot;verticalAlign&quot;:&quot;TOP&quot;,&quot;_lastCaretLocation&quot;:{&quot;lineIndex&quot;:0,&quot;runIndex&quot;:-1,&quot;charIndex&quot;:-1,&quot;endOfLine&quot;:true}},&quot;size&quot;:{&quot;x&quot;:290.1967843306204,&quot;y&quot;:38},&quot;targetSize&quot;:{&quot;x&quot;:290.1967843306204,&quot;y&quot;:2},&quot;format&quot;:&quot;BETTER_TEXT&quot;},&quot;parent&quot;:{&quot;type&quot;:&quot;CHILD&quot;,&quot;parentId&quot;:&quot;30f266c0-9097-4acf-8467-5c33f508e395&quot;,&quot;order&quot;:&quot;5&quot;}},&quot;7b2b0e4b-193e-43ff-a997-89ed58a7f470&quot;:{&quot;type&quot;:&quot;FIGURE_OBJECT&quot;,&quot;id&quot;:&quot;7b2b0e4b-193e-43ff-a997-89ed58a7f470&quot;,&quot;relativeTransform&quot;:{&quot;translate&quot;:{&quot;x&quot;:-94.9997829123641,&quot;y&quot;:181.1310131975174},&quot;rotate&quot;:0,&quot;skewX&quot;:0,&quot;scale&quot;:{&quot;x&quot;:1,&quot;y&quot;:1}},&quot;layout&quot;:{&quot;sizeRatio&quot;:{&quot;x&quot;:0.99328165374677,&quot;y&quot;:0.95},&quot;keepAspectRatio&quot;:false},&quot;opacity&quot;:1,&quot;path&quot;:{&quot;type&quot;:&quot;RECT&quot;,&quot;size&quot;:{&quot;x&quot;:230.2939469817862,&quot;y&quot;:56.77219086912988},&quot;cornerRounding&quot;:{&quot;type&quot;:&quot;ARC_LENGTH&quot;,&quot;global&quot;:6.879249403964083}},&quot;pathStyles&quot;:[{&quot;type&quot;:&quot;FILL&quot;,&quot;fillStyle&quot;:&quot;rgba(251, 253, 242, 1)&quot;},{&quot;type&quot;:&quot;STROKE&quot;,&quot;strokeStyle&quot;:&quot;rgba(196, 206, 146, 1)&quot;,&quot;lineWidth&quot;:1.62,&quot;lineJoin&quot;:&quot;round&quot;}],&quot;isLocked&quot;:false,&quot;parent&quot;:{&quot;type&quot;:&quot;CHILD&quot;,&quot;parentId&quot;:&quot;865a3a62-89db-4a0f-9081-e39324f060c0&quot;,&quot;order&quot;:&quot;95&quot;}},&quot;0cca777f-f01b-419d-a5ba-8dcf333e6e00&quot;:{&quot;type&quot;:&quot;FIGURE_OBJECT&quot;,&quot;id&quot;:&quot;0cca777f-f01b-419d-a5ba-8dcf333e6e00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6,&quot;color&quot;:&quot;rgb(0,0,0)&quot;,&quot;fontWeight&quot;:&quot;normal&quot;,&quot;fontStyle&quot;:&quot;normal&quot;,&quot;decoration&quot;:&quot;none&quot;,&quot;script&quot;:&quot;none&quot;},&quot;range&quot;:[0,24]}],&quot;text&quot;:&quot;Plasma and tissue samples&quot;}],&quot;verticalAlign&quot;:&quot;TOP&quot;,&quot;_lastCaretLocation&quot;:{&quot;lineIndex&quot;:0,&quot;runIndex&quot;:-1,&quot;charIndex&quot;:-1,&quot;endOfLine&quot;:true}},&quot;size&quot;:{&quot;x&quot;:228.74675250593955,&quot;y&quot;:19},&quot;targetSize&quot;:{&quot;x&quot;:228.74675250593955,&quot;y&quot;:2},&quot;format&quot;:&quot;BETTER_TEXT&quot;},&quot;parent&quot;:{&quot;type&quot;:&quot;CHILD&quot;,&quot;parentId&quot;:&quot;7b2b0e4b-193e-43ff-a997-89ed58a7f470&quot;,&quot;order&quot;:&quot;5&quot;}},&quot;0cd5ff76-777a-4fc2-9ce1-0a52fdb604df&quot;:{&quot;relativeTransform&quot;:{&quot;translate&quot;:{&quot;x&quot;:114.20858583297576,&quot;y&quot;:-174.6588239516709},&quot;rotate&quot;:0,&quot;skewX&quot;:0,&quot;scale&quot;:{&quot;x&quot;:1,&quot;y&quot;:1}},&quot;type&quot;:&quot;FIGURE_OBJECT&quot;,&quot;id&quot;:&quot;0cd5ff76-777a-4fc2-9ce1-0a52fdb604df&quot;,&quot;parent&quot;:{&quot;type&quot;:&quot;CHILD&quot;,&quot;parentId&quot;:&quot;865a3a62-89db-4a0f-9081-e39324f060c0&quot;,&quot;order&quot;:&quot;5&quot;},&quot;name&quot;:&quot;Flow chart (screening funnel)&quot;,&quot;displayName&quot;:&quot;Flow chart (screening funnel)&quot;,&quot;source&quot;:{&quot;id&quot;:&quot;645551def11a26485b20bd98&quot;,&quot;type&quot;:&quot;ASSETS&quot;},&quot;isPremium&quot;:true},&quot;48e3587e-0645-4622-8b66-3d267bb53448&quot;:{&quot;type&quot;:&quot;FIGURE_OBJECT&quot;,&quot;id&quot;:&quot;48e3587e-0645-4622-8b66-3d267bb53448&quot;,&quot;relativeTransform&quot;:{&quot;translate&quot;:{&quot;x&quot;:0,&quot;y&quot;:0},&quot;rotate&quot;:0,&quot;skewX&quot;:0,&quot;scale&quot;:{&quot;x&quot;:1,&quot;y&quot;:1}},&quot;opacity&quot;:1,&quot;path&quot;:{&quot;type&quot;:&quot;POLY_LINE&quot;,&quot;points&quot;:[{&quot;x&quot;:-106.00236874533985,&quot;y&quot;:-65.11245264806269},{&quot;x&quot;:-106.00236874533985,&quot;y&quot;:-26.88925827128824}],&quot;closed&quot;:false},&quot;pathStyles&quot;:[{&quot;type&quot;:&quot;FILL&quot;,&quot;fillStyle&quot;:&quot;rgba(0,0,0,0)&quot;},{&quot;type&quot;:&quot;STROKE&quot;,&quot;strokeStyle&quot;:&quot;rgba(138, 79, 33, 1)&quot;,&quot;lineWidth&quot;:2.24588009723663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0cd5ff76-777a-4fc2-9ce1-0a52fdb604df&quot;,&quot;order&quot;:&quot;1&quot;},&quot;connectorInfo&quot;:{&quot;type&quot;:&quot;LINE&quot;,&quot;offset&quot;:{&quot;x&quot;:0,&quot;y&quot;:0},&quot;bending&quot;:0.1,&quot;customized&quot;:true,&quot;connectedObjectAtLineStart&quot;:{&quot;objectId&quot;:&quot;c4c055c1-5a7b-44bc-a6cb-5669cd9c3fbc&quot;,&quot;coordinates&quot;:{&quot;x&quot;:0.5,&quot;y&quot;:1}}}},&quot;c4c055c1-5a7b-44bc-a6cb-5669cd9c3fbc&quot;:{&quot;type&quot;:&quot;FIGURE_OBJECT&quot;,&quot;id&quot;:&quot;c4c055c1-5a7b-44bc-a6cb-5669cd9c3fbc&quot;,&quot;relativeTransform&quot;:{&quot;translate&quot;:{&quot;x&quot;:-106.00236874533985,&quot;y&quot;:-98.79666317437847},&quot;rotate&quot;:0},&quot;layout&quot;:{&quot;sizeRatio&quot;:{&quot;x&quot;:0.99328165374677,&quot;y&quot;:0.95},&quot;keepAspectRatio&quot;:false},&quot;opacity&quot;:1,&quot;path&quot;:{&quot;type&quot;:&quot;RECT&quot;,&quot;size&quot;:{&quot;x&quot;:280.735012154579,&quot;y&quot;:67.36842105263158},&quot;cornerRounding&quot;:{&quot;type&quot;:&quot;ARC_LENGTH&quot;,&quot;global&quot;:6.879249403964083}},&quot;pathStyles&quot;:[{&quot;type&quot;:&quot;FILL&quot;,&quot;fillStyle&quot;:&quot;rgba(237, 217, 186, 1)&quot;},{&quot;type&quot;:&quot;STROKE&quot;,&quot;strokeStyle&quot;:&quot;rgba(138, 79, 33, 1)&quot;,&quot;lineWidth&quot;:1.62,&quot;lineJoin&quot;:&quot;round&quot;}],&quot;isLocked&quot;:false,&quot;parent&quot;:{&quot;type&quot;:&quot;CHILD&quot;,&quot;parentId&quot;:&quot;0cd5ff76-777a-4fc2-9ce1-0a52fdb604df&quot;,&quot;order&quot;:&quot;2&quot;}},&quot;14cb080d-baca-4150-8202-535561c945c1&quot;:{&quot;type&quot;:&quot;FIGURE_OBJECT&quot;,&quot;id&quot;:&quot;14cb080d-baca-4150-8202-535561c945c1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6,&quot;color&quot;:&quot;rgb(0,0,0)&quot;,&quot;fontWeight&quot;:&quot;normal&quot;,&quot;fontStyle&quot;:&quot;normal&quot;,&quot;decoration&quot;:&quot;none&quot;,&quot;script&quot;:&quot;none&quot;},&quot;range&quot;:[0,11]}],&quot;text&quot;:&quot;HCC patients&quot;,&quot;baseStyle&quot;:{&quot;fontFamily&quot;:&quot;Roboto&quot;,&quot;fontSize&quot;:16,&quot;color&quot;:&quot;rgba(23,23,23,1)&quot;,&quot;fontWeight&quot;:&quot;normal&quot;,&quot;fontStyle&quot;:&quot;normal&quot;,&quot;decoration&quot;:&quot;none&quot;,&quot;script&quot;:&quot;none&quot;}},{&quot;runs&quot;:[],&quot;text&quot;:&quot;&quot;,&quot;baseStyle&quot;:{&quot;fontFamily&quot;:&quot;Roboto&quot;,&quot;fontSize&quot;:16,&quot;color&quot;:&quot;rgba(23,23,23,1)&quot;,&quot;fontWeight&quot;:&quot;normal&quot;,&quot;fontStyle&quot;:&quot;normal&quot;,&quot;decoration&quot;:&quot;none&quot;,&quot;script&quot;:&quot;none&quot;}},{&quot;runs&quot;:[{&quot;style&quot;:{&quot;fontFamily&quot;:&quot;Roboto&quot;,&quot;fontSize&quot;:13.333333333333332,&quot;color&quot;:&quot;rgb(0,0,0)&quot;,&quot;fontWeight&quot;:&quot;normal&quot;,&quot;fontStyle&quot;:&quot;normal&quot;,&quot;decoration&quot;:&quot;none&quot;,&quot;script&quot;:&quot;none&quot;},&quot;range&quot;:[0,41]}],&quot;text&quot;:&quot;Diagnosis- clinical, imaging and histology&quot;}],&quot;verticalAlign&quot;:&quot;TOP&quot;,&quot;_lastCaretLocation&quot;:{&quot;lineIndex&quot;:2,&quot;runIndex&quot;:-1,&quot;charIndex&quot;:-1,&quot;endOfLine&quot;:true}},&quot;size&quot;:{&quot;x&quot;:278.8489371375199,&quot;y&quot;:53},&quot;targetSize&quot;:{&quot;x&quot;:278.8489371375199,&quot;y&quot;:2},&quot;format&quot;:&quot;BETTER_TEXT&quot;},&quot;parent&quot;:{&quot;type&quot;:&quot;CHILD&quot;,&quot;parentId&quot;:&quot;c4c055c1-5a7b-44bc-a6cb-5669cd9c3fbc&quot;,&quot;order&quot;:&quot;5&quot;}},&quot;cdffe003-3a59-4a21-ab4b-7fe7110e94bd&quot;:{&quot;type&quot;:&quot;FIGURE_OBJECT&quot;,&quot;id&quot;:&quot;cdffe003-3a59-4a21-ab4b-7fe7110e94bd&quot;,&quot;relativeTransform&quot;:{&quot;translate&quot;:{&quot;x&quot;:0,&quot;y&quot;:0},&quot;rotate&quot;:0,&quot;skewX&quot;:0,&quot;scale&quot;:{&quot;x&quot;:1,&quot;y&quot;:1}},&quot;opacity&quot;:1,&quot;path&quot;:{&quot;type&quot;:&quot;POLY_LINE&quot;,&quot;points&quot;:[{&quot;x&quot;:-105.5971669015404,&quot;y&quot;:39.394451350534666},{&quot;x&quot;:-105.99543858134496,&quot;y&quot;:72.36456418133977}],&quot;closed&quot;:false},&quot;pathStyles&quot;:[{&quot;type&quot;:&quot;FILL&quot;,&quot;fillStyle&quot;:&quot;rgba(0,0,0,0)&quot;},{&quot;type&quot;:&quot;STROKE&quot;,&quot;strokeStyle&quot;:&quot;rgba(138, 79, 33, 1)&quot;,&quot;lineWidth&quot;:2.24588009723663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0cd5ff76-777a-4fc2-9ce1-0a52fdb604df&quot;,&quot;order&quot;:&quot;3&quot;},&quot;connectorInfo&quot;:{&quot;type&quot;:&quot;LINE&quot;,&quot;offset&quot;:{&quot;x&quot;:0,&quot;y&quot;:0},&quot;bending&quot;:0.1,&quot;customized&quot;:true,&quot;connectedObjectAtLineStart&quot;:{&quot;objectId&quot;:&quot;d9fe545a-48a0-4e29-8904-8ac8a044c862&quot;,&quot;coordinates&quot;:{&quot;x&quot;:0.5,&quot;y&quot;:1}},&quot;connectedObjectAtLineEnd&quot;:{&quot;objectId&quot;:&quot;925c11b3-3e42-4daf-a937-6c80df8486f8&quot;,&quot;coordinates&quot;:{&quot;x&quot;:0.5,&quot;y&quot;:0}}}},&quot;f8fe2bc9-da44-4a88-bde3-ea884c730f23&quot;:{&quot;type&quot;:&quot;FIGURE_OBJECT&quot;,&quot;id&quot;:&quot;f8fe2bc9-da44-4a88-bde3-ea884c730f23&quot;,&quot;relativeTransform&quot;:{&quot;translate&quot;:{&quot;x&quot;:-3.945999999999998,&quot;y&quot;:53},&quot;rotate&quot;:0,&quot;skewX&quot;:0,&quot;scale&quot;:{&quot;x&quot;:1,&quot;y&quot;:1}},&quot;opacity&quot;:1,&quot;path&quot;:{&quot;type&quot;:&quot;POLY_LINE&quot;,&quot;points&quot;:[{&quot;x&quot;:-106.00211379846606,&quot;y&quot;:95.3548101905208},{&quot;x&quot;:-106.00211379846606,&quot;y&quot;:157.55798436171042},{&quot;x&quot;:-142.00211379846604,&quot;y&quot;:157.55798436171042}],&quot;closed&quot;:false},&quot;pathStyles&quot;:[{&quot;type&quot;:&quot;FILL&quot;,&quot;fillStyle&quot;:&quot;rgba(0,0,0,0)&quot;},{&quot;type&quot;:&quot;STROKE&quot;,&quot;strokeStyle&quot;:&quot;rgba(138, 79, 33, 1)&quot;,&quot;lineWidth&quot;:2.24588009723663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0cd5ff76-777a-4fc2-9ce1-0a52fdb604df&quot;,&quot;order&quot;:&quot;5&quot;},&quot;connectorInfo&quot;:{&quot;connectedObjects&quot;:[],&quot;type&quot;:&quot;LINE&quot;,&quot;offset&quot;:{&quot;x&quot;:0,&quot;y&quot;:0},&quot;bending&quot;:0.1,&quot;firstElementIsHead&quot;:true,&quot;customized&quot;:true}},&quot;925c11b3-3e42-4daf-a937-6c80df8486f8&quot;:{&quot;type&quot;:&quot;FIGURE_OBJECT&quot;,&quot;id&quot;:&quot;925c11b3-3e42-4daf-a937-6c80df8486f8&quot;,&quot;relativeTransform&quot;:{&quot;translate&quot;:{&quot;x&quot;:-105.99543858134496,&quot;y&quot;:109.5021380932057},&quot;rotate&quot;:0},&quot;layout&quot;:{&quot;sizeRatio&quot;:{&quot;x&quot;:0.99328165374677,&quot;y&quot;:0.95},&quot;keepAspectRatio&quot;:false},&quot;opacity&quot;:1,&quot;path&quot;:{&quot;type&quot;:&quot;RECT&quot;,&quot;size&quot;:{&quot;x&quot;:280.72091639233986,&quot;y&quot;:74.27514782373184},&quot;cornerRounding&quot;:{&quot;type&quot;:&quot;ARC_LENGTH&quot;,&quot;global&quot;:5.919626866780046}},&quot;pathStyles&quot;:[{&quot;type&quot;:&quot;FILL&quot;,&quot;fillStyle&quot;:&quot;rgba(237, 217, 186, 1)&quot;},{&quot;type&quot;:&quot;STROKE&quot;,&quot;strokeStyle&quot;:&quot;rgba(138, 79, 33, 1)&quot;,&quot;lineWidth&quot;:1.62,&quot;lineJoin&quot;:&quot;round&quot;}],&quot;isLocked&quot;:false,&quot;parent&quot;:{&quot;type&quot;:&quot;CHILD&quot;,&quot;parentId&quot;:&quot;0cd5ff76-777a-4fc2-9ce1-0a52fdb604df&quot;,&quot;order&quot;:&quot;7&quot;}},&quot;7e4fc2f0-dab2-48ba-8ad8-4f50618ac129&quot;:{&quot;type&quot;:&quot;FIGURE_OBJECT&quot;,&quot;id&quot;:&quot;7e4fc2f0-dab2-48ba-8ad8-4f50618ac129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6,&quot;color&quot;:&quot;rgb(0,0,0)&quot;,&quot;fontWeight&quot;:&quot;normal&quot;,&quot;fontStyle&quot;:&quot;normal&quot;,&quot;decoration&quot;:&quot;none&quot;,&quot;script&quot;:&quot;none&quot;},&quot;range&quot;:[0,38]}],&quot;text&quot;:&quot;HCC patients diagnosed with fatty liver&quot;},{&quot;runs&quot;:[{&quot;style&quot;:{&quot;fontFamily&quot;:&quot;Roboto&quot;,&quot;fontSize&quot;:13.333333333333332,&quot;color&quot;:&quot;rgb(0,0,0)&quot;,&quot;fontWeight&quot;:&quot;normal&quot;,&quot;fontStyle&quot;:&quot;normal&quot;,&quot;decoration&quot;:&quot;none&quot;,&quot;script&quot;:&quot;none&quot;},&quot;range&quot;:[0,38]}],&quot;text&quot;:&quot;Diagnosis- clinical, imaging, histology&quot;,&quot;baseStyle&quot;:{&quot;fontFamily&quot;:&quot;Roboto&quot;,&quot;fontSize&quot;:13.333333333333332,&quot;color&quot;:&quot;rgba(23,23,23,1)&quot;,&quot;fontWeight&quot;:&quot;normal&quot;,&quot;fontStyle&quot;:&quot;normal&quot;,&quot;decoration&quot;:&quot;none&quot;,&quot;script&quot;:&quot;none&quot;}}],&quot;verticalAlign&quot;:&quot;TOP&quot;,&quot;_lastCaretLocation&quot;:{&quot;lineIndex&quot;:2,&quot;runIndex&quot;:-1,&quot;charIndex&quot;:-1,&quot;endOfLine&quot;:true}},&quot;size&quot;:{&quot;x&quot;:278.8349360754921,&quot;y&quot;:34},&quot;targetSize&quot;:{&quot;x&quot;:278.8349360754921,&quot;y&quot;:2},&quot;format&quot;:&quot;BETTER_TEXT&quot;},&quot;parent&quot;:{&quot;type&quot;:&quot;CHILD&quot;,&quot;parentId&quot;:&quot;925c11b3-3e42-4daf-a937-6c80df8486f8&quot;,&quot;order&quot;:&quot;5&quot;}},&quot;f77f08b2-6e77-4070-86af-3a3b164df449&quot;:{&quot;type&quot;:&quot;FIGURE_OBJECT&quot;,&quot;id&quot;:&quot;f77f08b2-6e77-4070-86af-3a3b164df449&quot;,&quot;relativeTransform&quot;:{&quot;translate&quot;:{&quot;x&quot;:-209.2081135730521,&quot;y&quot;:213.1189329574551},&quot;rotate&quot;:0,&quot;skewX&quot;:0,&quot;scale&quot;:{&quot;x&quot;:1,&quot;y&quot;:1}},&quot;layout&quot;:{&quot;sizeRatio&quot;:{&quot;x&quot;:0.99328165374677,&quot;y&quot;:0.95},&quot;keepAspectRatio&quot;:false},&quot;opacity&quot;:1,&quot;path&quot;:{&quot;type&quot;:&quot;RECT&quot;,&quot;size&quot;:{&quot;x&quot;:114.90035466444174,&quot;y&quot;:88.74189696607536},&quot;cornerRounding&quot;:{&quot;type&quot;:&quot;ARC_LENGTH&quot;,&quot;global&quot;:6.879249403964083}},&quot;pathStyles&quot;:[{&quot;type&quot;:&quot;FILL&quot;,&quot;fillStyle&quot;:&quot;rgba(251, 253, 242, 1)&quot;},{&quot;type&quot;:&quot;STROKE&quot;,&quot;strokeStyle&quot;:&quot;rgba(196, 206, 146, 1)&quot;,&quot;lineWidth&quot;:1.62,&quot;lineJoin&quot;:&quot;round&quot;}],&quot;isLocked&quot;:false,&quot;parent&quot;:{&quot;type&quot;:&quot;CHILD&quot;,&quot;parentId&quot;:&quot;0cd5ff76-777a-4fc2-9ce1-0a52fdb604df&quot;,&quot;order&quot;:&quot;993&quot;}},&quot;9f50bdde-3de6-4c10-9752-f89981d27cd2&quot;:{&quot;type&quot;:&quot;FIGURE_OBJECT&quot;,&quot;id&quot;:&quot;9f50bdde-3de6-4c10-9752-f89981d27cd2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6,&quot;color&quot;:&quot;rgb(0,0,0)&quot;,&quot;fontWeight&quot;:&quot;normal&quot;,&quot;fontStyle&quot;:&quot;italic&quot;,&quot;decoration&quot;:&quot;none&quot;,&quot;script&quot;:&quot;none&quot;},&quot;range&quot;:[0,0]},{&quot;style&quot;:{&quot;fontFamily&quot;:&quot;Roboto&quot;,&quot;fontSize&quot;:16,&quot;color&quot;:&quot;rgb(0,0,0)&quot;,&quot;fontWeight&quot;:&quot;normal&quot;,&quot;fontStyle&quot;:&quot;normal&quot;,&quot;decoration&quot;:&quot;none&quot;,&quot;script&quot;:&quot;none&quot;},&quot;range&quot;:[1,9]}],&quot;text&quot;:&quot;cMAFLD-HCC&quot;},{&quot;runs&quot;:[],&quot;text&quot;:&quot;&quot;,&quot;baseStyle&quot;:{&quot;fontFamily&quot;:&quot;Roboto&quot;,&quot;fontSize&quot;:14.66904643582415,&quot;color&quot;:&quot;rgba(23,23,23,1)&quot;,&quot;fontWeight&quot;:&quot;normal&quot;,&quot;fontStyle&quot;:&quot;normal&quot;,&quot;decoration&quot;:&quot;none&quot;,&quot;script&quot;:&quot;none&quot;}},{&quot;runs&quot;:[{&quot;style&quot;:{&quot;fontFamily&quot;:&quot;Roboto&quot;,&quot;fontSize&quot;:13.333333333333332,&quot;color&quot;:&quot;rgb(0,0,0)&quot;,&quot;fontWeight&quot;:&quot;normal&quot;,&quot;fontStyle&quot;:&quot;normal&quot;,&quot;decoration&quot;:&quot;none&quot;,&quot;script&quot;:&quot;none&quot;},&quot;range&quot;:[0,27]}],&quot;text&quot;:&quot; Confirmed by histopathology&quot;}],&quot;verticalAlign&quot;:&quot;TOP&quot;,&quot;_lastCaretLocation&quot;:{&quot;lineIndex&quot;:2,&quot;runIndex&quot;:-1,&quot;charIndex&quot;:-1,&quot;endOfLine&quot;:true}},&quot;size&quot;:{&quot;x&quot;:114.1284142971871,&quot;y&quot;:67},&quot;targetSize&quot;:{&quot;x&quot;:114.1284142971871,&quot;y&quot;:2},&quot;format&quot;:&quot;BETTER_TEXT&quot;},&quot;parent&quot;:{&quot;type&quot;:&quot;CHILD&quot;,&quot;parentId&quot;:&quot;f77f08b2-6e77-4070-86af-3a3b164df449&quot;,&quot;order&quot;:&quot;5&quot;}},&quot;d9fe545a-48a0-4e29-8904-8ac8a044c862&quot;:{&quot;type&quot;:&quot;FIGURE_OBJECT&quot;,&quot;id&quot;:&quot;d9fe545a-48a0-4e29-8904-8ac8a044c862&quot;,&quot;relativeTransform&quot;:{&quot;translate&quot;:{&quot;x&quot;:-105.5971669015404,&quot;y&quot;:5.75259653257902},&quot;rotate&quot;:0},&quot;layout&quot;:{&quot;sizeRatio&quot;:{&quot;x&quot;:0.99328165374677,&quot;y&quot;:0.95},&quot;keepAspectRatio&quot;:false},&quot;opacity&quot;:1,&quot;path&quot;:{&quot;type&quot;:&quot;RECT&quot;,&quot;size&quot;:{&quot;x&quot;:279.9150079693094,&quot;y&quot;:67.2837096359113},&quot;cornerRounding&quot;:{&quot;type&quot;:&quot;ARC_LENGTH&quot;,&quot;global&quot;:8.15296031953944}},&quot;pathStyles&quot;:[{&quot;type&quot;:&quot;FILL&quot;,&quot;fillStyle&quot;:&quot;rgb(237, 217, 186)&quot;},{&quot;type&quot;:&quot;STROKE&quot;,&quot;strokeStyle&quot;:&quot;rgb(138, 79, 33)&quot;,&quot;lineWidth&quot;:1.629849237001786,&quot;lineJoin&quot;:&quot;round&quot;}],&quot;isLocked&quot;:false,&quot;parent&quot;:{&quot;type&quot;:&quot;CHILD&quot;,&quot;parentId&quot;:&quot;0cd5ff76-777a-4fc2-9ce1-0a52fdb604df&quot;,&quot;order&quot;:&quot;6&quot;}},&quot;0f1b02c7-dc77-4b24-8487-a40a8772317e&quot;:{&quot;type&quot;:&quot;FIGURE_OBJECT&quot;,&quot;id&quot;:&quot;0f1b02c7-dc77-4b24-8487-a40a8772317e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5.802034671285302,&quot;color&quot;:&quot;rgb(0,0,0)&quot;,&quot;fontWeight&quot;:&quot;normal&quot;,&quot;fontStyle&quot;:&quot;normal&quot;,&quot;decoration&quot;:&quot;none&quot;,&quot;script&quot;:&quot;none&quot;},&quot;range&quot;:[0,28]}],&quot;text&quot;:&quot;HCC patients without HBV, HCV&quot;}],&quot;verticalAlign&quot;:&quot;TOP&quot;,&quot;_lastCaretLocation&quot;:{&quot;lineIndex&quot;:0,&quot;runIndex&quot;:-1,&quot;charIndex&quot;:-1,&quot;endOfLine&quot;:true}},&quot;size&quot;:{&quot;x&quot;:278.0344420242959,&quot;y&quot;:19},&quot;targetSize&quot;:{&quot;x&quot;:278.0344420242959,&quot;y&quot;:2},&quot;format&quot;:&quot;BETTER_TEXT&quot;},&quot;parent&quot;:{&quot;type&quot;:&quot;CHILD&quot;,&quot;parentId&quot;:&quot;d9fe545a-48a0-4e29-8904-8ac8a044c862&quot;,&quot;order&quot;:&quot;5&quot;}},&quot;c3c39384-35bf-4685-9c83-1c9c399de0fc&quot;:{&quot;type&quot;:&quot;FIGURE_OBJECT&quot;,&quot;id&quot;:&quot;c3c39384-35bf-4685-9c83-1c9c399de0fc&quot;,&quot;relativeTransform&quot;:{&quot;translate&quot;:{&quot;x&quot;:-8.3031138548195,&quot;y&quot;:213.11933557769584},&quot;rotate&quot;:0,&quot;skewX&quot;:0,&quot;scale&quot;:{&quot;x&quot;:1,&quot;y&quot;:1}},&quot;layout&quot;:{&quot;sizeRatio&quot;:{&quot;x&quot;:0.99328165374677,&quot;y&quot;:0.95},&quot;keepAspectRatio&quot;:false},&quot;opacity&quot;:1,&quot;path&quot;:{&quot;type&quot;:&quot;RECT&quot;,&quot;size&quot;:{&quot;x&quot;:114.90035466444174,&quot;y&quot;:88.74114725255279},&quot;cornerRounding&quot;:{&quot;type&quot;:&quot;ARC_LENGTH&quot;,&quot;global&quot;:6.879249403964083}},&quot;pathStyles&quot;:[{&quot;type&quot;:&quot;FILL&quot;,&quot;fillStyle&quot;:&quot;rgba(251, 253, 242, 1)&quot;},{&quot;type&quot;:&quot;STROKE&quot;,&quot;strokeStyle&quot;:&quot;rgba(196, 206, 146, 1)&quot;,&quot;lineWidth&quot;:1.62,&quot;lineJoin&quot;:&quot;round&quot;}],&quot;isLocked&quot;:false,&quot;parent&quot;:{&quot;type&quot;:&quot;CHILD&quot;,&quot;parentId&quot;:&quot;0cd5ff76-777a-4fc2-9ce1-0a52fdb604df&quot;,&quot;order&quot;:&quot;995&quot;}},&quot;39e21a63-d2d2-476e-9afb-4f89f539751f&quot;:{&quot;type&quot;:&quot;FIGURE_OBJECT&quot;,&quot;id&quot;:&quot;39e21a63-d2d2-476e-9afb-4f89f539751f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Roboto&quot;,&quot;fontSize&quot;:16,&quot;color&quot;:&quot;rgb(0,0,0)&quot;,&quot;fontWeight&quot;:&quot;normal&quot;,&quot;fontStyle&quot;:&quot;italic&quot;,&quot;decoration&quot;:&quot;none&quot;,&quot;script&quot;:&quot;none&quot;},&quot;range&quot;:[0,1]},{&quot;style&quot;:{&quot;fontFamily&quot;:&quot;Roboto&quot;,&quot;fontSize&quot;:16,&quot;color&quot;:&quot;rgb(0,0,0)&quot;,&quot;fontWeight&quot;:&quot;normal&quot;,&quot;fontStyle&quot;:&quot;normal&quot;,&quot;decoration&quot;:&quot;none&quot;,&quot;script&quot;:&quot;none&quot;},&quot;range&quot;:[2,10]}],&quot;text&quot;:&quot;ncMAFLD-HCC&quot;},{&quot;runs&quot;:[],&quot;text&quot;:&quot;&quot;,&quot;baseStyle&quot;:{&quot;fontFamily&quot;:&quot;Roboto&quot;,&quot;fontSize&quot;:14.66904643582415,&quot;color&quot;:&quot;rgba(23,23,23,1)&quot;,&quot;fontWeight&quot;:&quot;normal&quot;,&quot;fontStyle&quot;:&quot;normal&quot;,&quot;decoration&quot;:&quot;none&quot;,&quot;script&quot;:&quot;none&quot;}},{&quot;runs&quot;:[{&quot;style&quot;:{&quot;fontFamily&quot;:&quot;Roboto&quot;,&quot;fontSize&quot;:13.333333333333332,&quot;color&quot;:&quot;rgb(0,0,0)&quot;,&quot;fontWeight&quot;:&quot;normal&quot;,&quot;fontStyle&quot;:&quot;normal&quot;,&quot;decoration&quot;:&quot;none&quot;,&quot;script&quot;:&quot;none&quot;},&quot;range&quot;:[0,27]}],&quot;text&quot;:&quot; Confirmed by histopathology&quot;}],&quot;verticalAlign&quot;:&quot;TOP&quot;,&quot;_lastCaretLocation&quot;:{&quot;lineIndex&quot;:2,&quot;runIndex&quot;:-1,&quot;charIndex&quot;:-1,&quot;endOfLine&quot;:true}},&quot;size&quot;:{&quot;x&quot;:114.12841429718708,&quot;y&quot;:67},&quot;targetSize&quot;:{&quot;x&quot;:114.12841429718708,&quot;y&quot;:2},&quot;format&quot;:&quot;BETTER_TEXT&quot;},&quot;parent&quot;:{&quot;type&quot;:&quot;CHILD&quot;,&quot;parentId&quot;:&quot;c3c39384-35bf-4685-9c83-1c9c399de0fc&quot;,&quot;order&quot;:&quot;5&quot;}},&quot;8497c225-6661-44ca-8892-c83c6bdf6feb&quot;:{&quot;type&quot;:&quot;FIGURE_OBJECT&quot;,&quot;id&quot;:&quot;8497c225-6661-44ca-8892-c83c6bdf6feb&quot;,&quot;relativeTransform&quot;:{&quot;translate&quot;:{&quot;x&quot;:-170.02447750504408,&quot;y&quot;:104.60534206011198},&quot;rotate&quot;:-1.5707963267948966,&quot;skewX&quot;:0,&quot;scale&quot;:{&quot;x&quot;:1,&quot;y&quot;:1}},&quot;opacity&quot;:1,&quot;path&quot;:{&quot;type&quot;:&quot;POLY_LINE&quot;,&quot;points&quot;:[{&quot;x&quot;:-105.95229022815825,&quot;y&quot;:57.43424664529244},{&quot;x&quot;:-105.95229022815825,&quot;y&quot;:94.90055212406251},{&quot;x&quot;:-105.95229022815823,&quot;y&quot;:98.51448076786377}],&quot;closed&quot;:false},&quot;pathStyles&quot;:[{&quot;type&quot;:&quot;FILL&quot;,&quot;fillStyle&quot;:&quot;rgba(0,0,0,0)&quot;},{&quot;type&quot;:&quot;STROKE&quot;,&quot;strokeStyle&quot;:&quot;rgba(138, 79, 33, 1)&quot;,&quot;lineWidth&quot;:2.24588009723663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0cd5ff76-777a-4fc2-9ce1-0a52fdb604df&quot;,&quot;order&quot;:&quot;997&quot;},&quot;connectorInfo&quot;:{&quot;connectedObjects&quot;:[],&quot;type&quot;:&quot;LINE&quot;,&quot;offset&quot;:{&quot;x&quot;:0,&quot;y&quot;:0},&quot;bending&quot;:0.1,&quot;firstElementIsHead&quot;:true,&quot;customized&quot;:true}},&quot;38827843-e348-4442-9ebf-8ad99d28aad2&quot;:{&quot;type&quot;:&quot;FIGURE_OBJECT&quot;,&quot;id&quot;:&quot;38827843-e348-4442-9ebf-8ad99d28aad2&quot;,&quot;relativeTransform&quot;:{&quot;translate&quot;:{&quot;x&quot;:-103.206,&quot;y&quot;:490.7640607032237},&quot;rotate&quot;:0},&quot;opacity&quot;:1,&quot;path&quot;:{&quot;type&quot;:&quot;POLY_LINE&quot;,&quot;points&quot;:[{&quot;x&quot;:-106.00236874533985,&quot;y&quot;:-103.61315841872806},{&quot;x&quot;:-106.00236874533985,&quot;y&quot;:-71.03831898860032}],&quot;closed&quot;:false},&quot;pathStyles&quot;:[{&quot;type&quot;:&quot;FILL&quot;,&quot;fillStyle&quot;:&quot;rgba(0,0,0,0)&quot;},{&quot;type&quot;:&quot;STROKE&quot;,&quot;strokeStyle&quot;:&quot;rgba(138, 79, 33, 1)&quot;,&quot;lineWidth&quot;:2.24588009723663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0cd5ff76-777a-4fc2-9ce1-0a52fdb604df&quot;,&quot;order&quot;:&quot;999&quot;},&quot;connectorInfo&quot;:{&quot;connectedObjects&quot;:[],&quot;type&quot;:&quot;LINE&quot;,&quot;offset&quot;:{&quot;x&quot;:0,&quot;y&quot;:0},&quot;bending&quot;:0.1,&quot;firstElementIsHead&quot;:false,&quot;customized&quot;:true}},&quot;e8449b69-b081-4aed-a7cd-3f263e488f24&quot;:{&quot;id&quot;:&quot;e8449b69-b081-4aed-a7cd-3f263e488f24&quot;,&quot;name&quot;:&quot;Hepatitis B (glycoprotein 2)&quot;,&quot;displayName&quot;:&quot;&quot;,&quot;type&quot;:&quot;FIGURE_OBJECT&quot;,&quot;relativeTransform&quot;:{&quot;translate&quot;:{&quot;x&quot;:232.8995916174355,&quot;y&quot;:-160.19333322350084},&quot;rotate&quot;:0,&quot;skewX&quot;:0,&quot;scale&quot;:{&quot;x&quot;:0.2814588363769286,&quot;y&quot;:0.2814588363769286}},&quot;image&quot;:{&quot;url&quot;:&quot;https://icons.cdn.biorender.com/biorender/604fc5c6f37f6000260b4ee1/20210315204113/image/604fc5c6f37f6000260b4ee1.png&quot;,&quot;isPremium&quot;:false,&quot;isOrgIcon&quot;:false,&quot;size&quot;:{&quot;x&quot;:25,&quot;y&quot;:63.75}},&quot;source&quot;:{&quot;id&quot;:&quot;604fc5c6f37f6000260b4ee1&quot;,&quot;version&quot;:&quot;20210315204113&quot;,&quot;type&quot;:&quot;ASSETS&quot;},&quot;isPremium&quot;:false,&quot;parent&quot;:{&quot;type&quot;:&quot;CHILD&quot;,&quot;parentId&quot;:&quot;40e1d13b-5ddf-41c4-878b-42ca49175b0f&quot;,&quot;order&quot;:&quot;1&quot;}},&quot;2294ff48-b891-4c47-94d2-d54c525ca194&quot;:{&quot;relativeTransform&quot;:{&quot;translate&quot;:{&quot;x&quot;:242.15983696793953,&quot;y&quot;:-148.01357628814577},&quot;rotate&quot;:0,&quot;skewX&quot;:0,&quot;scale&quot;:{&quot;x&quot;:1,&quot;y&quot;:1}},&quot;type&quot;:&quot;FIGURE_OBJECT&quot;,&quot;id&quot;:&quot;2294ff48-b891-4c47-94d2-d54c525ca194&quot;,&quot;parent&quot;:{&quot;type&quot;:&quot;CHILD&quot;,&quot;parentId&quot;:&quot;40e1d13b-5ddf-41c4-878b-42ca49175b0f&quot;,&quot;order&quot;:&quot;2&quot;},&quot;name&quot;:&quot;Hepatitis B&quot;,&quot;displayName&quot;:&quot;Hepatitis B&quot;,&quot;source&quot;:{&quot;id&quot;:&quot;60bf7febb3f92000ac66a0a7&quot;,&quot;type&quot;:&quot;ASSETS&quot;},&quot;isPremium&quot;:true},&quot;0b53492d-e67e-4bd0-8fe9-9b0176432eaa&quot;:{&quot;id&quot;:&quot;0b53492d-e67e-4bd0-8fe9-9b0176432eaa&quot;,&quot;name&quot;:&quot;Hepatitis B (genome)&quot;,&quot;type&quot;:&quot;FIGURE_OBJECT&quot;,&quot;relativeTransform&quot;:{&quot;translate&quot;:{&quot;x&quot;:-4.015205638659442,&quot;y&quot;:6.098342368212114},&quot;rotate&quot;:0,&quot;skewX&quot;:0,&quot;scale&quot;:{&quot;x&quot;:0.08292667730583887,&quot;y&quot;:0.08292667730583887}},&quot;image&quot;:{&quot;url&quot;:&quot;https://icons.biorender.com/biorender/60b8e77c449fb70026c40d70/hepatitis-b-genome.png&quot;,&quot;fallbackUrl&quot;:&quot;https://res.cloudinary.com/dlcjuc3ej/image/upload/v1622730613/xfjcohhoncicgzsxyrfl.svg#/keystone/api/icons/60b8e77c449fb70026c40d70/hepatitis-b-genome.svg&quot;,&quot;isPremium&quot;:false,&quot;isPacked&quot;:true,&quot;size&quot;:{&quot;x&quot;:100,&quot;y&quot;:100.418410041841}},&quot;source&quot;:{&quot;id&quot;:&quot;60b8e71b449fb70026c40d6f&quot;,&quot;type&quot;:&quot;ASSETS&quot;},&quot;parent&quot;:{&quot;type&quot;:&quot;CHILD&quot;,&quot;parentId&quot;:&quot;2294ff48-b891-4c47-94d2-d54c525ca194&quot;,&quot;order&quot;:&quot;92&quot;}},&quot;5e713af8-edd3-470c-857c-8518174468f2&quot;:{&quot;id&quot;:&quot;5e713af8-edd3-470c-857c-8518174468f2&quot;,&quot;name&quot;:&quot;Hepatitis B (capsid)&quot;,&quot;type&quot;:&quot;FIGURE_OBJECT&quot;,&quot;relativeTransform&quot;:{&quot;translate&quot;:{&quot;x&quot;:-4.023975721401434,&quot;y&quot;:6.098288240904905},&quot;rotate&quot;:0,&quot;skewX&quot;:0,&quot;scale&quot;:{&quot;x&quot;:0.08970864639707361,&quot;y&quot;:0.0897086463970736}},&quot;image&quot;:{&quot;url&quot;:&quot;https://icons.biorender.com/biorender/604fa2baf37f6000260b4ebb/20210316144724/image/hepatitis-b-capsid.png&quot;,&quot;fallbackUrl&quot;:&quot;https://res.cloudinary.com/dlcjuc3ej/image/upload/v1615906044/d8tocpzgnqhcctxrrwot.svg#/keystone/api/icons/604fa2baf37f6000260b4ebb/20210316144724/image/hepatitis-b-capsid.svg&quot;,&quot;isPremium&quot;:false,&quot;isPacked&quot;:true,&quot;size&quot;:{&quot;x&quot;:125,&quot;y&quot;:126.42045454545455}},&quot;source&quot;:{&quot;id&quot;:&quot;604fa2baf37f6000260b4ebb&quot;,&quot;type&quot;:&quot;ASSETS&quot;},&quot;parent&quot;:{&quot;type&quot;:&quot;CHILD&quot;,&quot;parentId&quot;:&quot;2294ff48-b891-4c47-94d2-d54c525ca194&quot;,&quot;order&quot;:&quot;82&quot;}},&quot;f2eb01d8-36bb-4d95-88b4-6ecfaafd1ba1&quot;:{&quot;id&quot;:&quot;f2eb01d8-36bb-4d95-88b4-6ecfaafd1ba1&quot;,&quot;name&quot;:&quot;Hepatitis B (glycoprotein 2)&quot;,&quot;type&quot;:&quot;FIGURE_OBJECT&quot;,&quot;relativeTransform&quot;:{&quot;translate&quot;:{&quot;x&quot;:-4.317182756456241,&quot;y&quot;:-1.7259491989344296},&quot;rotate&quot;:0,&quot;skewX&quot;:0,&quot;scale&quot;:{&quot;x&quot;:0.0464981339564515,&quot;y&quot;:0.046498133956451485}},&quot;image&quot;:{&quot;url&quot;:&quot;https://icons.biorender.com/biorender/604fc5c6f37f6000260b4ee1/20210315204113/image/hepatitis-b-capsid-glycoprotein-2.png&quot;,&quot;fallbackUrl&quot;:&quot;https://res.cloudinary.com/dlcjuc3ej/image/upload/v1615840873/rqbp0tv55nvemgism9fn.svg#/keystone/api/icons/604fc5c6f37f6000260b4ee1/20210315204113/image/hepatitis-b-capsid-glycoprotein-2.svg&quot;,&quot;isPremium&quot;:false,&quot;isPacked&quot;:true,&quot;size&quot;:{&quot;x&quot;:25,&quot;y&quot;:63.75}},&quot;source&quot;:{&quot;id&quot;:&quot;604fc5c6f37f6000260b4ee1&quot;,&quot;type&quot;:&quot;ASSETS&quot;},&quot;parent&quot;:{&quot;type&quot;:&quot;CHILD&quot;,&quot;parentId&quot;:&quot;2294ff48-b891-4c47-94d2-d54c525ca194&quot;,&quot;order&quot;:&quot;01&quot;}},&quot;e6853ffb-8746-489e-ac94-64e54b945a32&quot;:{&quot;id&quot;:&quot;e6853ffb-8746-489e-ac94-64e54b945a32&quot;,&quot;name&quot;:&quot;Hepatitis B (glycoprotein 1)&quot;,&quot;type&quot;:&quot;FIGURE_OBJECT&quot;,&quot;relativeTransform&quot;:{&quot;translate&quot;:{&quot;x&quot;:-4.01514372725948,&quot;y&quot;:-1.4934390476824213},&quot;rotate&quot;:0,&quot;skewX&quot;:0,&quot;scale&quot;:{&quot;x&quot;:0.0464981339564515,&quot;y&quot;:0.046498133956451485}},&quot;image&quot;:{&quot;url&quot;:&quot;https://icons.biorender.com/biorender/604fc69af37f6000260b4f07/20210315204426/image/hepatitis-b-capsid-glycoprotein-1.png&quot;,&quot;fallbackUrl&quot;:&quot;https://res.cloudinary.com/dlcjuc3ej/image/upload/v1615841066/u3apvfdwwna55umsrl7z.svg#/keystone/api/icons/604fc69af37f6000260b4f07/20210315204426/image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02&quot;}},&quot;5698f0b9-92b7-4df7-a8c1-d39b42ddb024&quot;:{&quot;type&quot;:&quot;FIGURE_OBJECT&quot;,&quot;id&quot;:&quot;5698f0b9-92b7-4df7-a8c1-d39b42ddb024&quot;,&quot;name&quot;:&quot;Viral envelope &quot;,&quot;relativeTransform&quot;:{&quot;translate&quot;:{&quot;x&quot;:-4.023982162058921,&quot;y&quot;:6.09650450930076},&quot;rotate&quot;:0,&quot;skewX&quot;:0,&quot;scale&quot;:{&quot;x&quot;:0.03945927487229812,&quot;y&quot;:0.039459274872298125}},&quot;opacity&quot;:1,&quot;image&quot;:{&quot;url&quot;:&quot;https://icons.biorender.com/biorender/5d3f05b64d6c910004dc43cf/viral-envelope-1.png&quot;,&quot;fallbackUrl&quot;:&quot;https://res.cloudinary.com/dlcjuc3ej/image/upload/v1564411312/l9xll3iq208v4hl6uh9y.svg#/keystone/api/icons/5d3f05b64d6c910004dc43cf/viral-envelope-1.svg&quot;,&quot;size&quot;:{&quot;x&quot;:354,&quot;y&quot;:354},&quot;isPremium&quot;:false,&quot;isPacked&quot;:true},&quot;source&quot;:{&quot;id&quot;:&quot;5a5fad64e2cabd001483dbb0&quot;,&quot;type&quot;:&quot;ASSETS&quot;},&quot;pathStyles&quot;:[{&quot;type&quot;:&quot;FILL&quot;,&quot;fillStyle&quot;:&quot;rgb(0,0,0)&quot;}],&quot;isLocked&quot;:false,&quot;parent&quot;:{&quot;type&quot;:&quot;CHILD&quot;,&quot;parentId&quot;:&quot;2294ff48-b891-4c47-94d2-d54c525ca194&quot;,&quot;order&quot;:&quot;85&quot;}},&quot;459d9eac-c40a-43f5-b616-9c41e21bb980&quot;:{&quot;type&quot;:&quot;FIGURE_OBJECT&quot;,&quot;id&quot;:&quot;459d9eac-c40a-43f5-b616-9c41e21bb980&quot;,&quot;relativeTransform&quot;:{&quot;translate&quot;:{&quot;x&quot;:-4.023949100903463,&quot;y&quot;:6.053761905397059},&quot;rotate&quot;:-5.8986057779734486e-18,&quot;skewX&quot;:-1.151310065843615e-17},&quot;opacity&quot;:1,&quot;path&quot;:{&quot;type&quot;:&quot;ELLIPSE&quot;,&quot;size&quot;:{&quot;x&quot;:-13.387039619724886,&quot;y&quot;:-13.234432155217283}},&quot;isLocked&quot;:false,&quot;pathStyles&quot;:[{&quot;type&quot;:&quot;FILL&quot;,&quot;fillStyle&quot;:&quot;rgba(255,252,244,1)&quot;},{&quot;type&quot;:&quot;STROKE&quot;,&quot;strokeStyle&quot;:&quot;rgba(0,0,0,0)&quot;,&quot;lineWidth&quot;:0,&quot;lineJoin&quot;:&quot;round&quot;}],&quot;parent&quot;:{&quot;type&quot;:&quot;CHILD&quot;,&quot;parentId&quot;:&quot;2294ff48-b891-4c47-94d2-d54c525ca194&quot;,&quot;order&quot;:&quot;8&quot;}},&quot;161fff74-c37e-4b70-9da4-b34c75580915&quot;:{&quot;id&quot;:&quot;161fff74-c37e-4b70-9da4-b34c75580915&quot;,&quot;name&quot;:&quot;Hepatitis B (glycoprotein 1)&quot;,&quot;type&quot;:&quot;FIGURE_OBJECT&quot;,&quot;relativeTransform&quot;:{&quot;translate&quot;:{&quot;x&quot;:-2.528333386665776,&quot;y&quot;:-1.482154953931656},&quot;rotate&quot;:0.1560573111190892,&quot;skewX&quot;:-1.205387642296231e-16,&quot;scale&quot;:{&quot;x&quot;:0.04742002444811091,&quot;y&quot;:0.047420024448110894}},&quot;image&quot;:{&quot;url&quot;:&quot;https://icons.biorender.com/biorender/604fc730f37f6000260b4f29/hepatitis-b-capsid-glycoprotein-1.png&quot;,&quot;fallbackUrl&quot;:&quot;https://res.cloudinary.com/dlcjuc3ej/image/upload/v1615841066/uovjah5woegrodmcfaur.svg#/keystone/api/icons/604fc730f37f6000260b4f29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07&quot;}},&quot;32ccc684-7f65-406f-9a20-7a5f7e557c83&quot;:{&quot;id&quot;:&quot;32ccc684-7f65-406f-9a20-7a5f7e557c83&quot;,&quot;name&quot;:&quot;Hepatitis B (glycoprotein 1)&quot;,&quot;type&quot;:&quot;FIGURE_OBJECT&quot;,&quot;relativeTransform&quot;:{&quot;translate&quot;:{&quot;x&quot;:-2.804958876147955,&quot;y&quot;:-1.5256552540522255},&quot;rotate&quot;:0.028601027677946828,&quot;skewX&quot;:-8.437713496073597e-17,&quot;scale&quot;:{&quot;x&quot;:0.04742002444811096,&quot;y&quot;:0.04742002444811099}},&quot;image&quot;:{&quot;url&quot;:&quot;https://icons.biorender.com/biorender/604fc730f37f6000260b4f13/hepatitis-b-capsid-glycoprotein-1.png&quot;,&quot;fallbackUrl&quot;:&quot;https://res.cloudinary.com/dlcjuc3ej/image/upload/v1615841066/jldztueptivbcj2a1aif.svg#/keystone/api/icons/604fc730f37f6000260b4f13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06&quot;}},&quot;271196dc-c97a-4afd-8df6-6d90d534ba9b&quot;:{&quot;id&quot;:&quot;271196dc-c97a-4afd-8df6-6d90d534ba9b&quot;,&quot;name&quot;:&quot;Hepatitis B (glycoprotein 2)&quot;,&quot;type&quot;:&quot;FIGURE_OBJECT&quot;,&quot;relativeTransform&quot;:{&quot;translate&quot;:{&quot;x&quot;:2.500123894466656,&quot;y&quot;:1.7873652753107818},&quot;rotate&quot;:1.0298761464252746,&quot;skewX&quot;:3.008780286430812e-16,&quot;scale&quot;:{&quot;x&quot;:0.04649813395645154,&quot;y&quot;:0.04649813395645157}},&quot;image&quot;:{&quot;url&quot;:&quot;https://icons.biorender.com/biorender/604fc5c6f37f6000260b4ee1/20210315204113/image/hepatitis-b-capsid-glycoprotein-2.png&quot;,&quot;fallbackUrl&quot;:&quot;https://res.cloudinary.com/dlcjuc3ej/image/upload/v1615840873/rqbp0tv55nvemgism9fn.svg#/keystone/api/icons/604fc5c6f37f6000260b4ee1/20210315204113/image/hepatitis-b-capsid-glycoprotein-2.svg&quot;,&quot;isPremium&quot;:false,&quot;isPacked&quot;:true,&quot;size&quot;:{&quot;x&quot;:25,&quot;y&quot;:63.75}},&quot;source&quot;:{&quot;id&quot;:&quot;604fc5c6f37f6000260b4ee1&quot;,&quot;type&quot;:&quot;ASSETS&quot;},&quot;parent&quot;:{&quot;type&quot;:&quot;CHILD&quot;,&quot;parentId&quot;:&quot;2294ff48-b891-4c47-94d2-d54c525ca194&quot;,&quot;order&quot;:&quot;03&quot;}},&quot;fa6fe726-d435-4558-93c5-45fea259cfdc&quot;:{&quot;id&quot;:&quot;fa6fe726-d435-4558-93c5-45fea259cfdc&quot;,&quot;name&quot;:&quot;Hepatitis B (glycoprotein 1)&quot;,&quot;type&quot;:&quot;FIGURE_OBJECT&quot;,&quot;relativeTransform&quot;:{&quot;translate&quot;:{&quot;x&quot;:2.4563354570198825,&quot;y&quot;:2.1660090635066607},&quot;rotate&quot;:1.0298761464252746,&quot;skewX&quot;:3.008780286430812e-16,&quot;scale&quot;:{&quot;x&quot;:0.04649813395645154,&quot;y&quot;:0.04649813395645157}},&quot;image&quot;:{&quot;url&quot;:&quot;https://icons.biorender.com/biorender/604fc69af37f6000260b4f07/20210315204426/image/hepatitis-b-capsid-glycoprotein-1.png&quot;,&quot;fallbackUrl&quot;:&quot;https://res.cloudinary.com/dlcjuc3ej/image/upload/v1615841066/u3apvfdwwna55umsrl7z.svg#/keystone/api/icons/604fc69af37f6000260b4f07/20210315204426/image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05&quot;}},&quot;71f92128-29a7-4ed6-ae8c-34e18ed06931&quot;:{&quot;id&quot;:&quot;71f92128-29a7-4ed6-ae8c-34e18ed06931&quot;,&quot;name&quot;:&quot;Hepatitis B (glycoprotein 1)&quot;,&quot;type&quot;:&quot;FIGURE_OBJECT&quot;,&quot;relativeTransform&quot;:{&quot;translate&quot;:{&quot;x&quot;:3.038605114089301,&quot;y&quot;:3.455628720018659},&quot;rotate&quot;:1.3246465524179647,&quot;skewX&quot;:-4.821550569184915e-17,&quot;scale&quot;:{&quot;x&quot;:0.04742002444811095,&quot;y&quot;:0.047420024448111}},&quot;image&quot;:{&quot;url&quot;:&quot;https://icons.biorender.com/biorender/604fc730f37f6000260b4f29/hepatitis-b-capsid-glycoprotein-1.png&quot;,&quot;fallbackUrl&quot;:&quot;https://res.cloudinary.com/dlcjuc3ej/image/upload/v1615841066/uovjah5woegrodmcfaur.svg#/keystone/api/icons/604fc730f37f6000260b4f29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11&quot;}},&quot;999b99f9-5513-4b87-a0ca-1e57d9f2ad83&quot;:{&quot;id&quot;:&quot;999b99f9-5513-4b87-a0ca-1e57d9f2ad83&quot;,&quot;name&quot;:&quot;Hepatitis B (glycoprotein 1)&quot;,&quot;type&quot;:&quot;FIGURE_OBJECT&quot;,&quot;relativeTransform&quot;:{&quot;translate&quot;:{&quot;x&quot;:2.9703489408636417,&quot;y&quot;:3.1840499425738322},&quot;rotate&quot;:1.1971902689768221,&quot;skewX&quot;:-1.446465170755475e-16,&quot;scale&quot;:{&quot;x&quot;:0.047420024448110935,&quot;y&quot;:0.04742002444811099}},&quot;image&quot;:{&quot;url&quot;:&quot;https://icons.biorender.com/biorender/604fc730f37f6000260b4f13/hepatitis-b-capsid-glycoprotein-1.png&quot;,&quot;fallbackUrl&quot;:&quot;https://res.cloudinary.com/dlcjuc3ej/image/upload/v1615841066/jldztueptivbcj2a1aif.svg#/keystone/api/icons/604fc730f37f6000260b4f13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1&quot;}},&quot;8de32ca2-b340-4c60-92fe-493b32296985&quot;:{&quot;id&quot;:&quot;8de32ca2-b340-4c60-92fe-493b32296985&quot;,&quot;name&quot;:&quot;Hepatitis B (glycoprotein 2)&quot;,&quot;type&quot;:&quot;FIGURE_OBJECT&quot;,&quot;relativeTransform&quot;:{&quot;translate&quot;:{&quot;x&quot;:-10.61695812773104,&quot;y&quot;:10.405546047248146},&quot;rotate&quot;:-2.1117165071645188,&quot;skewX&quot;:1.5043901432154098e-16,&quot;scale&quot;:{&quot;x&quot;:0.046498133956451485,&quot;y&quot;:0.046498133956451554}},&quot;image&quot;:{&quot;url&quot;:&quot;https://icons.biorender.com/biorender/604fc5c6f37f6000260b4ee1/20210315204113/image/hepatitis-b-capsid-glycoprotein-2.png&quot;,&quot;fallbackUrl&quot;:&quot;https://res.cloudinary.com/dlcjuc3ej/image/upload/v1615840873/rqbp0tv55nvemgism9fn.svg#/keystone/api/icons/604fc5c6f37f6000260b4ee1/20210315204113/image/hepatitis-b-capsid-glycoprotein-2.svg&quot;,&quot;isPremium&quot;:false,&quot;isPacked&quot;:true,&quot;size&quot;:{&quot;x&quot;:25,&quot;y&quot;:63.75}},&quot;source&quot;:{&quot;id&quot;:&quot;604fc5c6f37f6000260b4ee1&quot;,&quot;type&quot;:&quot;ASSETS&quot;},&quot;parent&quot;:{&quot;type&quot;:&quot;CHILD&quot;,&quot;parentId&quot;:&quot;2294ff48-b891-4c47-94d2-d54c525ca194&quot;,&quot;order&quot;:&quot;12&quot;}},&quot;feade068-cea2-4780-b7b9-6671b8c073b3&quot;:{&quot;id&quot;:&quot;feade068-cea2-4780-b7b9-6671b8c073b3&quot;,&quot;name&quot;:&quot;Hepatitis B (glycoprotein 1)&quot;,&quot;type&quot;:&quot;FIGURE_OBJECT&quot;,&quot;relativeTransform&quot;:{&quot;translate&quot;:{&quot;x&quot;:-10.573169690284274,&quot;y&quot;:10.026902259052267},&quot;rotate&quot;:-2.1117165071645188,&quot;skewX&quot;:1.5043901432154098e-16,&quot;scale&quot;:{&quot;x&quot;:0.046498133956451485,&quot;y&quot;:0.046498133956451554}},&quot;image&quot;:{&quot;url&quot;:&quot;https://icons.biorender.com/biorender/604fc69af37f6000260b4f07/20210315204426/image/hepatitis-b-capsid-glycoprotein-1.png&quot;,&quot;fallbackUrl&quot;:&quot;https://res.cloudinary.com/dlcjuc3ej/image/upload/v1615841066/u3apvfdwwna55umsrl7z.svg#/keystone/api/icons/604fc69af37f6000260b4f07/20210315204426/image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13&quot;}},&quot;88313227-f435-4381-ae0f-76ba1d2559a6&quot;:{&quot;id&quot;:&quot;88313227-f435-4381-ae0f-76ba1d2559a6&quot;,&quot;name&quot;:&quot;Hepatitis B (glycoprotein 1)&quot;,&quot;type&quot;:&quot;FIGURE_OBJECT&quot;,&quot;relativeTransform&quot;:{&quot;translate&quot;:{&quot;x&quot;:-11.071928504513552,&quot;y&quot;:8.90182054993859},&quot;rotate&quot;:-1.9303776348074886,&quot;skewX&quot;:0,&quot;scale&quot;:{&quot;x&quot;:0.04742002444811092,&quot;y&quot;:0.04742002444811093}},&quot;image&quot;:{&quot;url&quot;:&quot;https://icons.biorender.com/biorender/604fc730f37f6000260b4f29/hepatitis-b-capsid-glycoprotein-1.png&quot;,&quot;fallbackUrl&quot;:&quot;https://res.cloudinary.com/dlcjuc3ej/image/upload/v1615841066/uovjah5woegrodmcfaur.svg#/keystone/api/icons/604fc730f37f6000260b4f29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16&quot;}},&quot;1a460fdb-4bb4-4754-afe2-a0781967e90a&quot;:{&quot;id&quot;:&quot;1a460fdb-4bb4-4754-afe2-a0781967e90a&quot;,&quot;name&quot;:&quot;Hepatitis B (glycoprotein 1)&quot;,&quot;type&quot;:&quot;FIGURE_OBJECT&quot;,&quot;relativeTransform&quot;:{&quot;translate&quot;:{&quot;x&quot;:-10.97337139836138,&quot;y&quot;:9.163928226988965},&quot;rotate&quot;:-2.0578339182486296,&quot;skewX&quot;:-2.410775284592458e-16,&quot;scale&quot;:{&quot;x&quot;:0.04742002444811094,&quot;y&quot;:0.04742002444811103}},&quot;image&quot;:{&quot;url&quot;:&quot;https://icons.biorender.com/biorender/604fc730f37f6000260b4f13/hepatitis-b-capsid-glycoprotein-1.png&quot;,&quot;fallbackUrl&quot;:&quot;https://res.cloudinary.com/dlcjuc3ej/image/upload/v1615841066/jldztueptivbcj2a1aif.svg#/keystone/api/icons/604fc730f37f6000260b4f13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15&quot;}},&quot;2ca3626e-72ed-480b-8b4a-d0610c4ccf8b&quot;:{&quot;id&quot;:&quot;2ca3626e-72ed-480b-8b4a-d0610c4ccf8b&quot;,&quot;name&quot;:&quot;Hepatitis B (glycoprotein 2)&quot;,&quot;type&quot;:&quot;FIGURE_OBJECT&quot;,&quot;relativeTransform&quot;:{&quot;translate&quot;:{&quot;x&quot;:-3.74485926879048,&quot;y&quot;:13.888135902073937},&quot;rotate&quot;:-3.1415926535897927,&quot;skewX&quot;:-2.672333720027014e-31,&quot;scale&quot;:{&quot;x&quot;:0.0464981339564515,&quot;y&quot;:0.046498133956451485}},&quot;image&quot;:{&quot;url&quot;:&quot;https://icons.biorender.com/biorender/604fc5c6f37f6000260b4ee1/20210315204113/image/hepatitis-b-capsid-glycoprotein-2.png&quot;,&quot;fallbackUrl&quot;:&quot;https://res.cloudinary.com/dlcjuc3ej/image/upload/v1615840873/rqbp0tv55nvemgism9fn.svg#/keystone/api/icons/604fc5c6f37f6000260b4ee1/20210315204113/image/hepatitis-b-capsid-glycoprotein-2.svg&quot;,&quot;isPremium&quot;:false,&quot;isPacked&quot;:true,&quot;size&quot;:{&quot;x&quot;:25,&quot;y&quot;:63.75}},&quot;source&quot;:{&quot;id&quot;:&quot;604fc5c6f37f6000260b4ee1&quot;,&quot;type&quot;:&quot;ASSETS&quot;},&quot;parent&quot;:{&quot;type&quot;:&quot;CHILD&quot;,&quot;parentId&quot;:&quot;2294ff48-b891-4c47-94d2-d54c525ca194&quot;,&quot;order&quot;:&quot;17&quot;}},&quot;39b645c9-7b9e-4f43-81fb-ad8af06f479c&quot;:{&quot;id&quot;:&quot;39b645c9-7b9e-4f43-81fb-ad8af06f479c&quot;,&quot;name&quot;:&quot;Hepatitis B (glycoprotein 1)&quot;,&quot;type&quot;:&quot;FIGURE_OBJECT&quot;,&quot;relativeTransform&quot;:{&quot;translate&quot;:{&quot;x&quot;:-4.046898297987244,&quot;y&quot;:13.65562575082193},&quot;rotate&quot;:-3.1415926535897927,&quot;skewX&quot;:-2.672333720027014e-31,&quot;scale&quot;:{&quot;x&quot;:0.0464981339564515,&quot;y&quot;:0.046498133956451485}},&quot;image&quot;:{&quot;url&quot;:&quot;https://icons.biorender.com/biorender/604fc69af37f6000260b4f07/20210315204426/image/hepatitis-b-capsid-glycoprotein-1.png&quot;,&quot;fallbackUrl&quot;:&quot;https://res.cloudinary.com/dlcjuc3ej/image/upload/v1615841066/u3apvfdwwna55umsrl7z.svg#/keystone/api/icons/604fc69af37f6000260b4f07/20210315204426/image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2&quot;}},&quot;2e65b54e-1de0-4ee2-a1d4-17daf2fc1e1b&quot;:{&quot;id&quot;:&quot;2e65b54e-1de0-4ee2-a1d4-17daf2fc1e1b&quot;,&quot;name&quot;:&quot;Hepatitis B (glycoprotein 1)&quot;,&quot;type&quot;:&quot;FIGURE_OBJECT&quot;,&quot;relativeTransform&quot;:{&quot;translate&quot;:{&quot;x&quot;:-5.443999992183875,&quot;y&quot;:13.61545547293131},&quot;rotate&quot;:-2.9855353424707043,&quot;skewX&quot;:-1.2053876422962293e-16,&quot;scale&quot;:{&quot;x&quot;:0.047420024448110935,&quot;y&quot;:0.047420024448110935}},&quot;image&quot;:{&quot;url&quot;:&quot;https://icons.biorender.com/biorender/604fc730f37f6000260b4f29/hepatitis-b-capsid-glycoprotein-1.png&quot;,&quot;fallbackUrl&quot;:&quot;https://res.cloudinary.com/dlcjuc3ej/image/upload/v1615841066/uovjah5woegrodmcfaur.svg#/keystone/api/icons/604fc730f37f6000260b4f29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22&quot;}},&quot;94b126da-0c20-4899-88a0-3fc48a4f8db5&quot;:{&quot;id&quot;:&quot;94b126da-0c20-4899-88a0-3fc48a4f8db5&quot;,&quot;name&quot;:&quot;Hepatitis B (glycoprotein 1)&quot;,&quot;type&quot;:&quot;FIGURE_OBJECT&quot;,&quot;relativeTransform&quot;:{&quot;translate&quot;:{&quot;x&quot;:-5.1673745027016915,&quot;y&quot;:13.658955773051876},&quot;rotate&quot;:-3.1129916259118455,&quot;skewX&quot;:-6.629632032629255e-17,&quot;scale&quot;:{&quot;x&quot;:0.04742002444811096,&quot;y&quot;:0.04742002444811107}},&quot;image&quot;:{&quot;url&quot;:&quot;https://icons.biorender.com/biorender/604fc730f37f6000260b4f13/hepatitis-b-capsid-glycoprotein-1.png&quot;,&quot;fallbackUrl&quot;:&quot;https://res.cloudinary.com/dlcjuc3ej/image/upload/v1615841066/jldztueptivbcj2a1aif.svg#/keystone/api/icons/604fc730f37f6000260b4f13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21&quot;}},&quot;834917d2-8a80-49d6-9903-720a41664ddd&quot;:{&quot;id&quot;:&quot;834917d2-8a80-49d6-9903-720a41664ddd&quot;,&quot;name&quot;:&quot;Hepatitis B (glycoprotein 2)&quot;,&quot;type&quot;:&quot;FIGURE_OBJECT&quot;,&quot;relativeTransform&quot;:{&quot;translate&quot;:{&quot;x&quot;:-11.102596748318437,&quot;y&quot;:2.481270118463152},&quot;rotate&quot;:-0.9961735904092504,&quot;skewX&quot;:5.014633810718027e-16,&quot;scale&quot;:{&quot;x&quot;:0.04649813395645151,&quot;y&quot;:0.04649813395645157}},&quot;image&quot;:{&quot;url&quot;:&quot;https://icons.biorender.com/biorender/604fc5c6f37f6000260b4ee1/20210315204113/image/hepatitis-b-capsid-glycoprotein-2.png&quot;,&quot;fallbackUrl&quot;:&quot;https://res.cloudinary.com/dlcjuc3ej/image/upload/v1615840873/rqbp0tv55nvemgism9fn.svg#/keystone/api/icons/604fc5c6f37f6000260b4ee1/20210315204113/image/hepatitis-b-capsid-glycoprotein-2.svg&quot;,&quot;isPremium&quot;:false,&quot;isPacked&quot;:true,&quot;size&quot;:{&quot;x&quot;:25,&quot;y&quot;:63.75}},&quot;source&quot;:{&quot;id&quot;:&quot;604fc5c6f37f6000260b4ee1&quot;,&quot;type&quot;:&quot;ASSETS&quot;},&quot;parent&quot;:{&quot;type&quot;:&quot;CHILD&quot;,&quot;parentId&quot;:&quot;2294ff48-b891-4c47-94d2-d54c525ca194&quot;,&quot;order&quot;:&quot;23&quot;}},&quot;ef4059f6-1b8f-4b3a-bbcc-b78ef0999679&quot;:{&quot;id&quot;:&quot;ef4059f6-1b8f-4b3a-bbcc-b78ef0999679&quot;,&quot;name&quot;:&quot;Hepatitis B (glycoprotein 1)&quot;,&quot;type&quot;:&quot;FIGURE_OBJECT&quot;,&quot;relativeTransform&quot;:{&quot;translate&quot;:{&quot;x&quot;:-10.743264633178105,&quot;y&quot;:2.3541128275902716},&quot;rotate&quot;:-0.9961735904092504,&quot;skewX&quot;:5.014633810718027e-16,&quot;scale&quot;:{&quot;x&quot;:0.04649813395645151,&quot;y&quot;:0.04649813395645157}},&quot;image&quot;:{&quot;url&quot;:&quot;https://icons.biorender.com/biorender/604fc69af37f6000260b4f07/20210315204426/image/hepatitis-b-capsid-glycoprotein-1.png&quot;,&quot;fallbackUrl&quot;:&quot;https://res.cloudinary.com/dlcjuc3ej/image/upload/v1615841066/u3apvfdwwna55umsrl7z.svg#/keystone/api/icons/604fc69af37f6000260b4f07/20210315204426/image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25&quot;}},&quot;d0bac641-619e-4b0c-bfb0-aa3c89f74c5a&quot;:{&quot;id&quot;:&quot;d0bac641-619e-4b0c-bfb0-aa3c89f74c5a&quot;,&quot;name&quot;:&quot;Hepatitis B (glycoprotein 1)&quot;,&quot;type&quot;:&quot;FIGURE_OBJECT&quot;,&quot;relativeTransform&quot;:{&quot;translate&quot;:{&quot;x&quot;:-9.950195670334097,&quot;y&quot;:1.261013225675423},&quot;rotate&quot;:-0.8401162792901616,&quot;skewX&quot;:9.643101138369823e-17,&quot;scale&quot;:{&quot;x&quot;:0.04742002444811096,&quot;y&quot;:0.04742002444811092}},&quot;image&quot;:{&quot;url&quot;:&quot;https://icons.biorender.com/biorender/604fc730f37f6000260b4f29/hepatitis-b-capsid-glycoprotein-1.png&quot;,&quot;fallbackUrl&quot;:&quot;https://res.cloudinary.com/dlcjuc3ej/image/upload/v1615841066/uovjah5woegrodmcfaur.svg#/keystone/api/icons/604fc730f37f6000260b4f29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27&quot;}},&quot;07187a02-0b99-40f0-9311-a0a9c356aebd&quot;:{&quot;id&quot;:&quot;07187a02-0b99-40f0-9311-a0a9c356aebd&quot;,&quot;name&quot;:&quot;Hepatitis B (glycoprotein 1)&quot;,&quot;type&quot;:&quot;FIGURE_OBJECT&quot;,&quot;relativeTransform&quot;:{&quot;translate&quot;:{&quot;x&quot;:-10.137060685410324,&quot;y&quot;:1.4695687427024076},&quot;rotate&quot;:-0.967572562731303,&quot;skewX&quot;:-1.9286202276739614e-16,&quot;scale&quot;:{&quot;x&quot;:0.047420024448111005,&quot;y&quot;:0.04742002444811105}},&quot;image&quot;:{&quot;url&quot;:&quot;https://icons.biorender.com/biorender/604fc730f37f6000260b4f13/hepatitis-b-capsid-glycoprotein-1.png&quot;,&quot;fallbackUrl&quot;:&quot;https://res.cloudinary.com/dlcjuc3ej/image/upload/v1615841066/jldztueptivbcj2a1aif.svg#/keystone/api/icons/604fc730f37f6000260b4f13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26&quot;}},&quot;320d8f41-091f-4eff-b855-c5ff29d1f5ab&quot;:{&quot;id&quot;:&quot;320d8f41-091f-4eff-b855-c5ff29d1f5ab&quot;,&quot;name&quot;:&quot;Hepatitis B (glycoprotein 1)&quot;,&quot;type&quot;:&quot;FIGURE_OBJECT&quot;,&quot;relativeTransform&quot;:{&quot;translate&quot;:{&quot;x&quot;:-1.5397001644411803,&quot;y&quot;:-1.2431290117897147},&quot;rotate&quot;:0.38969636042225847,&quot;skewX&quot;:-3.8572404553479375e-16,&quot;scale&quot;:{&quot;x&quot;:0.047420024448110915,&quot;y&quot;:0.04742002444811083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3&quot;}},&quot;f8248a6a-750b-4939-83b0-6a0420fe406c&quot;:{&quot;id&quot;:&quot;f8248a6a-750b-4939-83b0-6a0420fe406c&quot;,&quot;name&quot;:&quot;Hepatitis B (glycoprotein 1)&quot;,&quot;type&quot;:&quot;FIGURE_OBJECT&quot;,&quot;relativeTransform&quot;:{&quot;translate&quot;:{&quot;x&quot;:-0.28779586529429124,&quot;y&quot;:-0.706720737630165},&quot;rotate&quot;:0.5629995908063324,&quot;skewX&quot;:-5.78586068302189e-16,&quot;scale&quot;:{&quot;x&quot;:0.04742002444811098,&quot;y&quot;:0.04742002444811086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32&quot;}},&quot;6ab7beeb-084b-4de4-a1b9-85a2ba586775&quot;:{&quot;id&quot;:&quot;6ab7beeb-084b-4de4-a1b9-85a2ba586775&quot;,&quot;name&quot;:&quot;Hepatitis B (glycoprotein 1)&quot;,&quot;type&quot;:&quot;FIGURE_OBJECT&quot;,&quot;relativeTransform&quot;:{&quot;translate&quot;:{&quot;x&quot;:0.6192409352717025,&quot;y&quot;:0.0072868561424635474},&quot;rotate&quot;:0.7137857363950431,&quot;skewX&quot;:-3.857240455347942e-16,&quot;scale&quot;:{&quot;x&quot;:0.04742002444811089,&quot;y&quot;:0.04742002444811085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35&quot;}},&quot;2bb327ec-094f-4ce3-8b4a-f8673f2be0e5&quot;:{&quot;id&quot;:&quot;2bb327ec-094f-4ce3-8b4a-f8673f2be0e5&quot;,&quot;name&quot;:&quot;Hepatitis B (glycoprotein 1)&quot;,&quot;type&quot;:&quot;FIGURE_OBJECT&quot;,&quot;relativeTransform&quot;:{&quot;translate&quot;:{&quot;x&quot;:1.7013359207324406,&quot;y&quot;:0.833781769342207},&quot;rotate&quot;:0.8950642320737707,&quot;skewX&quot;:-2.8929303415109515e-16,&quot;scale&quot;:{&quot;x&quot;:0.04742002444811093,&quot;y&quot;:0.04742002444811087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37&quot;}},&quot;78ddbe52-345c-4a30-92af-2a4f88b35a9d&quot;:{&quot;id&quot;:&quot;78ddbe52-345c-4a30-92af-2a4f88b35a9d&quot;,&quot;name&quot;:&quot;Hepatitis B (glycoprotein 1)&quot;,&quot;type&quot;:&quot;FIGURE_OBJECT&quot;,&quot;relativeTransform&quot;:{&quot;translate&quot;:{&quot;x&quot;:-2.6511049970634244,&quot;y&quot;:13.61517436287821},&quot;rotate&quot;:2.9862385326683576,&quot;skewX&quot;:-9.643101138369833e-17,&quot;scale&quot;:{&quot;x&quot;:-0.04742002444811094,&quot;y&quot;:0.047420024448110894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4&quot;}},&quot;c4e0a6b6-b3c0-4ff0-9212-791bf640ce72&quot;:{&quot;id&quot;:&quot;c4e0a6b6-b3c0-4ff0-9212-791bf640ce72&quot;,&quot;name&quot;:&quot;Hepatitis B (glycoprotein 1)&quot;,&quot;type&quot;:&quot;FIGURE_OBJECT&quot;,&quot;relativeTransform&quot;:{&quot;translate&quot;:{&quot;x&quot;:-1.3919202847413017,&quot;y&quot;:13.168938422618861},&quot;rotate&quot;:2.8129353022842825,&quot;skewX&quot;:-1.4464651707554768e-16,&quot;scale&quot;:{&quot;x&quot;:-0.04742002444811091,&quot;y&quot;:0.04742002444811089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42&quot;}},&quot;feca4bf7-5704-420c-af80-a18c46b95921&quot;:{&quot;id&quot;:&quot;feca4bf7-5704-420c-af80-a18c46b95921&quot;,&quot;name&quot;:&quot;Hepatitis B (glycoprotein 1)&quot;,&quot;type&quot;:&quot;FIGURE_OBJECT&quot;,&quot;relativeTransform&quot;:{&quot;translate&quot;:{&quot;x&quot;:-0.2819685938041931,&quot;y&quot;:12.654588181856585},&quot;rotate&quot;:2.6621491566955724,&quot;skewX&quot;:-4.3393955122664305e-16,&quot;scale&quot;:{&quot;x&quot;:-0.04742002444811091,&quot;y&quot;:0.04742002444811084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45&quot;}},&quot;bd5f21f2-ce38-4995-aabf-e4e1876682f9&quot;:{&quot;id&quot;:&quot;bd5f21f2-ce38-4995-aabf-e4e1876682f9&quot;,&quot;name&quot;:&quot;Hepatitis B (glycoprotein 1)&quot;,&quot;type&quot;:&quot;FIGURE_OBJECT&quot;,&quot;relativeTransform&quot;:{&quot;translate&quot;:{&quot;x&quot;:0.8305416344476885,&quot;y&quot;:11.948163343294247},&quot;rotate&quot;:2.480870661016845,&quot;skewX&quot;:0,&quot;scale&quot;:{&quot;x&quot;:-0.04742002444811093,&quot;y&quot;:0.04742002444811092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5&quot;}},&quot;b8c1b7f6-004e-41e2-a411-5169d6b077c1&quot;:{&quot;id&quot;:&quot;b8c1b7f6-004e-41e2-a411-5169d6b077c1&quot;,&quot;name&quot;:&quot;Hepatitis B (glycoprotein 1)&quot;,&quot;type&quot;:&quot;FIGURE_OBJECT&quot;,&quot;relativeTransform&quot;:{&quot;translate&quot;:{&quot;x&quot;:-6.449223616660046,&quot;y&quot;:13.16330013583422},&quot;rotate&quot;:-2.7631293239372448,&quot;skewX&quot;:2.4107752845924635e-16,&quot;scale&quot;:{&quot;x&quot;:0.04742002444811089,&quot;y&quot;:0.047420024448110866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51&quot;}},&quot;0454b67a-8791-4548-af5c-cda26ce6b182&quot;:{&quot;id&quot;:&quot;0454b67a-8791-4548-af5c-cda26ce6b182&quot;,&quot;name&quot;:&quot;Hepatitis B (glycoprotein 1)&quot;,&quot;type&quot;:&quot;FIGURE_OBJECT&quot;,&quot;relativeTransform&quot;:{&quot;translate&quot;:{&quot;x&quot;:-7.701248521402753,&quot;y&quot;:12.72470140987053},&quot;rotate&quot;:-2.58982609355317,&quot;skewX&quot;:-2.8929303415109535e-16,&quot;scale&quot;:{&quot;x&quot;:0.04742002444811091,&quot;y&quot;:0.04742002444811083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52&quot;}},&quot;a21b346c-fb00-400a-8a00-89e64403c437&quot;:{&quot;id&quot;:&quot;a21b346c-fb00-400a-8a00-89e64403c437&quot;,&quot;name&quot;:&quot;Hepatitis B (glycoprotein 1)&quot;,&quot;type&quot;:&quot;FIGURE_OBJECT&quot;,&quot;relativeTransform&quot;:{&quot;translate&quot;:{&quot;x&quot;:-8.823668844853396,&quot;y&quot;:12.003139732241642},&quot;rotate&quot;:-2.43903994796446,&quot;skewX&quot;:-3.857240455347935e-16,&quot;scale&quot;:{&quot;x&quot;:0.04742002444811093,&quot;y&quot;:0.047420024448110866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53&quot;}},&quot;bdf18574-bc59-476a-9e38-3202c6529374&quot;:{&quot;id&quot;:&quot;bdf18574-bc59-476a-9e38-3202c6529374&quot;,&quot;name&quot;:&quot;Hepatitis B (glycoprotein 1)&quot;,&quot;type&quot;:&quot;FIGURE_OBJECT&quot;,&quot;relativeTransform&quot;:{&quot;translate&quot;:{&quot;x&quot;:-9.752299069779836,&quot;y&quot;:11.119329109710078},&quot;rotate&quot;:-2.2577614522857328,&quot;skewX&quot;:2.892930341510954e-16,&quot;scale&quot;:{&quot;x&quot;:0.04742002444811091,&quot;y&quot;:0.04742002444811084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55&quot;}},&quot;775ee221-54d8-41e8-8d89-423268c26672&quot;:{&quot;id&quot;:&quot;775ee221-54d8-41e8-8d89-423268c26672&quot;,&quot;name&quot;:&quot;Hepatitis B (glycoprotein 1)&quot;,&quot;type&quot;:&quot;FIGURE_OBJECT&quot;,&quot;relativeTransform&quot;:{&quot;translate&quot;:{&quot;x&quot;:-5.459903848672204,&quot;y&quot;:-1.4815272812781537},&quot;rotate&quot;:6.125561714347933,&quot;skewX&quot;:2.1696977561332128e-16,&quot;scale&quot;:{&quot;x&quot;:-0.047420024448110935,&quot;y&quot;:0.04742002444811086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56&quot;}},&quot;5a6e1980-5031-4dd9-8f3a-a11acd23c9d8&quot;:{&quot;id&quot;:&quot;5a6e1980-5031-4dd9-8f3a-a11acd23c9d8&quot;,&quot;name&quot;:&quot;Hepatitis B (glycoprotein 1)&quot;,&quot;type&quot;:&quot;FIGURE_OBJECT&quot;,&quot;relativeTransform&quot;:{&quot;translate&quot;:{&quot;x&quot;:-6.711928753414912,&quot;y&quot;:-0.9907693851950129},&quot;rotate&quot;:5.968279016132387,&quot;skewX&quot;:-1.9286202276739688e-16,&quot;scale&quot;:{&quot;x&quot;:-0.047420024448110915,&quot;y&quot;:0.047420024448110935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57&quot;}},&quot;e20d6a35-331a-4edc-8a90-2bc853d11eca&quot;:{&quot;id&quot;:&quot;e20d6a35-331a-4edc-8a90-2bc853d11eca&quot;,&quot;name&quot;:&quot;Hepatitis B (glycoprotein 1)&quot;,&quot;type&quot;:&quot;FIGURE_OBJECT&quot;,&quot;relativeTransform&quot;:{&quot;translate&quot;:{&quot;x&quot;:-7.752650131039647,&quot;y&quot;:-0.42073842685170226},&quot;rotate&quot;:5.812371429712256,&quot;skewX&quot;:-1.2536031479880796e-15,&quot;scale&quot;:{&quot;x&quot;:-0.047420024448110915,&quot;y&quot;:0.047420024448110866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6&quot;}},&quot;eb6a2914-daf3-48a1-b3d2-e450e133357f&quot;:{&quot;id&quot;:&quot;eb6a2914-daf3-48a1-b3d2-e450e133357f&quot;,&quot;name&quot;:&quot;Hepatitis B (glycoprotein 1)&quot;,&quot;type&quot;:&quot;FIGURE_OBJECT&quot;,&quot;relativeTransform&quot;:{&quot;translate&quot;:{&quot;x&quot;:-8.845703489291006,&quot;y&quot;:0.3070304130326092},&quot;rotate&quot;:5.616638061232855,&quot;skewX&quot;:-8.678791024532861e-16,&quot;scale&quot;:{&quot;x&quot;:-0.04742002444811091,&quot;y&quot;:0.04742002444811084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61&quot;}},&quot;df66a729-63ff-4fe9-862b-09727943ec25&quot;:{&quot;id&quot;:&quot;df66a729-63ff-4fe9-862b-09727943ec25&quot;,&quot;name&quot;:&quot;Hepatitis B (glycoprotein 1)&quot;,&quot;type&quot;:&quot;FIGURE_OBJECT&quot;,&quot;relativeTransform&quot;:{&quot;translate&quot;:{&quot;x&quot;:-11.389487981161533,&quot;y&quot;:3.8310818943380145},&quot;rotate&quot;:4.9954154563543565,&quot;skewX&quot;:-9.643101138369875e-17,&quot;scale&quot;:{&quot;x&quot;:-0.04742002444811084,&quot;y&quot;:0.04742002444811087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62&quot;}},&quot;e1a747a8-9cde-4a92-afb8-1935a4f4d77c&quot;:{&quot;id&quot;:&quot;e1a747a8-9cde-4a92-afb8-1935a4f4d77c&quot;,&quot;name&quot;:&quot;Hepatitis B (glycoprotein 1)&quot;,&quot;type&quot;:&quot;FIGURE_OBJECT&quot;,&quot;relativeTransform&quot;:{&quot;translate&quot;:{&quot;x&quot;:-11.454001981284256,&quot;y&quot;:5.0703041807491225},&quot;rotate&quot;:4.807214786152754,&quot;skewX&quot;:-2.1696977561332165e-16,&quot;scale&quot;:{&quot;x&quot;:-0.047420024448110894,&quot;y&quot;:0.04742002444811086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63&quot;}},&quot;46edb614-1762-4754-8a48-0a0ae4bf88f8&quot;:{&quot;id&quot;:&quot;46edb614-1762-4754-8a48-0a0ae4bf88f8&quot;,&quot;name&quot;:&quot;Hepatitis B (glycoprotein 1)&quot;,&quot;type&quot;:&quot;FIGURE_OBJECT&quot;,&quot;relativeTransform&quot;:{&quot;translate&quot;:{&quot;x&quot;:-11.45921290823128,&quot;y&quot;:6.306006191850448},&quot;rotate&quot;:4.682225171718678,&quot;skewX&quot;:-4.2188567480367863e-16,&quot;scale&quot;:{&quot;x&quot;:-0.047420024448111026,&quot;y&quot;:0.04742002444811092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65&quot;}},&quot;764ef850-3a04-46b5-8df4-d71f879b7fb2&quot;:{&quot;id&quot;:&quot;764ef850-3a04-46b5-8df4-d71f879b7fb2&quot;,&quot;name&quot;:&quot;Hepatitis B (glycoprotein 1)&quot;,&quot;type&quot;:&quot;FIGURE_OBJECT&quot;,&quot;relativeTransform&quot;:{&quot;translate&quot;:{&quot;x&quot;:-11.292812877252453,&quot;y&quot;:7.553796530296521},&quot;rotate&quot;:4.486491803239279,&quot;skewX&quot;:9.643101138369847e-17,&quot;scale&quot;:{&quot;x&quot;:-0.04742002444811091,&quot;y&quot;:0.047420024448110845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66&quot;}},&quot;5e82cf08-87ad-415d-8623-2bafbbf6e2f6&quot;:{&quot;id&quot;:&quot;5e82cf08-87ad-415d-8623-2bafbbf6e2f6&quot;,&quot;name&quot;:&quot;Hepatitis B (glycoprotein 1)&quot;,&quot;type&quot;:&quot;FIGURE_OBJECT&quot;,&quot;relativeTransform&quot;:{&quot;translate&quot;:{&quot;x&quot;:3.3731233944855625,&quot;y&quot;:4.924207381728184},&quot;rotate&quot;:1.4548722918420776,&quot;skewX&quot;:1.2053876422962307e-16,&quot;scale&quot;:{&quot;x&quot;:0.04742002444811091,&quot;y&quot;:0.047420024448110915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67&quot;}},&quot;7df4ccc9-893c-493e-a704-876b26614462&quot;:{&quot;id&quot;:&quot;7df4ccc9-893c-493e-a704-876b26614462&quot;,&quot;name&quot;:&quot;Hepatitis B (glycoprotein 1)&quot;,&quot;type&quot;:&quot;FIGURE_OBJECT&quot;,&quot;relativeTransform&quot;:{&quot;translate&quot;:{&quot;x&quot;:3.4888994782637446,&quot;y&quot;:6.163429668139296},&quot;rotate&quot;:1.5707963267948963,&quot;skewX&quot;:-1.3126918150233453e-16,&quot;scale&quot;:{&quot;x&quot;:0.04742002444811089,&quot;y&quot;:0.04742002444811084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7&quot;}},&quot;3addb574-29fb-419a-a700-95a50cf6aa20&quot;:{&quot;id&quot;:&quot;3addb574-29fb-419a-a700-95a50cf6aa20&quot;,&quot;name&quot;:&quot;Hepatitis B (glycoprotein 1)&quot;,&quot;type&quot;:&quot;FIGURE_OBJECT&quot;,&quot;relativeTransform&quot;:{&quot;translate&quot;:{&quot;x&quot;:3.3731318877838667,&quot;y&quot;:7.444703671610327},&quot;rotate&quot;:1.7332459013448196,&quot;skewX&quot;:-4.339395512266412e-16,&quot;scale&quot;:{&quot;x&quot;:0.04742002444811101,&quot;y&quot;:0.04742002444811093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71&quot;}},&quot;d85e47eb-b785-418f-9594-d921115afadd&quot;:{&quot;id&quot;:&quot;d85e47eb-b785-418f-9594-d921115afadd&quot;,&quot;name&quot;:&quot;Hepatitis B (glycoprotein 1)&quot;,&quot;type&quot;:&quot;FIGURE_OBJECT&quot;,&quot;relativeTransform&quot;:{&quot;translate&quot;:{&quot;x&quot;:3.191032843685551,&quot;y&quot;:8.727608537360402},&quot;rotate&quot;:1.8996669526207015,&quot;skewX&quot;:-4.821550569184924e-17,&quot;scale&quot;:{&quot;x&quot;:0.04742002444811091,&quot;y&quot;:0.047420024448110894}},&quot;image&quot;:{&quot;url&quot;:&quot;https://icons.biorender.com/biorender/604fc730f37f6000260b4f28/hepatitis-b-capsid-glycoprotein-1.png&quot;,&quot;fallbackUrl&quot;:&quot;https://res.cloudinary.com/dlcjuc3ej/image/upload/v1615841066/bt8sqlr5ztnycyswtyob.svg#/keystone/api/icons/604fc730f37f6000260b4f28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72&quot;}},&quot;ea886893-79de-4dc7-a6c4-41e9d019811d&quot;:{&quot;id&quot;:&quot;ea886893-79de-4dc7-a6c4-41e9d019811d&quot;,&quot;name&quot;:&quot;Hepatitis B (glycoprotein 2)&quot;,&quot;type&quot;:&quot;FIGURE_OBJECT&quot;,&quot;relativeTransform&quot;:{&quot;translate&quot;:{&quot;x&quot;:2.836218389561781,&quot;y&quot;:9.947566536339131},&quot;rotate&quot;:2.146737665589561,&quot;skewX&quot;:1.0029267621436081e-16,&quot;scale&quot;:{&quot;x&quot;:0.04649813395645145,&quot;y&quot;:0.04649813395645143}},&quot;image&quot;:{&quot;url&quot;:&quot;https://icons.biorender.com/biorender/604fc5c6f37f6000260b4ee1/20210315204113/image/hepatitis-b-capsid-glycoprotein-2.png&quot;,&quot;fallbackUrl&quot;:&quot;https://res.cloudinary.com/dlcjuc3ej/image/upload/v1615840873/rqbp0tv55nvemgism9fn.svg#/keystone/api/icons/604fc5c6f37f6000260b4ee1/20210315204113/image/hepatitis-b-capsid-glycoprotein-2.svg&quot;,&quot;isPremium&quot;:false,&quot;isPacked&quot;:true,&quot;size&quot;:{&quot;x&quot;:25,&quot;y&quot;:63.75}},&quot;source&quot;:{&quot;id&quot;:&quot;604fc5c6f37f6000260b4ee1&quot;,&quot;type&quot;:&quot;ASSETS&quot;},&quot;parent&quot;:{&quot;type&quot;:&quot;CHILD&quot;,&quot;parentId&quot;:&quot;2294ff48-b891-4c47-94d2-d54c525ca194&quot;,&quot;order&quot;:&quot;73&quot;}},&quot;dfec35d7-90f8-4285-8853-86c336f63d82&quot;:{&quot;id&quot;:&quot;dfec35d7-90f8-4285-8853-86c336f63d82&quot;,&quot;name&quot;:&quot;Hepatitis B (glycoprotein 1)&quot;,&quot;type&quot;:&quot;FIGURE_OBJECT&quot;,&quot;relativeTransform&quot;:{&quot;translate&quot;:{&quot;x&quot;:2.4767189169475103,&quot;y&quot;:10.074249900611697},&quot;rotate&quot;:2.146737665589561,&quot;skewX&quot;:1.0029267621436081e-16,&quot;scale&quot;:{&quot;x&quot;:0.04649813395645145,&quot;y&quot;:0.04649813395645143}},&quot;image&quot;:{&quot;url&quot;:&quot;https://icons.biorender.com/biorender/604fc69af37f6000260b4f07/20210315204426/image/hepatitis-b-capsid-glycoprotein-1.png&quot;,&quot;fallbackUrl&quot;:&quot;https://res.cloudinary.com/dlcjuc3ej/image/upload/v1615841066/u3apvfdwwna55umsrl7z.svg#/keystone/api/icons/604fc69af37f6000260b4f07/20210315204426/image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75&quot;}},&quot;5cf65c19-689b-49fb-8b38-cf377ccea987&quot;:{&quot;id&quot;:&quot;5cf65c19-689b-49fb-8b38-cf377ccea987&quot;,&quot;name&quot;:&quot;Hepatitis B (glycoprotein 1)&quot;,&quot;type&quot;:&quot;FIGURE_OBJECT&quot;,&quot;relativeTransform&quot;:{&quot;translate&quot;:{&quot;x&quot;:1.6678716488992633,&quot;y&quot;:11.03848286134467},&quot;rotate&quot;:2.4099052286599867,&quot;skewX&quot;:7.714480910695885e-16,&quot;scale&quot;:{&quot;x&quot;:0.04742002444811088,&quot;y&quot;:0.04742002444811084}},&quot;image&quot;:{&quot;url&quot;:&quot;https://icons.biorender.com/biorender/604fc730f37f6000260b4f29/hepatitis-b-capsid-glycoprotein-1.png&quot;,&quot;fallbackUrl&quot;:&quot;https://res.cloudinary.com/dlcjuc3ej/image/upload/v1615841066/uovjah5woegrodmcfaur.svg#/keystone/api/icons/604fc730f37f6000260b4f29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77&quot;}},&quot;4339cf6e-5040-440d-84eb-2d4e0538af39&quot;:{&quot;id&quot;:&quot;4339cf6e-5040-440d-84eb-2d4e0538af39&quot;,&quot;name&quot;:&quot;Hepatitis B (glycoprotein 1)&quot;,&quot;type&quot;:&quot;FIGURE_OBJECT&quot;,&quot;relativeTransform&quot;:{&quot;translate&quot;:{&quot;x&quot;:1.8762084224057858,&quot;y&quot;:10.851373999056626},&quot;rotate&quot;:2.282448945218845,&quot;skewX&quot;:5.785860683021898e-16,&quot;scale&quot;:{&quot;x&quot;:0.04742002444811095,&quot;y&quot;:0.04742002444811102}},&quot;image&quot;:{&quot;url&quot;:&quot;https://icons.biorender.com/biorender/604fc730f37f6000260b4f13/hepatitis-b-capsid-glycoprotein-1.png&quot;,&quot;fallbackUrl&quot;:&quot;https://res.cloudinary.com/dlcjuc3ej/image/upload/v1615841066/jldztueptivbcj2a1aif.svg#/keystone/api/icons/604fc730f37f6000260b4f13/hepatitis-b-capsid-glycoprotein-1.svg&quot;,&quot;isPremium&quot;:false,&quot;isPacked&quot;:true,&quot;size&quot;:{&quot;x&quot;:25,&quot;y&quot;:53.75}},&quot;source&quot;:{&quot;id&quot;:&quot;604fc69af37f6000260b4f07&quot;,&quot;type&quot;:&quot;ASSETS&quot;},&quot;parent&quot;:{&quot;type&quot;:&quot;CHILD&quot;,&quot;parentId&quot;:&quot;2294ff48-b891-4c47-94d2-d54c525ca194&quot;,&quot;order&quot;:&quot;76&quot;}},&quot;66418f29-8c2f-4155-833b-022eb2c7c136&quot;:{&quot;type&quot;:&quot;FIGURE_OBJECT&quot;,&quot;id&quot;:&quot;66418f29-8c2f-4155-833b-022eb2c7c136&quot;,&quot;relativeTransform&quot;:{&quot;translate&quot;:{&quot;x&quot;:-4.015123199971689,&quot;y&quot;:8.51853978813731},&quot;rotate&quot;:-3.1415926535897927,&quot;skewX&quot;:5.5511151231257796e-17},&quot;opacity&quot;:1,&quot;path&quot;:{&quot;type&quot;:&quot;ELLIPSE&quot;,&quot;size&quot;:{&quot;x&quot;:-1.1874355651664736,&quot;y&quot;:-1.1874355651664739}},&quot;isLocked&quot;:false,&quot;pathStyles&quot;:[{&quot;type&quot;:&quot;FILL&quot;,&quot;fillStyle&quot;:&quot;rgba(128, 42, 42, 1)&quot;},{&quot;type&quot;:&quot;STROKE&quot;,&quot;strokeStyle&quot;:&quot;rgba(69, 12, 13, 1)&quot;,&quot;lineWidth&quot;:0.051240139557315066,&quot;lineJoin&quot;:&quot;round&quot;}],&quot;parent&quot;:{&quot;type&quot;:&quot;CHILD&quot;,&quot;parentId&quot;:&quot;2294ff48-b891-4c47-94d2-d54c525ca194&quot;,&quot;order&quot;:&quot;95&quot;}},&quot;9c0208f5-de4a-45a3-b4d0-445456fdf9c3&quot;:{&quot;type&quot;:&quot;FIGURE_OBJECT&quot;,&quot;id&quot;:&quot;9c0208f5-de4a-45a3-b4d0-445456fdf9c3&quot;,&quot;relativeTransform&quot;:{&quot;translate&quot;:{&quot;x&quot;:-1.4507782478082063,&quot;y&quot;:8.423805187388298},&quot;rotate&quot;:0},&quot;opacity&quot;:1,&quot;path&quot;:{&quot;type&quot;:&quot;POLY_LINE&quot;,&quot;points&quot;:[{&quot;x&quot;:-0.6179330539722107,&quot;y&quot;:0.8645326527938123},{&quot;x&quot;:-0.6179330539722107,&quot;y&quot;:0.45033687320760046},{&quot;x&quot;:-0.18040779809061275,&quot;y&quot;:0.22074278077924675},{&quot;x&quot;:-0.14593252539051732,&quot;y&quot;:-0.32549438173744194}],&quot;closed&quot;:false},&quot;pathStyles&quot;:[{&quot;type&quot;:&quot;FILL&quot;,&quot;fillStyle&quot;:&quot;rgba(0,0,0,0)&quot;},{&quot;type&quot;:&quot;STROKE&quot;,&quot;strokeStyle&quot;:&quot;rgb(158, 92, 220)&quot;,&quot;lineWidth&quot;:0.08618818175023743,&quot;lineJoin&quot;:&quot;round&quot;}],&quot;pathSmoothing&quot;:{&quot;type&quot;:&quot;CATMULL_SMOOTHING&quot;,&quot;smoothing&quot;:0.2},&quot;isLocked&quot;:false,&quot;parent&quot;:{&quot;type&quot;:&quot;CHILD&quot;,&quot;parentId&quot;:&quot;2294ff48-b891-4c47-94d2-d54c525ca194&quot;,&quot;order&quot;:&quot;9&quot;}},&quot;d3e5ad3a-99ef-4095-b115-cbe7c1c9281d&quot;:{&quot;relativeTransform&quot;:{&quot;translate&quot;:{&quot;x&quot;:219.9254194294635,&quot;y&quot;:-146.67771625352398},&quot;rotate&quot;:-3.012343009893442,&quot;skewX&quot;:0,&quot;scale&quot;:{&quot;x&quot;:0.9999999999999999,&quot;y&quot;:1}},&quot;type&quot;:&quot;FIGURE_OBJECT&quot;,&quot;id&quot;:&quot;d3e5ad3a-99ef-4095-b115-cbe7c1c9281d&quot;,&quot;parent&quot;:{&quot;type&quot;:&quot;CHILD&quot;,&quot;parentId&quot;:&quot;40e1d13b-5ddf-41c4-878b-42ca49175b0f&quot;,&quot;order&quot;:&quot;5&quot;},&quot;name&quot;:&quot;Antibody (round style, single color, editable)&quot;,&quot;displayName&quot;:&quot;Antibody (round style, single color, editable)&quot;,&quot;source&quot;:{&quot;id&quot;:&quot;66fda792656920bc91b7c5a8&quot;,&quot;type&quot;:&quot;ASSETS&quot;},&quot;isPremium&quot;:true},&quot;3e98bfff-fff6-4e7a-9f19-f3e3853a778f&quot;:{&quot;type&quot;:&quot;FIGURE_OBJECT&quot;,&quot;id&quot;:&quot;3e98bfff-fff6-4e7a-9f19-f3e3853a778f&quot;,&quot;path&quot;:{&quot;type&quot;:&quot;POLY_LINE&quot;,&quot;points&quot;:[{&quot;x&quot;:3.248320604777199,&quot;y&quot;:6.063635109649155},{&quot;x&quot;:3.248320604777199,&quot;y&quot;:9.008840082811105},{&quot;x&quot;:3.248320604777199,&quot;y&quot;:10.507240654372783},{&quot;x&quot;:3.3587619086615144,&quot;y&quot;:11.785931406747059},{&quot;x&quot;:3.7865885053831367,&quot;y&quot;:12.289740537663008},{&quot;x&quot;:4.638751046577052,&quot;y&quot;:12.289740537663008},{&quot;x&quot;:5.083629771584657,&quot;y&quot;:11.79136620144184},{&quot;x&quot;:5.143870482794282,&quot;y&quot;:10.949813473526305},{&quot;x&quot;:5.143870482794282,&quot;y&quot;:10.429666714534871},{&quot;x&quot;:5.15892263684725,&quot;y&quot;:5.961323581146905},{&quot;x&quot;:5.15892263684725,&quot;y&quot;:1.6184819294456616},{&quot;x&quot;:5.15892263684725,&quot;y&quot;:1.2113358980703026},{&quot;x&quot;:5.199083110987003,&quot;y&quot;:0.7507901059271797},{&quot;x&quot;:5.327173534385311,&quot;y&quot;:0.44376977392282524},{&quot;x&quot;:5.715195463300762,&quot;y&quot;:-0.1504232045214788},{&quot;x&quot;:9.457276956156829,&quot;y&quot;:-5.480063650241141},{&quot;x&quot;:9.69822994318949,&quot;y&quot;:-5.822457109222089},{&quot;x&quot;:9.915142722611597,&quot;y&quot;:-6.2335010608770345},{&quot;x&quot;:9.915142722611597,&quot;y&quot;:-6.7759715555920605},{&quot;x&quot;:9.701921675930915,&quot;y&quot;:-7.191862924151122},{&quot;x&quot;:9.295259705086742,&quot;y&quot;:-7.4273687023821555},{&quot;x&quot;:8.713969060951428,&quot;y&quot;:-7.4273687023821555},{&quot;x&quot;:8.31081939546248,&quot;y&quot;:-7.144337552045661},{&quot;x&quot;:7.9516809546240586,&quot;y&quot;:-6.65912303789571},{&quot;x&quot;:6.9887585803829335,&quot;y&quot;:-5.269209238944615},{&quot;x&quot;:5.696803678093294,&quot;y&quot;:-3.4158050293935966},{&quot;x&quot;:4.521538130585339,&quot;y&quot;:-1.751696461008587},{&quot;x&quot;:3.5983236499360767,&quot;y&quot;:-0.430012377772665},{&quot;x&quot;:3.3762924501282208,&quot;y&quot;:-0.09752191113794823},{&quot;x&quot;:3.298198021070775,&quot;y&quot;:0.1634584538511797},{&quot;x&quot;:3.2329372505936793,&quot;y&quot;:1.0847776064626293},{&quot;x&quot;:3.2329372505936793,&quot;y&quot;:1.6963347717961763},{&quot;x&quot;:3.2329372505936793,&quot;y&quot;:2.9007285024759333}],&quot;closed&quot;:true},&quot;pathSmoothing&quot;:{&quot;type&quot;:&quot;BISECT_SMOOTHING&quot;,&quot;smoothing&quot;:1,&quot;endPointMirroring&quot;:&quot;MIRROR_TANGENT_BOTH&quot;},&quot;pathStyles&quot;:[{&quot;type&quot;:&quot;FILL&quot;,&quot;fillStyle&quot;:&quot;rgba(66, 121, 189, 1)&quot;},{&quot;type&quot;:&quot;STROKE&quot;,&quot;strokeStyle&quot;:&quot;rgba(37, 58, 120, 1)&quot;,&quot;lineWidth&quot;:0.1861124502661381,&quot;lineJoin&quot;:&quot;round&quot;}],&quot;relativeTransform&quot;:{&quot;translate&quot;:{&quot;x&quot;:-1.3341440570376006,&quot;y&quot;:-1.0073090885052527},&quot;rotate&quot;:0},&quot;parent&quot;:{&quot;type&quot;:&quot;CHILD&quot;,&quot;parentId&quot;:&quot;d3e5ad3a-99ef-4095-b115-cbe7c1c9281d&quot;,&quot;order&quot;:&quot;1&quot;},&quot;connectorInfo&quot;:{&quot;connectedObjects&quot;:[],&quot;type&quot;:&quot;CUBIC&quot;,&quot;offset&quot;:{&quot;x&quot;:0,&quot;y&quot;:0},&quot;bending&quot;:0.1,&quot;firstElementIsHead&quot;:true,&quot;customized&quot;:true}},&quot;b67d5c8b-ea62-45e2-b5e0-ff229bd487f6&quot;:{&quot;type&quot;:&quot;FIGURE_OBJECT&quot;,&quot;id&quot;:&quot;b67d5c8b-ea62-45e2-b5e0-ff229bd487f6&quot;,&quot;relativeTransform&quot;:{&quot;translate&quot;:{&quot;x&quot;:8.277778539840433,&quot;y&quot;:-3.1189504859175794},&quot;rotate&quot;:0.6147863133011935,&quot;skewX&quot;:2.6771586893876386e-16},&quot;opacity&quot;:1,&quot;path&quot;:{&quot;type&quot;:&quot;RECT&quot;,&quot;size&quot;:{&quot;x&quot;:2.110925351572318,&quot;y&quot;:8.549916704929819},&quot;cornerRounding&quot;:{&quot;type&quot;:&quot;ARC_LENGTH&quot;,&quot;global&quot;:1.787322608365319},&quot;selectedObjectIds&quot;:[&quot;a6aa7d02-4965-4e56-b961-b56c4151f571&quot;]},&quot;pathStyles&quot;:[{&quot;type&quot;:&quot;FILL&quot;,&quot;fillStyle&quot;:&quot;rgba(66, 121, 189, 1)&quot;},{&quot;type&quot;:&quot;STROKE&quot;,&quot;strokeStyle&quot;:&quot;rgba(37, 58, 120, 1)&quot;,&quot;lineWidth&quot;:0.186112450266138,&quot;lineJoin&quot;:&quot;round&quot;}],&quot;isLocked&quot;:false,&quot;parent&quot;:{&quot;type&quot;:&quot;CHILD&quot;,&quot;parentId&quot;:&quot;d3e5ad3a-99ef-4095-b115-cbe7c1c9281d&quot;,&quot;order&quot;:&quot;2&quot;}},&quot;b054cbf9-a190-458e-b32b-6e67b6174fab&quot;:{&quot;type&quot;:&quot;FIGURE_OBJECT&quot;,&quot;id&quot;:&quot;b054cbf9-a190-458e-b32b-6e67b6174fab&quot;,&quot;path&quot;:{&quot;type&quot;:&quot;POLY_LINE&quot;,&quot;points&quot;:[{&quot;x&quot;:-3.248320604777199,&quot;y&quot;:6.063635109649155},{&quot;x&quot;:-3.248320604777199,&quot;y&quot;:9.008840082811105},{&quot;x&quot;:-3.248320604777199,&quot;y&quot;:10.507240654372783},{&quot;x&quot;:-3.3587619086615144,&quot;y&quot;:11.785931406747059},{&quot;x&quot;:-3.7865885053831367,&quot;y&quot;:12.289740537663008},{&quot;x&quot;:-4.638751046577052,&quot;y&quot;:12.289740537663008},{&quot;x&quot;:-5.083629771584657,&quot;y&quot;:11.79136620144184},{&quot;x&quot;:-5.143870482794282,&quot;y&quot;:10.949813473526305},{&quot;x&quot;:-5.143870482794282,&quot;y&quot;:10.429666714534871},{&quot;x&quot;:-5.15892263684725,&quot;y&quot;:5.961323581146905},{&quot;x&quot;:-5.15892263684725,&quot;y&quot;:1.6184819294456616},{&quot;x&quot;:-5.15892263684725,&quot;y&quot;:1.2113358980703026},{&quot;x&quot;:-5.199083110987003,&quot;y&quot;:0.7507901059271797},{&quot;x&quot;:-5.327173534385311,&quot;y&quot;:0.44376977392282524},{&quot;x&quot;:-5.715195463300762,&quot;y&quot;:-0.1504232045214788},{&quot;x&quot;:-9.457276956156829,&quot;y&quot;:-5.480063650241141},{&quot;x&quot;:-9.69822994318949,&quot;y&quot;:-5.822457109222089},{&quot;x&quot;:-9.915142722611597,&quot;y&quot;:-6.2335010608770345},{&quot;x&quot;:-9.915142722611597,&quot;y&quot;:-6.7759715555920605},{&quot;x&quot;:-9.701921675930915,&quot;y&quot;:-7.191862924151122},{&quot;x&quot;:-9.295259705086742,&quot;y&quot;:-7.4273687023821555},{&quot;x&quot;:-8.713969060951428,&quot;y&quot;:-7.4273687023821555},{&quot;x&quot;:-8.31081939546248,&quot;y&quot;:-7.144337552045661},{&quot;x&quot;:-7.9516809546240586,&quot;y&quot;:-6.65912303789571},{&quot;x&quot;:-6.9887585803829335,&quot;y&quot;:-5.269209238944615},{&quot;x&quot;:-5.696803678093294,&quot;y&quot;:-3.4158050293935966},{&quot;x&quot;:-4.521538130585339,&quot;y&quot;:-1.751696461008587},{&quot;x&quot;:-3.5983236499360767,&quot;y&quot;:-0.430012377772665},{&quot;x&quot;:-3.3762924501282208,&quot;y&quot;:-0.09752191113794823},{&quot;x&quot;:-3.298198021070775,&quot;y&quot;:0.1634584538511797},{&quot;x&quot;:-3.2329372505936793,&quot;y&quot;:1.0847776064626293},{&quot;x&quot;:-3.2329372505936793,&quot;y&quot;:1.6963347717961763},{&quot;x&quot;:-3.2329372505936793,&quot;y&quot;:2.9007285024759333}],&quot;closed&quot;:true},&quot;pathSmoothing&quot;:{&quot;type&quot;:&quot;BISECT_SMOOTHING&quot;,&quot;smoothing&quot;:1,&quot;endPointMirroring&quot;:&quot;MIRROR_TANGENT_BOTH&quot;},&quot;pathStyles&quot;:[{&quot;type&quot;:&quot;FILL&quot;,&quot;fillStyle&quot;:&quot;rgba(66, 121, 189, 1)&quot;},{&quot;type&quot;:&quot;STROKE&quot;,&quot;strokeStyle&quot;:&quot;rgba(37, 58, 120, 1)&quot;,&quot;lineWidth&quot;:0.1861124502661381,&quot;lineJoin&quot;:&quot;round&quot;}],&quot;relativeTransform&quot;:{&quot;translate&quot;:{&quot;x&quot;:3.8116110308459037,&quot;y&quot;:-1.0073090885052527},&quot;rotate&quot;:-2.449293598294706e-16},&quot;parent&quot;:{&quot;type&quot;:&quot;CHILD&quot;,&quot;parentId&quot;:&quot;d3e5ad3a-99ef-4095-b115-cbe7c1c9281d&quot;,&quot;order&quot;:&quot;5&quot;},&quot;connectorInfo&quot;:{&quot;connectedObjects&quot;:[],&quot;type&quot;:&quot;CUBIC&quot;,&quot;offset&quot;:{&quot;x&quot;:0,&quot;y&quot;:0},&quot;bending&quot;:0.1,&quot;firstElementIsHead&quot;:true,&quot;customized&quot;:true}},&quot;1755ea16-bf5e-4f39-92d6-bb2f9201073c&quot;:{&quot;type&quot;:&quot;FIGURE_OBJECT&quot;,&quot;id&quot;:&quot;1755ea16-bf5e-4f39-92d6-bb2f9201073c&quot;,&quot;relativeTransform&quot;:{&quot;translate&quot;:{&quot;x&quot;:-5.800311566032129,&quot;y&quot;:-3.1189504859175794},&quot;rotate&quot;:-0.6147863133011939,&quot;skewX&quot;:-8.923862297958795e-17},&quot;opacity&quot;:1,&quot;path&quot;:{&quot;type&quot;:&quot;RECT&quot;,&quot;size&quot;:{&quot;x&quot;:-2.110925351572317,&quot;y&quot;:8.549916704929817},&quot;cornerRounding&quot;:{&quot;type&quot;:&quot;ARC_LENGTH&quot;,&quot;global&quot;:1.7873226083653189},&quot;selectedObjectIds&quot;:[&quot;a6aa7d02-4965-4e56-b961-b56c4151f571&quot;]},&quot;pathStyles&quot;:[{&quot;type&quot;:&quot;FILL&quot;,&quot;fillStyle&quot;:&quot;rgba(66, 121, 189, 1)&quot;},{&quot;type&quot;:&quot;STROKE&quot;,&quot;strokeStyle&quot;:&quot;rgba(37, 58, 120, 1)&quot;,&quot;lineWidth&quot;:0.18611245026613796,&quot;lineJoin&quot;:&quot;round&quot;}],&quot;isLocked&quot;:false,&quot;parent&quot;:{&quot;type&quot;:&quot;CHILD&quot;,&quot;parentId&quot;:&quot;d3e5ad3a-99ef-4095-b115-cbe7c1c9281d&quot;,&quot;order&quot;:&quot;7&quot;}},&quot;ff8053df-a3ba-49a4-8fdf-edcf90091f9f&quot;:{&quot;id&quot;:&quot;ff8053df-a3ba-49a4-8fdf-edcf90091f9f&quot;,&quot;name&quot;:&quot;Hepatitis B (glycoprotein 1)&quot;,&quot;displayName&quot;:&quot;&quot;,&quot;type&quot;:&quot;FIGURE_OBJECT&quot;,&quot;relativeTransform&quot;:{&quot;translate&quot;:{&quot;x&quot;:223.5573504460562,&quot;y&quot;:-163.74249841634463},&quot;rotate&quot;:-0.3058002725220848,&quot;skewX&quot;:-3.196924350369841e-17,&quot;scale&quot;:{&quot;x&quot;:0.46588523171565827,&quot;y&quot;:0.46588523171565815}},&quot;image&quot;:{&quot;url&quot;:&quot;https://icons.cdn.biorender.com/biorender/604fc69af37f6000260b4f07/20210315204426/image/604fc69af37f6000260b4f07.png&quot;,&quot;isPremium&quot;:false,&quot;isOrgIcon&quot;:false,&quot;size&quot;:{&quot;x&quot;:25,&quot;y&quot;:53.75}},&quot;source&quot;:{&quot;id&quot;:&quot;604fc69af37f6000260b4f07&quot;,&quot;version&quot;:&quot;20210315204426&quot;,&quot;type&quot;:&quot;ASSETS&quot;},&quot;isPremium&quot;:false,&quot;parent&quot;:{&quot;type&quot;:&quot;CHILD&quot;,&quot;parentId&quot;:&quot;40e1d13b-5ddf-41c4-878b-42ca49175b0f&quot;,&quot;order&quot;:&quot;7&quot;}},&quot;d82398b9-3d7d-4d5b-9e70-20d5fceae8eb&quot;:{&quot;type&quot;:&quot;FIGURE_OBJECT&quot;,&quot;id&quot;:&quot;d82398b9-3d7d-4d5b-9e70-20d5fceae8eb&quot;,&quot;relativeTransform&quot;:{&quot;translate&quot;:{&quot;x&quot;:337.6697378380876,&quot;y&quot;:-153.18830799702093},&quot;rotate&quot;:0,&quot;skewX&quot;:0,&quot;scale&quot;:{&quot;x&quot;:1,&quot;y&quot;:1}},&quot;opacity&quot;:1,&quot;path&quot;:{&quot;type&quot;:&quot;RECT&quot;,&quot;size&quot;:{&quot;x&quot;:259.0075752364007,&quot;y&quot;:75.55303007771126},&quot;cornerRounding&quot;:{&quot;type&quot;:&quot;ARC_LENGTH&quot;,&quot;global&quot;:15.46996382151473}},&quot;pathStyles&quot;:[{&quot;type&quot;:&quot;FILL&quot;,&quot;fillStyle&quot;:&quot;#EEF4FB&quot;},{&quot;type&quot;:&quot;STROKE&quot;,&quot;strokeStyle&quot;:&quot;#95AAD3&quot;,&quot;lineWidth&quot;:1.9696969693174853,&quot;lineJoin&quot;:&quot;round&quot;}],&quot;isLocked&quot;:false,&quot;parent&quot;:{&quot;type&quot;:&quot;CHILD&quot;,&quot;parentId&quot;:&quot;865a3a62-89db-4a0f-9081-e39324f060c0&quot;,&quot;order&quot;:&quot;998&quot;},&quot;layout&quot;:{&quot;sizeRatio&quot;:{&quot;x&quot;:0.88,&quot;y&quot;:0.88},&quot;keepAspectRatio&quot;:false}},&quot;6a4eeb60-047a-43bb-b6aa-9405ea56cf7f&quot;:{&quot;id&quot;:&quot;6a4eeb60-047a-43bb-b6aa-9405ea56cf7f&quot;,&quot;type&quot;:&quot;FIGURE_OBJECT&quot;,&quot;relativeTransform&quot;:{&quot;translate&quot;:{&quot;x&quot;:0,&quot;y&quot;:0},&quot;rotate&quot;:0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4.666666666666666,&quot;color&quot;:&quot;black&quot;,&quot;fontWeight&quot;:&quot;normal&quot;,&quot;fontStyle&quot;:&quot;normal&quot;,&quot;decoration&quot;:&quot;none&quot;},&quot;range&quot;:[0,17]}],&quot;text&quot;:&quot;Exclusion criteria&quot;,&quot;baseStyle&quot;:{&quot;fontFamily&quot;:&quot;Roboto&quot;,&quot;fontSize&quot;:14.666666666666666,&quot;color&quot;:&quot;black&quot;,&quot;fontWeight&quot;:&quot;normal&quot;,&quot;fontStyle&quot;:&quot;normal&quot;,&quot;decoration&quot;:&quot;none&quot;,&quot;script&quot;:&quot;none&quot;}},{&quot;textIndent&quot;:{&quot;type&quot;:&quot;none&quot;,&quot;indent&quot;:1,&quot;symbol&quot;:&quot; &quot;,&quot;unit&quot;:&quot;levels&quot;},&quot;runs&quot;:[{&quot;style&quot;:{&quot;fontFamily&quot;:&quot;Roboto&quot;,&quot;fontSize&quot;:13.131313130731215,&quot;color&quot;:&quot;black&quot;,&quot;fontWeight&quot;:&quot;normal&quot;,&quot;fontStyle&quot;:&quot;normal&quot;,&quot;decoration&quot;:&quot;none&quot;,&quot;script&quot;:&quot;none&quot;},&quot;range&quot;:[0,39]}],&quot;text&quot;:&quot;HbSAg, HBcAb, anti HCV positive and/or  &quot;},{&quot;textIndent&quot;:{&quot;type&quot;:&quot;none&quot;,&quot;indent&quot;:1,&quot;symbol&quot;:&quot; &quot;,&quot;unit&quot;:&quot;levels&quot;},&quot;runs&quot;:[{&quot;style&quot;:{&quot;fontFamily&quot;:&quot;Roboto&quot;,&quot;fontSize&quot;:13.131313130731215,&quot;color&quot;:&quot;black&quot;,&quot;fontWeight&quot;:&quot;normal&quot;,&quot;fontStyle&quot;:&quot;normal&quot;,&quot;decoration&quot;:&quot;none&quot;,&quot;script&quot;:&quot;none&quot;},&quot;range&quot;:[0,29]}],&quot;text&quot;:&quot;History of hepatitis infection&quot;,&quot;baseStyle&quot;:{&quot;fontFamily&quot;:&quot;Roboto&quot;,&quot;fontSize&quot;:13.131313130731215,&quot;color&quot;:&quot;black&quot;,&quot;fontWeight&quot;:&quot;normal&quot;,&quot;fontStyle&quot;:&quot;normal&quot;,&quot;decoration&quot;:&quot;none&quot;,&quot;script&quot;:&quot;none&quot;}}],&quot;_lastCaretLocation&quot;:{&quot;lineIndex&quot;:2,&quot;runIndex&quot;:-1,&quot;charIndex&quot;:-1,&quot;endOfLine&quot;:true}},&quot;format&quot;:&quot;BETTER_TEXT&quot;,&quot;size&quot;:{&quot;x&quot;:227.92666620803263,&quot;y&quot;:63},&quot;targetSize&quot;:{&quot;x&quot;:227.92666620803263,&quot;y&quot;:2}},&quot;parent&quot;:{&quot;type&quot;:&quot;CHILD&quot;,&quot;parentId&quot;:&quot;d82398b9-3d7d-4d5b-9e70-20d5fceae8eb&quot;,&quot;order&quot;:&quot;5&quot;}},&quot;40e1d13b-5ddf-41c4-878b-42ca49175b0f&quot;:{&quot;type&quot;:&quot;FIGURE_OBJECT&quot;,&quot;id&quot;:&quot;40e1d13b-5ddf-41c4-878b-42ca49175b0f&quot;,&quot;parent&quot;:{&quot;type&quot;:&quot;CHILD&quot;,&quot;parentId&quot;:&quot;865a3a62-89db-4a0f-9081-e39324f060c0&quot;,&quot;order&quot;:&quot;9995&quot;},&quot;relativeTransform&quot;:{&quot;translate&quot;:{&quot;x&quot;:7.4909999999999854,&quot;y&quot;:1.850999999999999},&quot;rotate&quot;:0,&quot;skewX&quot;:0,&quot;scale&quot;:{&quot;x&quot;:1,&quot;y&quot;:1}}},&quot;300e1f6c-6486-453a-8f4d-43cc6a89d2d6&quot;:{&quot;type&quot;:&quot;FIGURE_OBJECT&quot;,&quot;id&quot;:&quot;300e1f6c-6486-453a-8f4d-43cc6a89d2d6&quot;,&quot;relativeTransform&quot;:{&quot;translate&quot;:{&quot;x&quot;:337.66952571692264,&quot;y&quot;:-65.42739029759605},&quot;rotate&quot;:0},&quot;opacity&quot;:1,&quot;path&quot;:{&quot;type&quot;:&quot;RECT&quot;,&quot;size&quot;:{&quot;x&quot;:259.0071510222479,&quot;y&quot;:74.26830351287967},&quot;cornerRounding&quot;:{&quot;type&quot;:&quot;ARC_LENGTH&quot;,&quot;global&quot;:15.46993848411836}},&quot;pathStyles&quot;:[{&quot;type&quot;:&quot;FILL&quot;,&quot;fillStyle&quot;:&quot;#EEF4FB&quot;},{&quot;type&quot;:&quot;STROKE&quot;,&quot;strokeStyle&quot;:&quot;#95AAD3&quot;,&quot;lineWidth&quot;:1.9696937432599835,&quot;lineJoin&quot;:&quot;round&quot;}],&quot;isLocked&quot;:false,&quot;parent&quot;:{&quot;type&quot;:&quot;CHILD&quot;,&quot;parentId&quot;:&quot;865a3a62-89db-4a0f-9081-e39324f060c0&quot;,&quot;order&quot;:&quot;9997&quot;},&quot;layout&quot;:{&quot;sizeRatio&quot;:{&quot;x&quot;:0.88,&quot;y&quot;:0.88},&quot;keepAspectRatio&quot;:false}},&quot;311dd234-904a-43fd-8b67-79207a8994f8&quot;:{&quot;id&quot;:&quot;311dd234-904a-43fd-8b67-79207a8994f8&quot;,&quot;type&quot;:&quot;FIGURE_OBJECT&quot;,&quot;relativeTransform&quot;:{&quot;translate&quot;:{&quot;x&quot;:0,&quot;y&quot;:0},&quot;rotate&quot;:0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3.333333333333332,&quot;color&quot;:&quot;black&quot;,&quot;fontWeight&quot;:&quot;normal&quot;,&quot;fontStyle&quot;:&quot;normal&quot;,&quot;decoration&quot;:&quot;none&quot;},&quot;range&quot;:[0,17]}],&quot;text&quot;:&quot;Exclusion criteria&quot;,&quot;baseStyle&quot;:{&quot;fontFamily&quot;:&quot;Roboto&quot;,&quot;fontSize&quot;:13.333333333333332,&quot;color&quot;:&quot;black&quot;,&quot;fontWeight&quot;:&quot;normal&quot;,&quot;fontStyle&quot;:&quot;normal&quot;,&quot;decoration&quot;:&quot;none&quot;,&quot;script&quot;:&quot;none&quot;}},{&quot;textIndent&quot;:{&quot;type&quot;:&quot;none&quot;,&quot;indent&quot;:1,&quot;symbol&quot;:&quot; &quot;,&quot;unit&quot;:&quot;levels&quot;},&quot;runs&quot;:[{&quot;style&quot;:{&quot;fontFamily&quot;:&quot;Roboto&quot;,&quot;fontSize&quot;:13.333333333333332,&quot;color&quot;:&quot;black&quot;,&quot;fontWeight&quot;:&quot;normal&quot;,&quot;fontStyle&quot;:&quot;normal&quot;,&quot;decoration&quot;:&quot;none&quot;},&quot;range&quot;:[0,78]}],&quot;text&quot;:&quot;Alcohol consumption &lt;2 drinks/day, cryptogenic cirrhosis, unknown HCC aetiology&quot;}],&quot;_lastCaretLocation&quot;:{&quot;lineIndex&quot;:1,&quot;runIndex&quot;:0,&quot;charIndex&quot;:33}},&quot;format&quot;:&quot;BETTER_TEXT&quot;,&quot;size&quot;:{&quot;x&quot;:227.92629289957816,&quot;y&quot;:60},&quot;targetSize&quot;:{&quot;x&quot;:227.92629289957816,&quot;y&quot;:2}},&quot;parent&quot;:{&quot;type&quot;:&quot;CHILD&quot;,&quot;parentId&quot;:&quot;300e1f6c-6486-453a-8f4d-43cc6a89d2d6&quot;,&quot;order&quot;:&quot;5&quot;}},&quot;a7afc4c2-030f-45bf-b95d-aae9ac781e20&quot;:{&quot;relativeTransform&quot;:{&quot;translate&quot;:{&quot;x&quot;:234.31274206659825,&quot;y&quot;:-51.42508681134534},&quot;rotate&quot;:0,&quot;skewX&quot;:0,&quot;scale&quot;:{&quot;x&quot;:1,&quot;y&quot;:1}},&quot;type&quot;:&quot;FIGURE_OBJECT&quot;,&quot;id&quot;:&quot;a7afc4c2-030f-45bf-b95d-aae9ac781e20&quot;,&quot;name&quot;:&quot;Alcoholic beverage&quot;,&quot;displayName&quot;:&quot;Alcoholic beverage&quot;,&quot;opacity&quot;:1,&quot;source&quot;:{&quot;id&quot;:&quot;5f104c8151216100ada64bf0&quot;,&quot;type&quot;:&quot;ASSETS&quot;},&quot;pathStyles&quot;:[{&quot;type&quot;:&quot;FILL&quot;,&quot;fillStyle&quot;:&quot;rgb(0,0,0)&quot;}],&quot;isLocked&quot;:false,&quot;parent&quot;:{&quot;type&quot;:&quot;CHILD&quot;,&quot;parentId&quot;:&quot;865a3a62-89db-4a0f-9081-e39324f060c0&quot;,&quot;order&quot;:&quot;9998&quot;},&quot;isPremium&quot;:true},&quot;2a53bc45-240c-4eb1-9025-5c0b4ce06288&quot;:{&quot;type&quot;:&quot;FIGURE_OBJECT&quot;,&quot;id&quot;:&quot;2a53bc45-240c-4eb1-9025-5c0b4ce06288&quot;,&quot;name&quot;:&quot;Sparkling wine bottle&quot;,&quot;relativeTransform&quot;:{&quot;translate&quot;:{&quot;x&quot;:-9.459499220557564,&quot;y&quot;:-1.7046946206784686},&quot;rotate&quot;:0,&quot;skewX&quot;:0,&quot;scale&quot;:{&quot;x&quot;:0.1023209334483966,&quot;y&quot;:0.106218739383255}},&quot;opacity&quot;:1,&quot;image&quot;:{&quot;url&quot;:&quot;https://icons.biorender.com/biorender/5cfe683053832904009bbf74/20190610142625/image/wine-sparkling-bottle.png&quot;,&quot;fallbackUrl&quot;:&quot;https://res.cloudinary.com/dlcjuc3ej/image/upload/v1560176785/qwt0s8ooazy6kiup0wh2.svg#/keystone/api/icons/5cfe683053832904009bbf74/20190610142625/image/wine-sparkling-bottle.svg&quot;,&quot;size&quot;:{&quot;x&quot;:172,&quot;y&quot;:422},&quot;isPremium&quot;:false},&quot;source&quot;:{&quot;id&quot;:&quot;5cfe683053832904009bbf74&quot;,&quot;type&quot;:&quot;ASSETS&quot;},&quot;pathStyles&quot;:[{&quot;type&quot;:&quot;FILL&quot;,&quot;fillStyle&quot;:&quot;rgb(0,0,0)&quot;}],&quot;isLocked&quot;:false,&quot;parent&quot;:{&quot;type&quot;:&quot;CHILD&quot;,&quot;parentId&quot;:&quot;a7afc4c2-030f-45bf-b95d-aae9ac781e20&quot;,&quot;order&quot;:&quot;1&quot;}},&quot;a5806e75-92a0-4cf7-a15b-fe370ade6340&quot;:{&quot;type&quot;:&quot;FIGURE_OBJECT&quot;,&quot;id&quot;:&quot;a5806e75-92a0-4cf7-a15b-fe370ade6340&quot;,&quot;name&quot;:&quot;Beer bottle&quot;,&quot;relativeTransform&quot;:{&quot;translate&quot;:{&quot;x&quot;:4.9489219939523466,&quot;y&quot;:1.536804699974893},&quot;rotate&quot;:0,&quot;skewX&quot;:0,&quot;scale&quot;:{&quot;x&quot;:0.06695091454868635,&quot;y&quot;:0.06950133764665073}},&quot;opacity&quot;:1,&quot;image&quot;:{&quot;url&quot;:&quot;https://icons.biorender.com/biorender/5cc36b68df35f43300d5ab7c/20190426203607/image/beer-bottle.png&quot;,&quot;fallbackUrl&quot;:&quot;https://res.cloudinary.com/dlcjuc3ej/image/upload/v1556310967/cdmbbj6ch05raoqdsuot.svg#/keystone/api/icons/5cc36b68df35f43300d5ab7c/20190426203607/image/beer-bottle.svg&quot;,&quot;size&quot;:{&quot;x&quot;:121,&quot;y&quot;:416},&quot;isPremium&quot;:false},&quot;source&quot;:{&quot;id&quot;:&quot;5cc36b68df35f43300d5ab7c&quot;,&quot;type&quot;:&quot;ASSETS&quot;},&quot;pathStyles&quot;:[{&quot;type&quot;:&quot;FILL&quot;,&quot;fillStyle&quot;:&quot;rgb(0,0,0)&quot;}],&quot;isLocked&quot;:false,&quot;parent&quot;:{&quot;type&quot;:&quot;CHILD&quot;,&quot;parentId&quot;:&quot;a7afc4c2-030f-45bf-b95d-aae9ac781e20&quot;,&quot;order&quot;:&quot;2&quot;}},&quot;97bef98c-303b-447f-b8c9-981aafedfc01&quot;:{&quot;type&quot;:&quot;FIGURE_OBJECT&quot;,&quot;id&quot;:&quot;97bef98c-303b-447f-b8c9-981aafedfc01&quot;,&quot;name&quot;:&quot;Whisky bottle (1/4 filled)&quot;,&quot;relativeTransform&quot;:{&quot;translate&quot;:{&quot;x&quot;:-2.880252344755189,&quot;y&quot;:6.674672846076289},&quot;rotate&quot;:0,&quot;skewX&quot;:0,&quot;scale&quot;:{&quot;x&quot;:0.07888317932876374,&quot;y&quot;:0.081888149222859}},&quot;opacity&quot;:0.95,&quot;image&quot;:{&quot;url&quot;:&quot;https://icons.biorender.com/biorender/5ef1363e61a6970028ec959e/20200622225639/image/whisky-1-4-filled.png&quot;,&quot;fallbackUrl&quot;:&quot;https://res.cloudinary.com/dlcjuc3ej/image/upload/v1592866599/s63xvmlezyjarebixyqy.svg#/keystone/api/icons/5ef1363e61a6970028ec959e/20200622225639/image/whisky-1-4-filled.svg&quot;,&quot;size&quot;:{&quot;x&quot;:157,&quot;y&quot;:426},&quot;isPremium&quot;:false},&quot;source&quot;:{&quot;id&quot;:&quot;5ef1363e61a6970028ec959e&quot;,&quot;type&quot;:&quot;ASSETS&quot;},&quot;pathStyles&quot;:[{&quot;type&quot;:&quot;FILL&quot;,&quot;fillStyle&quot;:&quot;rgb(0,0,0)&quot;}],&quot;isLocked&quot;:false,&quot;parent&quot;:{&quot;type&quot;:&quot;CHILD&quot;,&quot;parentId&quot;:&quot;a7afc4c2-030f-45bf-b95d-aae9ac781e20&quot;,&quot;order&quot;:&quot;5&quot;}},&quot;f16ac2db-5f24-47f0-a93f-44f899313fed&quot;:{&quot;type&quot;:&quot;FIGURE_OBJECT&quot;,&quot;id&quot;:&quot;f16ac2db-5f24-47f0-a93f-44f899313fed&quot;,&quot;name&quot;:&quot;Wine glass&quot;,&quot;relativeTransform&quot;:{&quot;translate&quot;:{&quot;x&quot;:-15.7867429403922,&quot;y&quot;:8.773135653595228},&quot;rotate&quot;:0,&quot;skewX&quot;:0,&quot;scale&quot;:{&quot;x&quot;:0.04078154374772584,&quot;y&quot;:0.042335072804736855}},&quot;opacity&quot;:1,&quot;image&quot;:{&quot;url&quot;:&quot;https://icons.biorender.com/biorender/5cac9fc92608ea33005d4754/20190409134325/image/wine-glass.png&quot;,&quot;fallbackUrl&quot;:&quot;https://res.cloudinary.com/dlcjuc3ej/image/upload/v1554817405/mua6unpp3eud0ufqgspb.svg#/keystone/api/icons/5cac9fc92608ea33005d4754/20190409134325/image/wine-glass.svg&quot;,&quot;size&quot;:{&quot;x&quot;:189,&quot;y&quot;:451},&quot;isPremium&quot;:false},&quot;source&quot;:{&quot;id&quot;:&quot;5cac9fc92608ea33005d4754&quot;,&quot;type&quot;:&quot;ASSETS&quot;},&quot;pathStyles&quot;:[{&quot;type&quot;:&quot;FILL&quot;,&quot;fillStyle&quot;:&quot;rgb(0,0,0)&quot;}],&quot;isLocked&quot;:false,&quot;parent&quot;:{&quot;type&quot;:&quot;CHILD&quot;,&quot;parentId&quot;:&quot;a7afc4c2-030f-45bf-b95d-aae9ac781e20&quot;,&quot;order&quot;:&quot;6&quot;}},&quot;1cd0cf42-50ea-46de-987b-34dabe3ab31a&quot;:{&quot;type&quot;:&quot;FIGURE_OBJECT&quot;,&quot;id&quot;:&quot;1cd0cf42-50ea-46de-987b-34dabe3ab31a&quot;,&quot;name&quot;:&quot;Beer mug&quot;,&quot;relativeTransform&quot;:{&quot;translate&quot;:{&quot;x&quot;:12.906491582429817,&quot;y&quot;:8.930568338996979},&quot;rotate&quot;:0,&quot;skewX&quot;:0,&quot;scale&quot;:{&quot;x&quot;:0.056352361858765396,&quot;y&quot;:0.05849904448854378}},&quot;opacity&quot;:1,&quot;image&quot;:{&quot;url&quot;:&quot;https://icons.biorender.com/biorender/5cc36bb9df35f43300d5ab80/20190426203711/image/beer-mug.png&quot;,&quot;fallbackUrl&quot;:&quot;https://res.cloudinary.com/dlcjuc3ej/image/upload/v1556311031/v86qwrfgoncded9vtekw.svg#/keystone/api/icons/5cc36bb9df35f43300d5ab80/20190426203711/image/beer-mug.svg&quot;,&quot;size&quot;:{&quot;x&quot;:239,&quot;y&quot;:321},&quot;isPremium&quot;:false},&quot;source&quot;:{&quot;id&quot;:&quot;5cc36bb9df35f43300d5ab80&quot;,&quot;type&quot;:&quot;ASSETS&quot;},&quot;pathStyles&quot;:[{&quot;type&quot;:&quot;FILL&quot;,&quot;fillStyle&quot;:&quot;rgb(0,0,0)&quot;}],&quot;isLocked&quot;:false,&quot;parent&quot;:{&quot;type&quot;:&quot;CHILD&quot;,&quot;parentId&quot;:&quot;a7afc4c2-030f-45bf-b95d-aae9ac781e20&quot;,&quot;order&quot;:&quot;7&quot;}}}}"/>
  <p:tag name="TRANSPARENTBACKGROUND" val="false"/>
  <p:tag name="VERSION" val="1755650903438"/>
  <p:tag name="TITLE" val="Copy of Copy of Untitled"/>
  <p:tag name="CREATORNAME" val="Fatema Safri"/>
  <p:tag name="DATEINSERTED" val="1755651000244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8a51f11ea18213cbb2330df"/>
  <p:tag name="TRANSPARENTBACKGROUND" val="false"/>
  <p:tag name="DATEINSERTED" val="1755653072463"/>
  <p:tag name="VERSION" val="1755653096834"/>
  <p:tag name="BIOJSON" val="{&quot;id&quot;:&quot;c40aecec-d27e-4f39-a45e-e93276852f81&quot;,&quot;objects&quot;:{&quot;c40aecec-d27e-4f39-a45e-e93276852f81&quot;:{&quot;id&quot;:&quot;c40aecec-d27e-4f39-a45e-e93276852f81&quot;,&quot;type&quot;:&quot;FIGURE_OBJECT&quot;,&quot;document&quot;:{&quot;type&quot;:&quot;DOCUMENT_GROUP&quot;,&quot;canvasType&quot;:&quot;FIGURE&quot;,&quot;units&quot;:&quot;in&quot;}},&quot;73c1c03b-a6c9-458a-a6a8-49aa7017dbe2&quot;:{&quot;id&quot;:&quot;73c1c03b-a6c9-458a-a6a8-49aa7017dbe2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c40aecec-d27e-4f39-a45e-e93276852f81&quot;,&quot;type&quot;:&quot;FRAME&quot;,&quot;order&quot;:&quot;5&quot;}},&quot;87706787-2703-4c99-9fca-724e4d71b426&quot;:{&quot;id&quot;:&quot;87706787-2703-4c99-9fca-724e4d71b426&quot;,&quot;type&quot;:&quot;FIGURE_OBJECT&quot;,&quot;document&quot;:{&quot;type&quot;:&quot;FIGURE&quot;,&quot;canvasType&quot;:&quot;FIGURE&quot;,&quot;units&quot;:&quot;in&quot;},&quot;parent&quot;:{&quot;parentId&quot;:&quot;c40aecec-d27e-4f39-a45e-e93276852f81&quot;,&quot;type&quot;:&quot;DOCUMENT&quot;,&quot;order&quot;:&quot;5&quot;}},&quot;e91da038-00fe-49ed-8018-72bb8fb3da34&quot;:{&quot;id&quot;:&quot;e91da038-00fe-49ed-8018-72bb8fb3da34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87706787-2703-4c99-9fca-724e4d71b426&quot;,&quot;order&quot;:&quot;5&quot;}},&quot;fe751eeb-8437-4f23-93f4-f9276e103f4e&quot;:{&quot;id&quot;:&quot;fe751eeb-8437-4f23-93f4-f9276e103f4e&quot;,&quot;type&quot;:&quot;FIGURE_OBJECT&quot;,&quot;guide&quot;:{&quot;type&quot;:&quot;GRID&quot;,&quot;distance&quot;:0.5,&quot;units&quot;:&quot;in&quot;},&quot;parent&quot;:{&quot;parentId&quot;:&quot;c40aecec-d27e-4f39-a45e-e93276852f81&quot;,&quot;type&quot;:&quot;GUIDE&quot;,&quot;order&quot;:&quot;5&quot;}},&quot;926512c2-3f9b-48ea-818a-4a22964cc241&quot;:{&quot;relativeTransform&quot;:{&quot;translate&quot;:{&quot;x&quot;:79.00687969665326,&quot;y&quot;:199.92672807213566},&quot;rotate&quot;:0,&quot;skewX&quot;:0,&quot;scale&quot;:{&quot;x&quot;:1,&quot;y&quot;:1}},&quot;type&quot;:&quot;FIGURE_OBJECT&quot;,&quot;id&quot;:&quot;926512c2-3f9b-48ea-818a-4a22964cc241&quot;,&quot;parent&quot;:{&quot;type&quot;:&quot;CHILD&quot;,&quot;parentId&quot;:&quot;87706787-2703-4c99-9fca-724e4d71b426&quot;,&quot;order&quot;:&quot;5&quot;},&quot;name&quot;:&quot;Increasing drug concentration in petri dish&quot;,&quot;displayName&quot;:&quot;Increasing drug concentration in petri dish&quot;,&quot;source&quot;:{&quot;id&quot;:&quot;670e8196958f56134d621c11&quot;,&quot;type&quot;:&quot;ASSETS&quot;},&quot;isPremium&quot;:false},&quot;c5869d0c-3736-48d4-8956-ef99d29f5c4d&quot;:{&quot;type&quot;:&quot;FIGURE_OBJECT&quot;,&quot;id&quot;:&quot;c5869d0c-3736-48d4-8956-ef99d29f5c4d&quot;,&quot;relativeTransform&quot;:{&quot;translate&quot;:{&quot;x&quot;:-18.02961950207954,&quot;y&quot;:-4.658709973238001},&quot;rotate&quot;:0,&quot;skewX&quot;:0,&quot;scale&quot;:{&quot;x&quot;:1,&quot;y&quot;:1}},&quot;opacity&quot;:1,&quot;path&quot;:{&quot;type&quot;:&quot;POLY_LINE&quot;,&quot;points&quot;:[{&quot;x&quot;:-143.36494070087198,&quot;y&quot;:-71.46627669784152},{&quot;x&quot;:-101.31173325678154,&quot;y&quot;:-71.46627669784152}],&quot;closed&quot;:false},&quot;pathStyles&quot;:[{&quot;type&quot;:&quot;FILL&quot;,&quot;fillStyle&quot;:&quot;rgba(0,0,0,0)&quot;},{&quot;type&quot;:&quot;STROKE&quot;,&quot;strokeStyle&quot;:{&quot;units&quot;:&quot;PATH_LENGTH&quot;,&quot;stops&quot;:{&quot;0&quot;:&quot;#7D96D600&quot;,&quot;1&quot;:&quot;#7D96D6&quot;,&quot;0.45&quot;:&quot;#7D96D6&quot;}},&quot;lineWidth&quot;:3.356480802913674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926512c2-3f9b-48ea-818a-4a22964cc241&quot;,&quot;order&quot;:&quot;5&quot;},&quot;connectorInfo&quot;:{&quot;connectedObjects&quot;:[],&quot;type&quot;:&quot;LINE&quot;,&quot;offset&quot;:{&quot;x&quot;:0,&quot;y&quot;:0},&quot;bending&quot;:0.1,&quot;firstElementIsHead&quot;:false,&quot;customized&quot;:false}},&quot;e9246576-76ad-48aa-9967-a1d250b92142&quot;:{&quot;type&quot;:&quot;FIGURE_OBJECT&quot;,&quot;id&quot;:&quot;e9246576-76ad-48aa-9967-a1d250b92142&quot;,&quot;relativeTransform&quot;:{&quot;translate&quot;:{&quot;x&quot;:202.51705630106628,&quot;y&quot;:-4.6579955804363244},&quot;rotate&quot;:0,&quot;skewX&quot;:0,&quot;scale&quot;:{&quot;x&quot;:1,&quot;y&quot;:1}},&quot;opacity&quot;:1,&quot;path&quot;:{&quot;type&quot;:&quot;POLY_LINE&quot;,&quot;points&quot;:[{&quot;x&quot;:-143.36494070087198,&quot;y&quot;:-71.46627669784152},{&quot;x&quot;:-101.31173325678154,&quot;y&quot;:-71.46627669784152}],&quot;closed&quot;:false},&quot;pathStyles&quot;:[{&quot;type&quot;:&quot;FILL&quot;,&quot;fillStyle&quot;:&quot;rgba(0,0,0,0)&quot;},{&quot;type&quot;:&quot;STROKE&quot;,&quot;strokeStyle&quot;:{&quot;units&quot;:&quot;PATH_LENGTH&quot;,&quot;stops&quot;:{&quot;0&quot;:&quot;#2C458500&quot;,&quot;1&quot;:&quot;#2C4585&quot;,&quot;0.45&quot;:&quot;#2C4585&quot;}},&quot;lineWidth&quot;:3.356480802913674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926512c2-3f9b-48ea-818a-4a22964cc241&quot;,&quot;order&quot;:&quot;6&quot;},&quot;connectorInfo&quot;:{&quot;connectedObjects&quot;:[],&quot;type&quot;:&quot;LINE&quot;,&quot;offset&quot;:{&quot;x&quot;:0,&quot;y&quot;:0},&quot;bending&quot;:0.1,&quot;firstElementIsHead&quot;:false,&quot;customized&quot;:false}},&quot;4ed4bd26-2db0-4246-a6fc-da58aeeae717&quot;:{&quot;type&quot;:&quot;FIGURE_OBJECT&quot;,&quot;id&quot;:&quot;4ed4bd26-2db0-4246-a6fc-da58aeeae717&quot;,&quot;relativeTransform&quot;:{&quot;translate&quot;:{&quot;x&quot;:-46.52768870722753,&quot;y&quot;:-162.93516897798602},&quot;rotate&quot;:0},&quot;opacity&quot;:1,&quot;path&quot;:{&quot;type&quot;:&quot;POLY_LINE&quot;,&quot;points&quot;:[{&quot;x&quot;:-331.96827605723547,&quot;y&quot;:34.16618468067425},{&quot;x&quot;:331.96827605723547,&quot;y&quot;:-87.73149680579967},{&quot;x&quot;:331.96827605723547,&quot;y&quot;:34.16618468067425}],&quot;closed&quot;:true},&quot;pathStyles&quot;:[{&quot;type&quot;:&quot;FILL&quot;,&quot;fillStyle&quot;:{&quot;type&quot;:&quot;linear&quot;,&quot;angle&quot;:90,&quot;colorStops&quot;:{&quot;0&quot;:&quot;rgba(249, 159, 4, 1)&quot;,&quot;1&quot;:&quot;rgba(255, 255, 255, 1)&quot;}}},{&quot;type&quot;:&quot;STROKE&quot;,&quot;strokeStyle&quot;:&quot;rgba(234, 195, 214, 1)&quot;,&quot;lineWidth&quot;:0,&quot;lineJoin&quot;:&quot;round&quot;}],&quot;isLocked&quot;:false,&quot;parent&quot;:{&quot;type&quot;:&quot;CHILD&quot;,&quot;parentId&quot;:&quot;926512c2-3f9b-48ea-818a-4a22964cc241&quot;,&quot;order&quot;:&quot;7&quot;},&quot;connectorInfo&quot;:{&quot;connectedObjects&quot;:[],&quot;type&quot;:&quot;ELBOW&quot;,&quot;offset&quot;:{&quot;x&quot;:0,&quot;y&quot;:0},&quot;bending&quot;:-0.1,&quot;firstElementIsHead&quot;:true,&quot;customized&quot;:true}},&quot;68e648ef-87d3-49c7-b215-76e85693144a&quot;:{&quot;id&quot;:&quot;68e648ef-87d3-49c7-b215-76e85693144a&quot;,&quot;type&quot;:&quot;FIGURE_OBJECT&quot;,&quot;relativeTransform&quot;:{&quot;translate&quot;:{&quot;x&quot;:143.82455769532336,&quot;y&quot;:-154.6382183313355},&quot;rotate&quot;:0},&quot;text&quot;:{&quot;textData&quot;:{&quot;lineSpacing&quot;:&quot;normal&quot;,&quot;alignment&quot;:&quot;right&quot;,&quot;verticalAlign&quot;:&quot;TOP&quot;,&quot;lines&quot;:[{&quot;runs&quot;:[{&quot;style&quot;:{&quot;fontFamily&quot;:&quot;Roboto&quot;,&quot;fontSize&quot;:29.089500291918508,&quot;color&quot;:&quot;rgb(44, 69, 133)&quot;,&quot;fontWeight&quot;:&quot;bold&quot;,&quot;fontStyle&quot;:&quot;normal&quot;,&quot;decoration&quot;:&quot;none&quot;,&quot;script&quot;:&quot;none&quot;},&quot;range&quot;:[0,14]}],&quot;text&quot;:&quot;Lipid abundance&quot;}],&quot;_lastCaretLocation&quot;:{&quot;lineIndex&quot;:0,&quot;runIndex&quot;:-1,&quot;charIndex&quot;:-1,&quot;endOfLine&quot;:true}},&quot;format&quot;:&quot;BETTER_TEXT&quot;,&quot;size&quot;:{&quot;x&quot;:262.36571977974955,&quot;y&quot;:34},&quot;targetSize&quot;:{&quot;x&quot;:262.36571977974955,&quot;y&quot;:33.56480802913674}},&quot;parent&quot;:{&quot;type&quot;:&quot;CHILD&quot;,&quot;parentId&quot;:&quot;926512c2-3f9b-48ea-818a-4a22964cc241&quot;,&quot;order&quot;:&quot;8&quot;}},&quot;e83eb2bf-45fa-450b-aa45-6c9649f5f295&quot;:{&quot;id&quot;:&quot;e83eb2bf-45fa-450b-aa45-6c9649f5f295&quot;,&quot;name&quot;:&quot;Liver (fatty 2)&quot;,&quot;displayName&quot;:&quot;Fatty liver 2&quot;,&quot;type&quot;:&quot;FIGURE_OBJECT&quot;,&quot;relativeTransform&quot;:{&quot;translate&quot;:{&quot;x&quot;:-246.02510475408758,&quot;y&quot;:-76.12491666563191},&quot;rotate&quot;:0,&quot;skewX&quot;:0,&quot;scale&quot;:{&quot;x&quot;:0.9546174441333843,&quot;y&quot;:0.9546174441333843}},&quot;image&quot;:{&quot;url&quot;:&quot;https://icons.cdn.biorender.com/biorender/5f89b242438bc10027158baf/20201016144712/image/5f89b242438bc10027158baf.png&quot;,&quot;isPremium&quot;:true,&quot;isOrgIcon&quot;:false,&quot;size&quot;:{&quot;x&quot;:125,&quot;y&quot;:81.875}},&quot;source&quot;:{&quot;id&quot;:&quot;5f89b242438bc10027158baf&quot;,&quot;version&quot;:&quot;20201016144712&quot;,&quot;type&quot;:&quot;ASSETS&quot;},&quot;isPremium&quot;:true,&quot;parent&quot;:{&quot;type&quot;:&quot;CHILD&quot;,&quot;parentId&quot;:&quot;926512c2-3f9b-48ea-818a-4a22964cc241&quot;,&quot;order&quot;:&quot;9&quot;}},&quot;3c0e4f00-2eb4-4951-af73-4ae30be235d4&quot;:{&quot;relativeTransform&quot;:{&quot;translate&quot;:{&quot;x&quot;:424.95263555675024,&quot;y&quot;:-23.63844352810049},&quot;rotate&quot;:0,&quot;skewX&quot;:0,&quot;scale&quot;:{&quot;x&quot;:1,&quot;y&quot;:1}},&quot;type&quot;:&quot;FIGURE_OBJECT&quot;,&quot;id&quot;:&quot;3c0e4f00-2eb4-4951-af73-4ae30be235d4&quot;,&quot;parent&quot;:{&quot;type&quot;:&quot;CHILD&quot;,&quot;parentId&quot;:&quot;926512c2-3f9b-48ea-818a-4a22964cc241&quot;,&quot;order&quot;:&quot;95&quot;},&quot;name&quot;:&quot;Liver (hepatocellular carcinoma, human)&quot;,&quot;displayName&quot;:&quot;Liver (hepatocellular carcinoma, human)&quot;,&quot;source&quot;:{&quot;id&quot;:&quot;6092e883a3cc6b00abedfc92&quot;,&quot;type&quot;:&quot;ASSETS&quot;},&quot;isPremium&quot;:true},&quot;47b34dc2-a311-4cc7-a273-4f7077c55c8d&quot;:{&quot;type&quot;:&quot;FIGURE_OBJECT&quot;,&quot;id&quot;:&quot;47b34dc2-a311-4cc7-a273-4f7077c55c8d&quot;,&quot;name&quot;:&quot;Liver (cirrhosis)&quot;,&quot;relativeTransform&quot;:{&quot;translate&quot;:{&quot;x&quot;:-250.26168882707557,&quot;y&quot;:-52.4860344791937},&quot;rotate&quot;:0,&quot;skewX&quot;:0,&quot;scale&quot;:{&quot;x&quot;:0.5874428414505196,&quot;y&quot;:0.5891964021712676}},&quot;opacity&quot;:1,&quot;image&quot;:{&quot;url&quot;:&quot;https://icons.biorender.com/biorender/5ad49fa8bb8caa001401481a/liver-cirrhosis-1.png&quot;,&quot;fallbackUrl&quot;:&quot;https://res.cloudinary.com/dlcjuc3ej/image/upload/v1523883940/yxqkepywhvb7687l7vca.svg#/keystone/api/icons/5ad49fa8bb8caa001401481a/liver-cirrhosis-1.svg&quot;,&quot;size&quot;:{&quot;x&quot;:192,&quot;y&quot;:134},&quot;isPremium&quot;:false,&quot;isPacked&quot;:true},&quot;source&quot;:{&quot;id&quot;:&quot;5ad49f42bb8caa0014014816&quot;,&quot;type&quot;:&quot;ASSETS&quot;},&quot;pathStyles&quot;:[{&quot;type&quot;:&quot;FILL&quot;,&quot;fillStyle&quot;:&quot;rgb(0,0,0)&quot;}],&quot;isLocked&quot;:false,&quot;parent&quot;:{&quot;type&quot;:&quot;CHILD&quot;,&quot;parentId&quot;:&quot;3c0e4f00-2eb4-4951-af73-4ae30be235d4&quot;,&quot;order&quot;:&quot;2&quot;}},&quot;04b6a0a5-9ef0-4520-8269-409a0c6abe6f&quot;:{&quot;type&quot;:&quot;FIGURE_OBJECT&quot;,&quot;id&quot;:&quot;04b6a0a5-9ef0-4520-8269-409a0c6abe6f&quot;,&quot;name&quot;:&quot;Tumor (round, necrosis 2) &quot;,&quot;relativeTransform&quot;:{&quot;translate&quot;:{&quot;x&quot;:-276.47915174379233,&quot;y&quot;:-56.11531826451258},&quot;rotate&quot;:0,&quot;skewX&quot;:0,&quot;scale&quot;:{&quot;x&quot;:0.09947126867207164,&quot;y&quot;:0.09947126867207164}},&quot;opacity&quot;:0.56,&quot;image&quot;:{&quot;url&quot;:&quot;https://icons.biorender.com/biorender/5d4c5b4d4c65360004f9d496/tumor-round-necrosis-2a.png&quot;,&quot;fallbackUrl&quot;:&quot;https://res.cloudinary.com/dlcjuc3ej/image/upload/v1565285193/yue6hcn4naiawxmaohfx.svg#/keystone/api/icons/5d4c5b4d4c65360004f9d496/tumor-round-necrosis-2a.svg&quot;,&quot;size&quot;:{&quot;x&quot;:423,&quot;y&quot;:390},&quot;isPremium&quot;:false,&quot;isPacked&quot;:true},&quot;source&quot;:{&quot;id&quot;:&quot;5d4c5b174c65360004f9d48b&quot;,&quot;type&quot;:&quot;ASSETS&quot;},&quot;pathStyles&quot;:[{&quot;type&quot;:&quot;FILL&quot;,&quot;fillStyle&quot;:&quot;rgb(0,0,0)&quot;}],&quot;isLocked&quot;:false,&quot;parent&quot;:{&quot;type&quot;:&quot;CHILD&quot;,&quot;parentId&quot;:&quot;3c0e4f00-2eb4-4951-af73-4ae30be235d4&quot;,&quot;order&quot;:&quot;5&quot;}},&quot;61df894a-d5da-431c-afb0-ab8f99f148a5&quot;:{&quot;type&quot;:&quot;FIGURE_OBJECT&quot;,&quot;id&quot;:&quot;61df894a-d5da-431c-afb0-ab8f99f148a5&quot;,&quot;name&quot;:&quot;Tumor (round, necrosis 2) &quot;,&quot;relativeTransform&quot;:{&quot;translate&quot;:{&quot;x&quot;:-226.27042449537814,&quot;y&quot;:-71.32544270306282},&quot;rotate&quot;:3.061716917255792,&quot;skewX&quot;:4.269656624004913e-17,&quot;scale&quot;:{&quot;x&quot;:0.05039165962496264,&quot;y&quot;:0.05039165962496257}},&quot;opacity&quot;:0.56,&quot;image&quot;:{&quot;url&quot;:&quot;https://icons.biorender.com/biorender/5d4c5b4d4c65360004f9d496/tumor-round-necrosis-2a.png&quot;,&quot;fallbackUrl&quot;:&quot;https://res.cloudinary.com/dlcjuc3ej/image/upload/v1565285193/yue6hcn4naiawxmaohfx.svg#/keystone/api/icons/5d4c5b4d4c65360004f9d496/tumor-round-necrosis-2a.svg&quot;,&quot;size&quot;:{&quot;x&quot;:423,&quot;y&quot;:390},&quot;isPremium&quot;:false,&quot;isPacked&quot;:true},&quot;source&quot;:{&quot;id&quot;:&quot;5d4c5b174c65360004f9d48b&quot;,&quot;type&quot;:&quot;ASSETS&quot;},&quot;pathStyles&quot;:[{&quot;type&quot;:&quot;FILL&quot;,&quot;fillStyle&quot;:&quot;rgb(0,0,0)&quot;}],&quot;isLocked&quot;:false,&quot;parent&quot;:{&quot;type&quot;:&quot;CHILD&quot;,&quot;parentId&quot;:&quot;3c0e4f00-2eb4-4951-af73-4ae30be235d4&quot;,&quot;order&quot;:&quot;7&quot;}},&quot;00fd665d-cf37-4f8d-9446-5957220844d4&quot;:{&quot;id&quot;:&quot;00fd665d-cf37-4f8d-9446-5957220844d4&quot;,&quot;name&quot;:&quot;Liver (fatty 2)&quot;,&quot;displayName&quot;:&quot;Fatty liver 2&quot;,&quot;type&quot;:&quot;FIGURE_OBJECT&quot;,&quot;relativeTransform&quot;:{&quot;translate&quot;:{&quot;x&quot;:-48.57115710685274,&quot;y&quot;:-56.68763008053487},&quot;rotate&quot;:0,&quot;skewX&quot;:0,&quot;scale&quot;:{&quot;x&quot;:0.9546174441333843,&quot;y&quot;:0.9546174441333843}},&quot;image&quot;:{&quot;url&quot;:&quot;https://icons.cdn.biorender.com/biorender/5f89b242438bc10027158baf/20201016144712/image/5f89b242438bc10027158baf.png&quot;,&quot;isPremium&quot;:true,&quot;isOrgIcon&quot;:false,&quot;size&quot;:{&quot;x&quot;:125,&quot;y&quot;:81.875}},&quot;source&quot;:{&quot;id&quot;:&quot;5f89b242438bc10027158baf&quot;,&quot;version&quot;:&quot;20201016144712&quot;,&quot;type&quot;:&quot;ASSETS&quot;},&quot;isPremium&quot;:true,&quot;parent&quot;:{&quot;type&quot;:&quot;CHILD&quot;,&quot;parentId&quot;:&quot;ce651826-ad5b-4c58-82c0-ab2073918f74&quot;,&quot;order&quot;:&quot;2&quot;}},&quot;4e033db8-3f97-469c-a603-10657fb48f24&quot;:{&quot;type&quot;:&quot;FIGURE_OBJECT&quot;,&quot;id&quot;:&quot;4e033db8-3f97-469c-a603-10657fb48f24&quot;,&quot;name&quot;:&quot;Tumor (round, necrosis 2) &quot;,&quot;relativeTransform&quot;:{&quot;translate&quot;:{&quot;x&quot;:-79.06159186438538,&quot;y&quot;:-56.68835897359999},&quot;rotate&quot;:0,&quot;skewX&quot;:0,&quot;scale&quot;:{&quot;x&quot;:0.08495155176147531,&quot;y&quot;:0.08495155176147531}},&quot;opacity&quot;:0.56,&quot;image&quot;:{&quot;url&quot;:&quot;https://icons.biorender.com/biorender/5d4c5b4d4c65360004f9d496/tumor-round-necrosis-2a.png&quot;,&quot;fallbackUrl&quot;:&quot;https://res.cloudinary.com/dlcjuc3ej/image/upload/v1565285193/yue6hcn4naiawxmaohfx.svg#/keystone/api/icons/5d4c5b4d4c65360004f9d496/tumor-round-necrosis-2a.svg&quot;,&quot;size&quot;:{&quot;x&quot;:423,&quot;y&quot;:390},&quot;isPremium&quot;:false,&quot;isPacked&quot;:true},&quot;source&quot;:{&quot;id&quot;:&quot;5d4c5b174c65360004f9d48b&quot;,&quot;type&quot;:&quot;ASSETS&quot;},&quot;pathStyles&quot;:[{&quot;type&quot;:&quot;FILL&quot;,&quot;fillStyle&quot;:&quot;rgb(0,0,0)&quot;}],&quot;isLocked&quot;:false,&quot;parent&quot;:{&quot;type&quot;:&quot;CHILD&quot;,&quot;parentId&quot;:&quot;ce651826-ad5b-4c58-82c0-ab2073918f74&quot;,&quot;order&quot;:&quot;5&quot;}},&quot;ce651826-ad5b-4c58-82c0-ab2073918f74&quot;:{&quot;type&quot;:&quot;FIGURE_OBJECT&quot;,&quot;id&quot;:&quot;ce651826-ad5b-4c58-82c0-ab2073918f74&quot;,&quot;parent&quot;:{&quot;type&quot;:&quot;CHILD&quot;,&quot;parentId&quot;:&quot;926512c2-3f9b-48ea-818a-4a22964cc241&quot;,&quot;order&quot;:&quot;98&quot;},&quot;relativeTransform&quot;:{&quot;translate&quot;:{&quot;x&quot;:13.860452985197899,&quot;y&quot;:-19.43728667162562},&quot;rotate&quot;:0,&quot;skewX&quot;:0,&quot;scale&quot;:{&quot;x&quot;:1,&quot;y&quot;:1}}},&quot;dccc454a-766b-412c-bc24-8044ade93713&quot;:{&quot;type&quot;:&quot;FIGURE_OBJECT&quot;,&quot;id&quot;:&quot;dccc454a-766b-412c-bc24-8044ade93713&quot;,&quot;relativeTransform&quot;:{&quot;translate&quot;:{&quot;x&quot;:-46.5276888762879,&quot;y&quot;:-225.36948152576252},&quot;rotate&quot;:3.141592653589793,&quot;skewX&quot;:0,&quot;scale&quot;:{&quot;x&quot;:1,&quot;y&quot;:1}},&quot;opacity&quot;:1,&quot;path&quot;:{&quot;type&quot;:&quot;POLY_LINE&quot;,&quot;points&quot;:[{&quot;x&quot;:-331.96827605723547,&quot;y&quot;:34.16618468067425},{&quot;x&quot;:331.96827605723547,&quot;y&quot;:-87.73149680579967},{&quot;x&quot;:331.96827605723547,&quot;y&quot;:34.16618468067425}],&quot;closed&quot;:true},&quot;pathStyles&quot;:[{&quot;type&quot;:&quot;FILL&quot;,&quot;fillStyle&quot;:{&quot;type&quot;:&quot;linear&quot;,&quot;angle&quot;:90,&quot;colorStops&quot;:{&quot;0&quot;:&quot;rgba(249, 159, 4, 1)&quot;,&quot;1&quot;:&quot;rgba(255, 255, 255, 1)&quot;}}},{&quot;type&quot;:&quot;STROKE&quot;,&quot;strokeStyle&quot;:&quot;#2d5f8a&quot;,&quot;lineWidth&quot;:0,&quot;lineJoin&quot;:&quot;round&quot;}],&quot;isLocked&quot;:false,&quot;parent&quot;:{&quot;type&quot;:&quot;CHILD&quot;,&quot;parentId&quot;:&quot;926512c2-3f9b-48ea-818a-4a22964cc241&quot;,&quot;order&quot;:&quot;99&quot;},&quot;connectorInfo&quot;:{&quot;connectedObjects&quot;:[],&quot;type&quot;:&quot;ELBOW&quot;,&quot;offset&quot;:{&quot;x&quot;:0,&quot;y&quot;:0},&quot;bending&quot;:-0.1,&quot;firstElementIsHead&quot;:true,&quot;customized&quot;:true}},&quot;5c0f60a5-b081-4bf5-b67f-2a8eaeab2609&quot;:{&quot;id&quot;:&quot;5c0f60a5-b081-4bf5-b67f-2a8eaeab2609&quot;,&quot;type&quot;:&quot;FIGURE_OBJECT&quot;,&quot;relativeTransform&quot;:{&quot;translate&quot;:{&quot;x&quot;:-313.4959302586707,&quot;y&quot;:-207.27737206854482},&quot;rotate&quot;:0,&quot;skewX&quot;:0,&quot;scale&quot;:{&quot;x&quot;:1,&quot;y&quot;:1}},&quot;text&quot;:{&quot;textData&quot;:{&quot;lineSpacing&quot;:&quot;onehalf&quot;,&quot;alignment&quot;:&quot;left&quot;,&quot;verticalAlign&quot;:&quot;TOP&quot;,&quot;lines&quot;:[{&quot;runs&quot;:[{&quot;style&quot;:{&quot;fontFamily&quot;:&quot;Roboto&quot;,&quot;fontSize&quot;:12,&quot;color&quot;:&quot;#000000&quot;,&quot;fontWeight&quot;:&quot;normal&quot;,&quot;fontStyle&quot;:&quot;normal&quot;,&quot;decoration&quot;:&quot;none&quot;},&quot;range&quot;:[0,7]}],&quot;text&quot;:&quot;Ceramide&quot;},{&quot;runs&quot;:[{&quot;style&quot;:{&quot;fontFamily&quot;:&quot;Roboto&quot;,&quot;fontSize&quot;:12,&quot;color&quot;:&quot;#000000&quot;,&quot;fontWeight&quot;:&quot;normal&quot;,&quot;fontStyle&quot;:&quot;normal&quot;,&quot;decoration&quot;:&quot;none&quot;,&quot;script&quot;:&quot;none&quot;},&quot;range&quot;:[0,19]}],&quot;text&quot;:&quot;Ceramide-1-Phosphate&quot;},{&quot;runs&quot;:[{&quot;style&quot;:{&quot;fontFamily&quot;:&quot;Roboto&quot;,&quot;fontSize&quot;:12,&quot;color&quot;:&quot;#000000&quot;,&quot;fontWeight&quot;:&quot;normal&quot;,&quot;fontStyle&quot;:&quot;normal&quot;,&quot;decoration&quot;:&quot;none&quot;,&quot;script&quot;:&quot;none&quot;},&quot;range&quot;:[0,10]}],&quot;text&quot;:&quot;Diglyceride&quot;},{&quot;runs&quot;:[{&quot;style&quot;:{&quot;fontFamily&quot;:&quot;Roboto&quot;,&quot;fontSize&quot;:12,&quot;color&quot;:&quot;#000000&quot;,&quot;fontWeight&quot;:&quot;normal&quot;,&quot;fontStyle&quot;:&quot;normal&quot;,&quot;decoration&quot;:&quot;none&quot;,&quot;script&quot;:&quot;none&quot;},&quot;range&quot;:[0,12]}],&quot;text&quot;:&quot;Sphingomylein&quot;},{&quot;runs&quot;:[{&quot;style&quot;:{&quot;fontFamily&quot;:&quot;Roboto&quot;,&quot;fontSize&quot;:12,&quot;color&quot;:&quot;#000000&quot;,&quot;fontWeight&quot;:&quot;normal&quot;,&quot;fontStyle&quot;:&quot;normal&quot;,&quot;decoration&quot;:&quot;none&quot;,&quot;script&quot;:&quot;none&quot;},&quot;range&quot;:[0,10]}],&quot;text&quot;:&quot;Sphingosine&quot;},{&quot;runs&quot;:[{&quot;style&quot;:{&quot;fontFamily&quot;:&quot;Roboto&quot;,&quot;fontSize&quot;:12,&quot;color&quot;:&quot;#000000&quot;,&quot;fontWeight&quot;:&quot;normal&quot;,&quot;fontStyle&quot;:&quot;normal&quot;,&quot;decoration&quot;:&quot;none&quot;,&quot;script&quot;:&quot;none&quot;},&quot;range&quot;:[0,11]}],&quot;text&quot;:&quot;Triglyceride&quot;}],&quot;_lastCaretLocation&quot;:{&quot;lineIndex&quot;:5,&quot;runIndex&quot;:-1,&quot;charIndex&quot;:-1,&quot;endOfLine&quot;:true}},&quot;format&quot;:&quot;BETTER_TEXT&quot;,&quot;size&quot;:{&quot;x&quot;:129.99999916878608,&quot;y&quot;:104.51724137931035},&quot;targetSize&quot;:{&quot;x&quot;:129.99999916878608,&quot;y&quot;:104.51724137931035}},&quot;parent&quot;:{&quot;type&quot;:&quot;CHILD&quot;,&quot;parentId&quot;:&quot;926512c2-3f9b-48ea-818a-4a22964cc241&quot;,&quot;order&quot;:&quot;995&quot;}},&quot;e2745e9d-89ed-4010-8879-f84ed50c1539&quot;:{&quot;id&quot;:&quot;e2745e9d-89ed-4010-8879-f84ed50c1539&quot;,&quot;type&quot;:&quot;FIGURE_OBJECT&quot;,&quot;relativeTransform&quot;:{&quot;translate&quot;:{&quot;x&quot;:180.5070765530569,&quot;y&quot;:-196.74154403151},&quot;rotate&quot;:0,&quot;skewX&quot;:0,&quot;scale&quot;:{&quot;x&quot;:1,&quot;y&quot;:1}},&quot;text&quot;:{&quot;textData&quot;:{&quot;lineSpacing&quot;:&quot;onehalf&quot;,&quot;alignment&quot;:&quot;right&quot;,&quot;verticalAlign&quot;:&quot;TOP&quot;,&quot;lines&quot;:[{&quot;runs&quot;:[{&quot;style&quot;:{&quot;fontWeight&quot;:&quot;normal&quot;,&quot;fontStyle&quot;:&quot;normal&quot;,&quot;fontSize&quot;:12,&quot;fontFamily&quot;:&quot;Roboto&quot;,&quot;color&quot;:&quot;#000000&quot;,&quot;decoration&quot;:&quot;none&quot;},&quot;range&quot;:[0,18]}],&quot;text&quot;:&quot;Trihexosylceramide &quot;},{&quot;runs&quot;:[{&quot;style&quot;:{&quot;fontFamily&quot;:&quot;Roboto&quot;,&quot;fontSize&quot;:12,&quot;color&quot;:&quot;#000000&quot;,&quot;fontWeight&quot;:&quot;normal&quot;,&quot;fontStyle&quot;:&quot;normal&quot;,&quot;decoration&quot;:&quot;none&quot;,&quot;script&quot;:&quot;none&quot;},&quot;range&quot;:[0,22]}],&quot;text&quot;:&quot;Lysophosphatidylcholine&quot;},{&quot;runs&quot;:[{&quot;style&quot;:{&quot;fontFamily&quot;:&quot;Roboto&quot;,&quot;fontSize&quot;:12,&quot;color&quot;:&quot;#000000&quot;,&quot;fontWeight&quot;:&quot;normal&quot;,&quot;fontStyle&quot;:&quot;normal&quot;,&quot;decoration&quot;:&quot;none&quot;,&quot;script&quot;:&quot;none&quot;},&quot;range&quot;:[0,6]}],&quot;text&quot;:&quot;Sterols&quot;}],&quot;_lastCaretLocation&quot;:{&quot;lineIndex&quot;:2,&quot;runIndex&quot;:-1,&quot;charIndex&quot;:-1,&quot;endOfLine&quot;:true}},&quot;format&quot;:&quot;BETTER_TEXT&quot;,&quot;size&quot;:{&quot;x&quot;:189,&quot;y&quot;:50.20689655172414},&quot;targetSize&quot;:{&quot;x&quot;:189,&quot;y&quot;:46}},&quot;parent&quot;:{&quot;type&quot;:&quot;CHILD&quot;,&quot;parentId&quot;:&quot;926512c2-3f9b-48ea-818a-4a22964cc241&quot;,&quot;order&quot;:&quot;997&quot;}},&quot;61e42e85-03a4-4f54-87d5-54c77ede1933&quot;:{&quot;id&quot;:&quot;61e42e85-03a4-4f54-87d5-54c77ede1933&quot;,&quot;type&quot;:&quot;FIGURE_OBJECT&quot;,&quot;relativeTransform&quot;:{&quot;translate&quot;:{&quot;x&quot;:-246.02492923726376,&quot;y&quot;:-83.12499277228834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3.333333333333332,&quot;color&quot;:&quot;rgba(255,255,255,1)&quot;,&quot;fontWeight&quot;:&quot;normal&quot;,&quot;fontStyle&quot;:&quot;normal&quot;,&quot;decoration&quot;:&quot;none&quot;},&quot;range&quot;:[0,4]}],&quot;text&quot;:&quot;MAFLD&quot;}],&quot;_lastCaretLocation&quot;:{&quot;lineIndex&quot;:0,&quot;runIndex&quot;:-1,&quot;charIndex&quot;:-1,&quot;endOfLine&quot;:true}},&quot;format&quot;:&quot;BETTER_TEXT&quot;,&quot;size&quot;:{&quot;x&quot;:68.9999993237582,&quot;y&quot;:22},&quot;targetSize&quot;:{&quot;x&quot;:68.9999993237582,&quot;y&quot;:22}},&quot;parent&quot;:{&quot;type&quot;:&quot;CHILD&quot;,&quot;parentId&quot;:&quot;926512c2-3f9b-48ea-818a-4a22964cc241&quot;,&quot;order&quot;:&quot;998&quot;}},&quot;c20a01f5-537e-4356-81ab-e5d00252f0e2&quot;:{&quot;id&quot;:&quot;c20a01f5-537e-4356-81ab-e5d00252f0e2&quot;,&quot;type&quot;:&quot;FIGURE_OBJECT&quot;,&quot;relativeTransform&quot;:{&quot;translate&quot;:{&quot;x&quot;:-30.094929687224408,&quot;y&quot;:-76.12499292726031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3.333333333333332,&quot;color&quot;:&quot;rgba(255,255,255,1)&quot;,&quot;fontWeight&quot;:&quot;normal&quot;,&quot;fontStyle&quot;:&quot;italic&quot;,&quot;decoration&quot;:&quot;none&quot;},&quot;range&quot;:[0,1]},{&quot;style&quot;:{&quot;fontFamily&quot;:&quot;Roboto&quot;,&quot;fontSize&quot;:13.333333333333332,&quot;color&quot;:&quot;rgba(255,255,255,1)&quot;,&quot;fontWeight&quot;:&quot;normal&quot;,&quot;fontStyle&quot;:&quot;normal&quot;,&quot;decoration&quot;:&quot;none&quot;},&quot;range&quot;:[2,10]}],&quot;text&quot;:&quot;ncMAFLD-HCC&quot;,&quot;baseStyle&quot;:{&quot;fontFamily&quot;:&quot;Roboto&quot;,&quot;fontSize&quot;:13.333333333333332,&quot;color&quot;:&quot;rgba(255,255,255,1)&quot;,&quot;fontWeight&quot;:&quot;normal&quot;,&quot;fontStyle&quot;:&quot;normal&quot;,&quot;decoration&quot;:&quot;none&quot;,&quot;script&quot;:&quot;none&quot;}}],&quot;_lastCaretLocation&quot;:{&quot;lineIndex&quot;:0,&quot;runIndex&quot;:-1,&quot;charIndex&quot;:-1,&quot;endOfLine&quot;:true}},&quot;format&quot;:&quot;BETTER_TEXT&quot;,&quot;size&quot;:{&quot;x&quot;:110.42999301390228,&quot;y&quot;:36},&quot;targetSize&quot;:{&quot;x&quot;:110.42999301390228,&quot;y&quot;:36}},&quot;parent&quot;:{&quot;type&quot;:&quot;CHILD&quot;,&quot;parentId&quot;:&quot;926512c2-3f9b-48ea-818a-4a22964cc241&quot;,&quot;order&quot;:&quot;999&quot;}},&quot;8034b702-51c0-4ef1-b234-6ea2b1c5ff58&quot;:{&quot;id&quot;:&quot;8034b702-51c0-4ef1-b234-6ea2b1c5ff58&quot;,&quot;type&quot;:&quot;FIGURE_OBJECT&quot;,&quot;relativeTransform&quot;:{&quot;translate&quot;:{&quot;x&quot;:171.38707000987552,&quot;y&quot;:-76.12499296952544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3.333333333333332,&quot;color&quot;:&quot;rgba(255,255,255,1)&quot;,&quot;fontWeight&quot;:&quot;normal&quot;,&quot;fontStyle&quot;:&quot;italic&quot;,&quot;decoration&quot;:&quot;none&quot;},&quot;range&quot;:[0,0]},{&quot;style&quot;:{&quot;fontFamily&quot;:&quot;Roboto&quot;,&quot;fontSize&quot;:13.333333333333332,&quot;color&quot;:&quot;rgba(255,255,255,1)&quot;,&quot;fontWeight&quot;:&quot;normal&quot;,&quot;fontStyle&quot;:&quot;normal&quot;,&quot;decoration&quot;:&quot;none&quot;},&quot;range&quot;:[1,9]}],&quot;text&quot;:&quot;cMAFLD-HCC&quot;,&quot;baseStyle&quot;:{&quot;fontFamily&quot;:&quot;Roboto&quot;,&quot;fontSize&quot;:13.333333333333332,&quot;color&quot;:&quot;rgba(255,255,255,1)&quot;,&quot;fontWeight&quot;:&quot;normal&quot;,&quot;fontStyle&quot;:&quot;normal&quot;,&quot;decoration&quot;:&quot;none&quot;,&quot;script&quot;:&quot;none&quot;}}],&quot;_lastCaretLocation&quot;:{&quot;lineIndex&quot;:0,&quot;runIndex&quot;:-1,&quot;charIndex&quot;:-1,&quot;endOfLine&quot;:true}},&quot;format&quot;:&quot;BETTER_TEXT&quot;,&quot;size&quot;:{&quot;x&quot;:90.42999277439975,&quot;y&quot;:36},&quot;targetSize&quot;:{&quot;x&quot;:90.42999277439975,&quot;y&quot;:36}},&quot;parent&quot;:{&quot;type&quot;:&quot;CHILD&quot;,&quot;parentId&quot;:&quot;926512c2-3f9b-48ea-818a-4a22964cc241&quot;,&quot;order&quot;:&quot;9995&quot;}}}}"/>
  <p:tag name="TITLE" val="Untitled"/>
  <p:tag name="CREATORNAME" val="Fatema Safri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3193713C-E433-43A4-AD7E-1FB223EB8DFE}">
  <we:reference id="wa200006038" version="1.0.0.5" store="en-US" storeType="OMEX"/>
  <we:alternateReferences>
    <we:reference id="WA200006038" version="1.0.0.5" store="" storeType="OMEX"/>
  </we:alternateReferences>
  <we:properties>
    <we:property name="pptx_export_from_biorender" value="false"/>
    <we:property name="has-user-completed-add" value="true"/>
  </we:properties>
  <we:bindings/>
  <we:snapshot xmlns:r="http://schemas.openxmlformats.org/officeDocument/2006/relationships"/>
  <we:extLst>
    <a:ext xmlns:a="http://schemas.openxmlformats.org/drawingml/2006/main" uri="{0858819E-0033-43BF-8937-05EC82904868}">
      <we:backgroundApp state="1" runtimeId="Taskpane.Url"/>
    </a:ext>
  </we:extLst>
</we:webextension>
</file>

<file path=docProps/app.xml><?xml version="1.0" encoding="utf-8"?>
<Properties xmlns="http://schemas.openxmlformats.org/officeDocument/2006/extended-properties" xmlns:vt="http://schemas.openxmlformats.org/officeDocument/2006/docPropsVTypes">
  <TotalTime>1102</TotalTime>
  <Words>60</Words>
  <Application>Microsoft Office PowerPoint</Application>
  <PresentationFormat>Widescreen</PresentationFormat>
  <Paragraphs>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atema Safri</dc:creator>
  <cp:lastModifiedBy>MDPI</cp:lastModifiedBy>
  <cp:revision>5</cp:revision>
  <dcterms:created xsi:type="dcterms:W3CDTF">2025-08-20T00:46:23Z</dcterms:created>
  <dcterms:modified xsi:type="dcterms:W3CDTF">2026-07-06T10:32:01Z</dcterms:modified>
</cp:coreProperties>
</file>